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60" r:id="rId3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7" d="100"/>
          <a:sy n="127" d="100"/>
        </p:scale>
        <p:origin x="1776" y="6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8F9C77B-5AD7-4D1C-8C82-D5C4C1D80329}" type="doc">
      <dgm:prSet loTypeId="urn:microsoft.com/office/officeart/2005/8/layout/hierarchy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kumimoji="1" lang="ja-JP" altLang="en-US"/>
        </a:p>
      </dgm:t>
    </dgm:pt>
    <dgm:pt modelId="{E109C842-DF4D-4874-934A-75C1FC7351FB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sponder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85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E1763E7-869C-494E-8418-3BBF85CADE70}" type="parTrans" cxnId="{B726A5DA-20CD-4976-9A4E-5EB3133307BF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51AF88A-AD0D-40B1-A7E0-0C92826D4A2F}" type="sibTrans" cxnId="{B726A5DA-20CD-4976-9A4E-5EB3133307BF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AD2DF9A-2771-41EE-82AC-8AE16847D661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-RT (+)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75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9F0B53C-A72F-426B-BAC2-1716AD3451E8}" type="parTrans" cxnId="{92AF2E82-49DA-4200-A402-6C3B3CE9418F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40810F0-FAD5-4C8C-A413-C5CE333458BE}" type="sibTrans" cxnId="{92AF2E82-49DA-4200-A402-6C3B3CE9418F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A61E367-4E00-4CD8-84B3-2DF6569EF614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Easy to extract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16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B0C3836-7B96-4E0F-BCE2-2FB91FB731C5}" type="parTrans" cxnId="{0B25096D-4B90-4A58-9C16-078C4509CF1B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2833BA6-35FE-4A4D-8A46-7AF93346F70B}" type="sibTrans" cxnId="{0B25096D-4B90-4A58-9C16-078C4509CF1B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8889E9D-D329-481B-AF93-84C32D4E0FD7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Difficult to extract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59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07952B3-589F-44E8-A4AA-76311DB32698}" type="parTrans" cxnId="{9B0A6342-82D3-4B79-A844-67A906520874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DC0CD68-DBDE-4F9E-B09C-2DB30B54A44E}" type="sibTrans" cxnId="{9B0A6342-82D3-4B79-A844-67A906520874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8A15F87-AEDD-4DB1-BE18-EC822D0CA7E4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-)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3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7D8A148-E4FA-4D45-BC42-0AECBDE79B44}" type="parTrans" cxnId="{D367E06D-2922-40A2-9031-A4524F4B0170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DEF916C-9F12-4741-9F32-BA4819538FFF}" type="sibTrans" cxnId="{D367E06D-2922-40A2-9031-A4524F4B0170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3C68425-05E7-4C12-A123-620DD74A9C33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+)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13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E309D28-DCE2-4D2C-BF93-A1C56DDCB019}" type="parTrans" cxnId="{4D907D3B-A8DA-4E59-9F95-0E02C8819B20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8751693-52FE-4727-BBF2-3BD29DB06B60}" type="sibTrans" cxnId="{4D907D3B-A8DA-4E59-9F95-0E02C8819B20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E69CBCD-724B-4868-A5D2-38D71C261D7E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+)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 N=7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8E56FA4-F9B2-44C5-B73E-D168E408D80F}" type="parTrans" cxnId="{7B952B5A-96DE-495D-8B7A-C3FE8C4578E9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0B81399-5996-4839-B105-28269C4D55C4}" type="sibTrans" cxnId="{7B952B5A-96DE-495D-8B7A-C3FE8C4578E9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23F5703-6868-495A-B483-331C5A6E593F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-)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52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76D7421-9F51-43CE-8093-FF028D0B718E}" type="parTrans" cxnId="{7F877369-8A37-4339-88C6-0E4ABD8C68CB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19716A1-0958-46FB-82D3-BF6BB6E0F5CC}" type="sibTrans" cxnId="{7F877369-8A37-4339-88C6-0E4ABD8C68CB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9FD1F6D-E75B-4D7B-9BC2-511C4B134A9E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 2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7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E4FF110-3041-4645-9009-FEEC7990A23B}" type="parTrans" cxnId="{4A602B56-8F4A-41E5-84A7-964EBD4DF85A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4226182-62A7-4532-B36D-F04F860E553B}" type="sibTrans" cxnId="{4A602B56-8F4A-41E5-84A7-964EBD4DF85A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C90C042-AE96-4730-9F2F-C0ADB2E8E303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2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2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B511C73-67FC-46EA-B918-D3128D8BEA61}" type="parTrans" cxnId="{E963FFCB-45EA-4C6A-865C-16D6BDDCA995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F31E661-3309-4BBF-89B2-A5571824E9AC}" type="sibTrans" cxnId="{E963FFCB-45EA-4C6A-865C-16D6BDDCA995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49F779A-C81B-4090-AB09-24AAD6F05920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 3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1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D95037D-CAF6-4C4E-BA19-8D9873FDA0D0}" type="parTrans" cxnId="{A9BDA42F-700F-46E1-9D81-9B119B996291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4FC4B6F6-1AF1-44DB-AA32-31FB86D5A3A9}" type="sibTrans" cxnId="{A9BDA42F-700F-46E1-9D81-9B119B996291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18CB1CA-2048-4069-9EFC-B61730CBA65F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 2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6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FEDF1E2-3CD3-48D5-8185-AC04ABBD0A3D}" type="parTrans" cxnId="{0608FF6E-C07C-45EC-AF74-635D1579F5E4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9F36917-5EA2-4392-9299-1FC395A8125B}" type="sibTrans" cxnId="{0608FF6E-C07C-45EC-AF74-635D1579F5E4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E303283-046E-49F3-9BAB-66A12C8E0A53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3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6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F1AEF42-44CD-4814-9FB1-4C2121B96481}" type="parTrans" cxnId="{BE3340E5-6D09-475C-AAD7-55E9975ADA46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A98CED0-3861-4ECD-95D9-41BDFCDBA0FD}" type="sibTrans" cxnId="{BE3340E5-6D09-475C-AAD7-55E9975ADA46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44BDE05-49B1-4A4C-A3FC-6C14ABCC2A11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 3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1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4E8429C-29B3-4049-BC32-F949230560FB}" type="parTrans" cxnId="{E5D4D65D-4003-40AA-847E-0B3D54007D3E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7758B9E-4893-4BE8-A722-E595A37B2B0B}" type="sibTrans" cxnId="{E5D4D65D-4003-40AA-847E-0B3D54007D3E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54D7212-5EEE-4758-869D-32648AD83B51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 1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15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84C74068-0EB0-48EA-B56E-0ED57BD49422}" type="parTrans" cxnId="{7F090334-7196-426A-8782-E210F0B64CBE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13C38C0-6DB4-4F02-84F2-D3B2B2F7C906}" type="sibTrans" cxnId="{7F090334-7196-426A-8782-E210F0B64CBE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DF2A722-BC08-434C-9302-EEAFE8DD3294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Group 2 </a:t>
          </a:r>
        </a:p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36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2A73C8A-850C-42EE-902B-B553568776FD}" type="parTrans" cxnId="{7C428793-B08D-4B22-AED7-32430F062EBD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6CDE5DB-20BB-4273-A451-F58CE1ECBFC3}" type="sibTrans" cxnId="{7C428793-B08D-4B22-AED7-32430F062EBD}">
      <dgm:prSet/>
      <dgm:spPr/>
      <dgm:t>
        <a:bodyPr/>
        <a:lstStyle/>
        <a:p>
          <a:endParaRPr kumimoji="1" lang="ja-JP" alt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6A2184B-5326-4B87-8605-1EAF8AEB37B7}">
      <dgm:prSet phldrT="[テキスト]" custT="1"/>
      <dgm:spPr/>
      <dgm:t>
        <a:bodyPr/>
        <a:lstStyle/>
        <a:p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-RT(-)</a:t>
          </a:r>
          <a:r>
            <a: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kumimoji="1"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N=10</a:t>
          </a:r>
          <a:endParaRPr kumimoji="1" lang="ja-JP" alt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97CA720-C083-4FA0-AC78-7626E7A31DA2}" type="parTrans" cxnId="{ADCCA717-A601-434F-A1BB-209169616658}">
      <dgm:prSet/>
      <dgm:spPr/>
      <dgm:t>
        <a:bodyPr/>
        <a:lstStyle/>
        <a:p>
          <a:endParaRPr kumimoji="1" lang="ja-JP" altLang="en-US"/>
        </a:p>
      </dgm:t>
    </dgm:pt>
    <dgm:pt modelId="{F8462B98-31A7-4EDC-8B02-FFDF92077D92}" type="sibTrans" cxnId="{ADCCA717-A601-434F-A1BB-209169616658}">
      <dgm:prSet/>
      <dgm:spPr/>
      <dgm:t>
        <a:bodyPr/>
        <a:lstStyle/>
        <a:p>
          <a:endParaRPr kumimoji="1" lang="ja-JP" altLang="en-US"/>
        </a:p>
      </dgm:t>
    </dgm:pt>
    <dgm:pt modelId="{80A5ACE4-8145-45EF-85F3-0E85BB0F84D2}" type="pres">
      <dgm:prSet presAssocID="{C8F9C77B-5AD7-4D1C-8C82-D5C4C1D80329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F24A1E0D-0FE4-4509-9750-81900F386085}" type="pres">
      <dgm:prSet presAssocID="{E109C842-DF4D-4874-934A-75C1FC7351FB}" presName="hierRoot1" presStyleCnt="0"/>
      <dgm:spPr/>
    </dgm:pt>
    <dgm:pt modelId="{345CE9CB-C8E8-4AB8-95C7-A5E6E0BAF347}" type="pres">
      <dgm:prSet presAssocID="{E109C842-DF4D-4874-934A-75C1FC7351FB}" presName="composite" presStyleCnt="0"/>
      <dgm:spPr/>
    </dgm:pt>
    <dgm:pt modelId="{04AAFA18-63F0-4988-85D0-2D7F5F495905}" type="pres">
      <dgm:prSet presAssocID="{E109C842-DF4D-4874-934A-75C1FC7351FB}" presName="background" presStyleLbl="node0" presStyleIdx="0" presStyleCnt="1"/>
      <dgm:spPr/>
    </dgm:pt>
    <dgm:pt modelId="{CC76E990-510F-44BA-A3D8-7CC09CF70B5D}" type="pres">
      <dgm:prSet presAssocID="{E109C842-DF4D-4874-934A-75C1FC7351FB}" presName="text" presStyleLbl="fgAcc0" presStyleIdx="0" presStyleCnt="1">
        <dgm:presLayoutVars>
          <dgm:chPref val="3"/>
        </dgm:presLayoutVars>
      </dgm:prSet>
      <dgm:spPr/>
    </dgm:pt>
    <dgm:pt modelId="{5AB75C73-C8FA-4E7A-B4F6-1518491E659D}" type="pres">
      <dgm:prSet presAssocID="{E109C842-DF4D-4874-934A-75C1FC7351FB}" presName="hierChild2" presStyleCnt="0"/>
      <dgm:spPr/>
    </dgm:pt>
    <dgm:pt modelId="{D5C62699-8A41-414D-AE54-E06E01E9B5F6}" type="pres">
      <dgm:prSet presAssocID="{997CA720-C083-4FA0-AC78-7626E7A31DA2}" presName="Name10" presStyleLbl="parChTrans1D2" presStyleIdx="0" presStyleCnt="2"/>
      <dgm:spPr/>
    </dgm:pt>
    <dgm:pt modelId="{8E09DC5B-419C-40F4-A9D3-DFCCE5B399DC}" type="pres">
      <dgm:prSet presAssocID="{D6A2184B-5326-4B87-8605-1EAF8AEB37B7}" presName="hierRoot2" presStyleCnt="0"/>
      <dgm:spPr/>
    </dgm:pt>
    <dgm:pt modelId="{8E43902E-C3A6-40DD-8EBF-8FD32C0C9955}" type="pres">
      <dgm:prSet presAssocID="{D6A2184B-5326-4B87-8605-1EAF8AEB37B7}" presName="composite2" presStyleCnt="0"/>
      <dgm:spPr/>
    </dgm:pt>
    <dgm:pt modelId="{B02C5496-8B1A-4517-87D9-494694F82D3E}" type="pres">
      <dgm:prSet presAssocID="{D6A2184B-5326-4B87-8605-1EAF8AEB37B7}" presName="background2" presStyleLbl="node2" presStyleIdx="0" presStyleCnt="2"/>
      <dgm:spPr/>
    </dgm:pt>
    <dgm:pt modelId="{EF741AF2-A701-4F4F-B5D0-3F6DE0D42BDC}" type="pres">
      <dgm:prSet presAssocID="{D6A2184B-5326-4B87-8605-1EAF8AEB37B7}" presName="text2" presStyleLbl="fgAcc2" presStyleIdx="0" presStyleCnt="2">
        <dgm:presLayoutVars>
          <dgm:chPref val="3"/>
        </dgm:presLayoutVars>
      </dgm:prSet>
      <dgm:spPr/>
    </dgm:pt>
    <dgm:pt modelId="{D185645C-4C44-4274-A77E-C0F2CEABD8F1}" type="pres">
      <dgm:prSet presAssocID="{D6A2184B-5326-4B87-8605-1EAF8AEB37B7}" presName="hierChild3" presStyleCnt="0"/>
      <dgm:spPr/>
    </dgm:pt>
    <dgm:pt modelId="{CC3D6616-166B-4F1A-835D-C4983B921AF3}" type="pres">
      <dgm:prSet presAssocID="{E9F0B53C-A72F-426B-BAC2-1716AD3451E8}" presName="Name10" presStyleLbl="parChTrans1D2" presStyleIdx="1" presStyleCnt="2"/>
      <dgm:spPr/>
    </dgm:pt>
    <dgm:pt modelId="{6E7C81C3-D54D-47DC-A22F-714586AE2BE4}" type="pres">
      <dgm:prSet presAssocID="{FAD2DF9A-2771-41EE-82AC-8AE16847D661}" presName="hierRoot2" presStyleCnt="0"/>
      <dgm:spPr/>
    </dgm:pt>
    <dgm:pt modelId="{E16674CA-7224-4BCF-94D8-96F5FF8F6EB7}" type="pres">
      <dgm:prSet presAssocID="{FAD2DF9A-2771-41EE-82AC-8AE16847D661}" presName="composite2" presStyleCnt="0"/>
      <dgm:spPr/>
    </dgm:pt>
    <dgm:pt modelId="{09D3524B-00EB-477F-A906-B97918D328E5}" type="pres">
      <dgm:prSet presAssocID="{FAD2DF9A-2771-41EE-82AC-8AE16847D661}" presName="background2" presStyleLbl="node2" presStyleIdx="1" presStyleCnt="2"/>
      <dgm:spPr/>
    </dgm:pt>
    <dgm:pt modelId="{2540F739-880D-4C70-8B47-819C5AC53D6F}" type="pres">
      <dgm:prSet presAssocID="{FAD2DF9A-2771-41EE-82AC-8AE16847D661}" presName="text2" presStyleLbl="fgAcc2" presStyleIdx="1" presStyleCnt="2">
        <dgm:presLayoutVars>
          <dgm:chPref val="3"/>
        </dgm:presLayoutVars>
      </dgm:prSet>
      <dgm:spPr/>
    </dgm:pt>
    <dgm:pt modelId="{153F37CA-E17A-4B7E-9A3D-47D04264F541}" type="pres">
      <dgm:prSet presAssocID="{FAD2DF9A-2771-41EE-82AC-8AE16847D661}" presName="hierChild3" presStyleCnt="0"/>
      <dgm:spPr/>
    </dgm:pt>
    <dgm:pt modelId="{A6EFC856-ACCC-4510-84DB-192EF9E61DA8}" type="pres">
      <dgm:prSet presAssocID="{2B0C3836-7B96-4E0F-BCE2-2FB91FB731C5}" presName="Name17" presStyleLbl="parChTrans1D3" presStyleIdx="0" presStyleCnt="2"/>
      <dgm:spPr/>
    </dgm:pt>
    <dgm:pt modelId="{5C4D0AAB-88A0-400D-A09D-AB1F29F8EB77}" type="pres">
      <dgm:prSet presAssocID="{FA61E367-4E00-4CD8-84B3-2DF6569EF614}" presName="hierRoot3" presStyleCnt="0"/>
      <dgm:spPr/>
    </dgm:pt>
    <dgm:pt modelId="{7EAC2781-482B-452C-9E72-CFB1647FFF22}" type="pres">
      <dgm:prSet presAssocID="{FA61E367-4E00-4CD8-84B3-2DF6569EF614}" presName="composite3" presStyleCnt="0"/>
      <dgm:spPr/>
    </dgm:pt>
    <dgm:pt modelId="{AA05AB12-323C-4EC7-9AAE-F6C167ED2F24}" type="pres">
      <dgm:prSet presAssocID="{FA61E367-4E00-4CD8-84B3-2DF6569EF614}" presName="background3" presStyleLbl="node3" presStyleIdx="0" presStyleCnt="2"/>
      <dgm:spPr/>
    </dgm:pt>
    <dgm:pt modelId="{DF26862E-F334-49E1-B006-1D136B108AE6}" type="pres">
      <dgm:prSet presAssocID="{FA61E367-4E00-4CD8-84B3-2DF6569EF614}" presName="text3" presStyleLbl="fgAcc3" presStyleIdx="0" presStyleCnt="2">
        <dgm:presLayoutVars>
          <dgm:chPref val="3"/>
        </dgm:presLayoutVars>
      </dgm:prSet>
      <dgm:spPr/>
    </dgm:pt>
    <dgm:pt modelId="{B18520FF-86FF-421C-B466-6536844BBCAC}" type="pres">
      <dgm:prSet presAssocID="{FA61E367-4E00-4CD8-84B3-2DF6569EF614}" presName="hierChild4" presStyleCnt="0"/>
      <dgm:spPr/>
    </dgm:pt>
    <dgm:pt modelId="{38E8D6DB-B3B2-44B5-BD68-245B285F1D4D}" type="pres">
      <dgm:prSet presAssocID="{2E309D28-DCE2-4D2C-BF93-A1C56DDCB019}" presName="Name23" presStyleLbl="parChTrans1D4" presStyleIdx="0" presStyleCnt="12"/>
      <dgm:spPr/>
    </dgm:pt>
    <dgm:pt modelId="{02CE8FA6-10ED-4E7E-A533-6566CFB9A90C}" type="pres">
      <dgm:prSet presAssocID="{73C68425-05E7-4C12-A123-620DD74A9C33}" presName="hierRoot4" presStyleCnt="0"/>
      <dgm:spPr/>
    </dgm:pt>
    <dgm:pt modelId="{DDFE3686-0292-4B23-92DE-30EA3D7DB1F9}" type="pres">
      <dgm:prSet presAssocID="{73C68425-05E7-4C12-A123-620DD74A9C33}" presName="composite4" presStyleCnt="0"/>
      <dgm:spPr/>
    </dgm:pt>
    <dgm:pt modelId="{78B236F7-9A9F-47E1-9F07-31C60A9EB8C2}" type="pres">
      <dgm:prSet presAssocID="{73C68425-05E7-4C12-A123-620DD74A9C33}" presName="background4" presStyleLbl="node4" presStyleIdx="0" presStyleCnt="12"/>
      <dgm:spPr/>
    </dgm:pt>
    <dgm:pt modelId="{67766ADD-A194-4432-A7A9-11F069D5B965}" type="pres">
      <dgm:prSet presAssocID="{73C68425-05E7-4C12-A123-620DD74A9C33}" presName="text4" presStyleLbl="fgAcc4" presStyleIdx="0" presStyleCnt="12" custScaleX="138017" custLinFactNeighborX="8064" custLinFactNeighborY="3855">
        <dgm:presLayoutVars>
          <dgm:chPref val="3"/>
        </dgm:presLayoutVars>
      </dgm:prSet>
      <dgm:spPr/>
    </dgm:pt>
    <dgm:pt modelId="{B00BE78D-595A-43D6-B57D-FFBBAE2A78BA}" type="pres">
      <dgm:prSet presAssocID="{73C68425-05E7-4C12-A123-620DD74A9C33}" presName="hierChild5" presStyleCnt="0"/>
      <dgm:spPr/>
    </dgm:pt>
    <dgm:pt modelId="{CFB98C59-4220-44BB-B9B0-52F22164B30F}" type="pres">
      <dgm:prSet presAssocID="{1FEDF1E2-3CD3-48D5-8185-AC04ABBD0A3D}" presName="Name23" presStyleLbl="parChTrans1D4" presStyleIdx="1" presStyleCnt="12"/>
      <dgm:spPr/>
    </dgm:pt>
    <dgm:pt modelId="{43ECD03C-03AC-49DA-9A4B-868DD8E2CA99}" type="pres">
      <dgm:prSet presAssocID="{A18CB1CA-2048-4069-9EFC-B61730CBA65F}" presName="hierRoot4" presStyleCnt="0"/>
      <dgm:spPr/>
    </dgm:pt>
    <dgm:pt modelId="{E68ACD10-D7AB-4E4E-AB27-68F7D8F22882}" type="pres">
      <dgm:prSet presAssocID="{A18CB1CA-2048-4069-9EFC-B61730CBA65F}" presName="composite4" presStyleCnt="0"/>
      <dgm:spPr/>
    </dgm:pt>
    <dgm:pt modelId="{9A1CC577-1548-482B-B7A4-47D02F050469}" type="pres">
      <dgm:prSet presAssocID="{A18CB1CA-2048-4069-9EFC-B61730CBA65F}" presName="background4" presStyleLbl="node4" presStyleIdx="1" presStyleCnt="12"/>
      <dgm:spPr/>
    </dgm:pt>
    <dgm:pt modelId="{43DEEE5D-E6F2-4179-8188-995C3E6E815D}" type="pres">
      <dgm:prSet presAssocID="{A18CB1CA-2048-4069-9EFC-B61730CBA65F}" presName="text4" presStyleLbl="fgAcc4" presStyleIdx="1" presStyleCnt="12">
        <dgm:presLayoutVars>
          <dgm:chPref val="3"/>
        </dgm:presLayoutVars>
      </dgm:prSet>
      <dgm:spPr/>
    </dgm:pt>
    <dgm:pt modelId="{F35BB6EC-BDB9-49C2-AC4F-5073CD6A1E28}" type="pres">
      <dgm:prSet presAssocID="{A18CB1CA-2048-4069-9EFC-B61730CBA65F}" presName="hierChild5" presStyleCnt="0"/>
      <dgm:spPr/>
    </dgm:pt>
    <dgm:pt modelId="{0DB36F63-04D3-42CC-A08E-1E1D6E4E2822}" type="pres">
      <dgm:prSet presAssocID="{8F1AEF42-44CD-4814-9FB1-4C2121B96481}" presName="Name23" presStyleLbl="parChTrans1D4" presStyleIdx="2" presStyleCnt="12"/>
      <dgm:spPr/>
    </dgm:pt>
    <dgm:pt modelId="{6D39F739-1EF6-437D-92BA-F7C9466B7E6D}" type="pres">
      <dgm:prSet presAssocID="{BE303283-046E-49F3-9BAB-66A12C8E0A53}" presName="hierRoot4" presStyleCnt="0"/>
      <dgm:spPr/>
    </dgm:pt>
    <dgm:pt modelId="{BE73F52C-9B96-4850-B6B4-6C16BA4075E9}" type="pres">
      <dgm:prSet presAssocID="{BE303283-046E-49F3-9BAB-66A12C8E0A53}" presName="composite4" presStyleCnt="0"/>
      <dgm:spPr/>
    </dgm:pt>
    <dgm:pt modelId="{4AAE161A-3AAC-4A2C-82FF-B9E743E0E7CF}" type="pres">
      <dgm:prSet presAssocID="{BE303283-046E-49F3-9BAB-66A12C8E0A53}" presName="background4" presStyleLbl="node4" presStyleIdx="2" presStyleCnt="12"/>
      <dgm:spPr/>
    </dgm:pt>
    <dgm:pt modelId="{678CB666-E6F0-486B-B4F0-76147EB28DE4}" type="pres">
      <dgm:prSet presAssocID="{BE303283-046E-49F3-9BAB-66A12C8E0A53}" presName="text4" presStyleLbl="fgAcc4" presStyleIdx="2" presStyleCnt="12">
        <dgm:presLayoutVars>
          <dgm:chPref val="3"/>
        </dgm:presLayoutVars>
      </dgm:prSet>
      <dgm:spPr/>
    </dgm:pt>
    <dgm:pt modelId="{DFF06C54-7090-454E-B4D2-66A590D30FB4}" type="pres">
      <dgm:prSet presAssocID="{BE303283-046E-49F3-9BAB-66A12C8E0A53}" presName="hierChild5" presStyleCnt="0"/>
      <dgm:spPr/>
    </dgm:pt>
    <dgm:pt modelId="{4E13EBBF-CFCF-4B42-AC2D-763F318D5A08}" type="pres">
      <dgm:prSet presAssocID="{17D8A148-E4FA-4D45-BC42-0AECBDE79B44}" presName="Name23" presStyleLbl="parChTrans1D4" presStyleIdx="3" presStyleCnt="12"/>
      <dgm:spPr/>
    </dgm:pt>
    <dgm:pt modelId="{3F8C11B2-EF24-4904-AB65-A51AA3F99FFE}" type="pres">
      <dgm:prSet presAssocID="{D8A15F87-AEDD-4DB1-BE18-EC822D0CA7E4}" presName="hierRoot4" presStyleCnt="0"/>
      <dgm:spPr/>
    </dgm:pt>
    <dgm:pt modelId="{E4DF6107-08E1-4B67-8F6C-8F1516453454}" type="pres">
      <dgm:prSet presAssocID="{D8A15F87-AEDD-4DB1-BE18-EC822D0CA7E4}" presName="composite4" presStyleCnt="0"/>
      <dgm:spPr/>
    </dgm:pt>
    <dgm:pt modelId="{6FA0F4EB-7B95-4C80-A348-F48AE57E9EAF}" type="pres">
      <dgm:prSet presAssocID="{D8A15F87-AEDD-4DB1-BE18-EC822D0CA7E4}" presName="background4" presStyleLbl="node4" presStyleIdx="3" presStyleCnt="12"/>
      <dgm:spPr/>
    </dgm:pt>
    <dgm:pt modelId="{3D0E944D-D50E-4AF0-9738-A657EB5AC76A}" type="pres">
      <dgm:prSet presAssocID="{D8A15F87-AEDD-4DB1-BE18-EC822D0CA7E4}" presName="text4" presStyleLbl="fgAcc4" presStyleIdx="3" presStyleCnt="12" custScaleX="147139">
        <dgm:presLayoutVars>
          <dgm:chPref val="3"/>
        </dgm:presLayoutVars>
      </dgm:prSet>
      <dgm:spPr/>
    </dgm:pt>
    <dgm:pt modelId="{2B3372D1-DFCA-47E9-898F-DC4AC1E37AD2}" type="pres">
      <dgm:prSet presAssocID="{D8A15F87-AEDD-4DB1-BE18-EC822D0CA7E4}" presName="hierChild5" presStyleCnt="0"/>
      <dgm:spPr/>
    </dgm:pt>
    <dgm:pt modelId="{2A90E2CB-1107-439F-9345-F7C1191605A9}" type="pres">
      <dgm:prSet presAssocID="{CB511C73-67FC-46EA-B918-D3128D8BEA61}" presName="Name23" presStyleLbl="parChTrans1D4" presStyleIdx="4" presStyleCnt="12"/>
      <dgm:spPr/>
    </dgm:pt>
    <dgm:pt modelId="{F647E5E9-C27F-4F01-B021-D1867B96D88C}" type="pres">
      <dgm:prSet presAssocID="{7C90C042-AE96-4730-9F2F-C0ADB2E8E303}" presName="hierRoot4" presStyleCnt="0"/>
      <dgm:spPr/>
    </dgm:pt>
    <dgm:pt modelId="{ED0C6B9A-7A22-4CA7-AD4B-C74943C30BA8}" type="pres">
      <dgm:prSet presAssocID="{7C90C042-AE96-4730-9F2F-C0ADB2E8E303}" presName="composite4" presStyleCnt="0"/>
      <dgm:spPr/>
    </dgm:pt>
    <dgm:pt modelId="{4BAD7874-3DAF-47F0-8419-9A9391976DDF}" type="pres">
      <dgm:prSet presAssocID="{7C90C042-AE96-4730-9F2F-C0ADB2E8E303}" presName="background4" presStyleLbl="node4" presStyleIdx="4" presStyleCnt="12"/>
      <dgm:spPr/>
    </dgm:pt>
    <dgm:pt modelId="{D05B2C5A-8E19-4289-B5DB-23851939C00A}" type="pres">
      <dgm:prSet presAssocID="{7C90C042-AE96-4730-9F2F-C0ADB2E8E303}" presName="text4" presStyleLbl="fgAcc4" presStyleIdx="4" presStyleCnt="12">
        <dgm:presLayoutVars>
          <dgm:chPref val="3"/>
        </dgm:presLayoutVars>
      </dgm:prSet>
      <dgm:spPr/>
    </dgm:pt>
    <dgm:pt modelId="{5706280A-B609-4B6B-8ED6-CB3D0F4FEF3D}" type="pres">
      <dgm:prSet presAssocID="{7C90C042-AE96-4730-9F2F-C0ADB2E8E303}" presName="hierChild5" presStyleCnt="0"/>
      <dgm:spPr/>
    </dgm:pt>
    <dgm:pt modelId="{6FD6D4F6-6A40-470E-9FCC-70A6BAF98C9E}" type="pres">
      <dgm:prSet presAssocID="{9D95037D-CAF6-4C4E-BA19-8D9873FDA0D0}" presName="Name23" presStyleLbl="parChTrans1D4" presStyleIdx="5" presStyleCnt="12"/>
      <dgm:spPr/>
    </dgm:pt>
    <dgm:pt modelId="{859449C4-EB9D-4E25-B988-99E6EBC02FD3}" type="pres">
      <dgm:prSet presAssocID="{949F779A-C81B-4090-AB09-24AAD6F05920}" presName="hierRoot4" presStyleCnt="0"/>
      <dgm:spPr/>
    </dgm:pt>
    <dgm:pt modelId="{2CEE9840-B782-46BA-9B21-B1C78A0142C2}" type="pres">
      <dgm:prSet presAssocID="{949F779A-C81B-4090-AB09-24AAD6F05920}" presName="composite4" presStyleCnt="0"/>
      <dgm:spPr/>
    </dgm:pt>
    <dgm:pt modelId="{08764D7D-4C59-48F9-8F17-2540D8396F34}" type="pres">
      <dgm:prSet presAssocID="{949F779A-C81B-4090-AB09-24AAD6F05920}" presName="background4" presStyleLbl="node4" presStyleIdx="5" presStyleCnt="12"/>
      <dgm:spPr/>
    </dgm:pt>
    <dgm:pt modelId="{C3027C78-6028-4933-B85E-4EEC9B64E5CD}" type="pres">
      <dgm:prSet presAssocID="{949F779A-C81B-4090-AB09-24AAD6F05920}" presName="text4" presStyleLbl="fgAcc4" presStyleIdx="5" presStyleCnt="12">
        <dgm:presLayoutVars>
          <dgm:chPref val="3"/>
        </dgm:presLayoutVars>
      </dgm:prSet>
      <dgm:spPr/>
    </dgm:pt>
    <dgm:pt modelId="{E3F681BA-6BA1-447A-80D3-7D78C1F71B70}" type="pres">
      <dgm:prSet presAssocID="{949F779A-C81B-4090-AB09-24AAD6F05920}" presName="hierChild5" presStyleCnt="0"/>
      <dgm:spPr/>
    </dgm:pt>
    <dgm:pt modelId="{4436436E-6CDE-4D95-BFED-4C2725194863}" type="pres">
      <dgm:prSet presAssocID="{607952B3-589F-44E8-A4AA-76311DB32698}" presName="Name17" presStyleLbl="parChTrans1D3" presStyleIdx="1" presStyleCnt="2"/>
      <dgm:spPr/>
    </dgm:pt>
    <dgm:pt modelId="{C1ED6E50-ED94-4B65-863B-38B8DE33F68D}" type="pres">
      <dgm:prSet presAssocID="{68889E9D-D329-481B-AF93-84C32D4E0FD7}" presName="hierRoot3" presStyleCnt="0"/>
      <dgm:spPr/>
    </dgm:pt>
    <dgm:pt modelId="{A6F5D357-9B0F-42C1-9892-213DE8DF1233}" type="pres">
      <dgm:prSet presAssocID="{68889E9D-D329-481B-AF93-84C32D4E0FD7}" presName="composite3" presStyleCnt="0"/>
      <dgm:spPr/>
    </dgm:pt>
    <dgm:pt modelId="{40000CE0-B1C7-48C9-AF87-E5AC362B1169}" type="pres">
      <dgm:prSet presAssocID="{68889E9D-D329-481B-AF93-84C32D4E0FD7}" presName="background3" presStyleLbl="node3" presStyleIdx="1" presStyleCnt="2"/>
      <dgm:spPr/>
    </dgm:pt>
    <dgm:pt modelId="{A43C7995-EE0A-4B55-8C55-E73B9AF18DD6}" type="pres">
      <dgm:prSet presAssocID="{68889E9D-D329-481B-AF93-84C32D4E0FD7}" presName="text3" presStyleLbl="fgAcc3" presStyleIdx="1" presStyleCnt="2">
        <dgm:presLayoutVars>
          <dgm:chPref val="3"/>
        </dgm:presLayoutVars>
      </dgm:prSet>
      <dgm:spPr/>
    </dgm:pt>
    <dgm:pt modelId="{51A905D0-97BB-4E42-B745-AD88BFBAE9BF}" type="pres">
      <dgm:prSet presAssocID="{68889E9D-D329-481B-AF93-84C32D4E0FD7}" presName="hierChild4" presStyleCnt="0"/>
      <dgm:spPr/>
    </dgm:pt>
    <dgm:pt modelId="{DA67402F-85C9-46EB-A8A4-A5D4E89817E4}" type="pres">
      <dgm:prSet presAssocID="{28E56FA4-F9B2-44C5-B73E-D168E408D80F}" presName="Name23" presStyleLbl="parChTrans1D4" presStyleIdx="6" presStyleCnt="12"/>
      <dgm:spPr/>
    </dgm:pt>
    <dgm:pt modelId="{4E9A45B0-E529-498B-B9AD-33E8FEC9DB63}" type="pres">
      <dgm:prSet presAssocID="{1E69CBCD-724B-4868-A5D2-38D71C261D7E}" presName="hierRoot4" presStyleCnt="0"/>
      <dgm:spPr/>
    </dgm:pt>
    <dgm:pt modelId="{4879F727-BEDA-48D5-82BF-FB6D4F544D95}" type="pres">
      <dgm:prSet presAssocID="{1E69CBCD-724B-4868-A5D2-38D71C261D7E}" presName="composite4" presStyleCnt="0"/>
      <dgm:spPr/>
    </dgm:pt>
    <dgm:pt modelId="{E6AFA5F8-F0FA-4179-8235-23184592B669}" type="pres">
      <dgm:prSet presAssocID="{1E69CBCD-724B-4868-A5D2-38D71C261D7E}" presName="background4" presStyleLbl="node4" presStyleIdx="6" presStyleCnt="12"/>
      <dgm:spPr/>
    </dgm:pt>
    <dgm:pt modelId="{CF237029-440B-4624-81A5-A5BA041163D8}" type="pres">
      <dgm:prSet presAssocID="{1E69CBCD-724B-4868-A5D2-38D71C261D7E}" presName="text4" presStyleLbl="fgAcc4" presStyleIdx="6" presStyleCnt="12" custScaleX="163571" custLinFactNeighborX="-6" custLinFactNeighborY="-2379">
        <dgm:presLayoutVars>
          <dgm:chPref val="3"/>
        </dgm:presLayoutVars>
      </dgm:prSet>
      <dgm:spPr/>
    </dgm:pt>
    <dgm:pt modelId="{2519DAD4-2238-4374-A880-ABED05C00428}" type="pres">
      <dgm:prSet presAssocID="{1E69CBCD-724B-4868-A5D2-38D71C261D7E}" presName="hierChild5" presStyleCnt="0"/>
      <dgm:spPr/>
    </dgm:pt>
    <dgm:pt modelId="{DC155B66-3E06-4B93-87AD-64FF92E4BCEB}" type="pres">
      <dgm:prSet presAssocID="{FE4FF110-3041-4645-9009-FEEC7990A23B}" presName="Name23" presStyleLbl="parChTrans1D4" presStyleIdx="7" presStyleCnt="12"/>
      <dgm:spPr/>
    </dgm:pt>
    <dgm:pt modelId="{85D74C60-ABF6-4457-BD58-B37CBD64EF9C}" type="pres">
      <dgm:prSet presAssocID="{A9FD1F6D-E75B-4D7B-9BC2-511C4B134A9E}" presName="hierRoot4" presStyleCnt="0"/>
      <dgm:spPr/>
    </dgm:pt>
    <dgm:pt modelId="{0C5B35FE-9D1E-4658-885F-E5746A411003}" type="pres">
      <dgm:prSet presAssocID="{A9FD1F6D-E75B-4D7B-9BC2-511C4B134A9E}" presName="composite4" presStyleCnt="0"/>
      <dgm:spPr/>
    </dgm:pt>
    <dgm:pt modelId="{0FFDABD6-31C4-4061-88B4-E8216447B88D}" type="pres">
      <dgm:prSet presAssocID="{A9FD1F6D-E75B-4D7B-9BC2-511C4B134A9E}" presName="background4" presStyleLbl="node4" presStyleIdx="7" presStyleCnt="12"/>
      <dgm:spPr/>
    </dgm:pt>
    <dgm:pt modelId="{341F1C0F-3227-4AF7-A235-7B8715329ED2}" type="pres">
      <dgm:prSet presAssocID="{A9FD1F6D-E75B-4D7B-9BC2-511C4B134A9E}" presName="text4" presStyleLbl="fgAcc4" presStyleIdx="7" presStyleCnt="12">
        <dgm:presLayoutVars>
          <dgm:chPref val="3"/>
        </dgm:presLayoutVars>
      </dgm:prSet>
      <dgm:spPr/>
    </dgm:pt>
    <dgm:pt modelId="{FE0007A4-C4D6-4A36-A474-BA63BEC562FC}" type="pres">
      <dgm:prSet presAssocID="{A9FD1F6D-E75B-4D7B-9BC2-511C4B134A9E}" presName="hierChild5" presStyleCnt="0"/>
      <dgm:spPr/>
    </dgm:pt>
    <dgm:pt modelId="{5B9643E3-212C-47EF-AFB2-973F1D8AF02C}" type="pres">
      <dgm:prSet presAssocID="{D76D7421-9F51-43CE-8093-FF028D0B718E}" presName="Name23" presStyleLbl="parChTrans1D4" presStyleIdx="8" presStyleCnt="12"/>
      <dgm:spPr/>
    </dgm:pt>
    <dgm:pt modelId="{D010951F-8DED-4C5B-A136-6D57C0E2E402}" type="pres">
      <dgm:prSet presAssocID="{523F5703-6868-495A-B483-331C5A6E593F}" presName="hierRoot4" presStyleCnt="0"/>
      <dgm:spPr/>
    </dgm:pt>
    <dgm:pt modelId="{597047E5-926F-4E76-A26C-7FA0AAB2DE61}" type="pres">
      <dgm:prSet presAssocID="{523F5703-6868-495A-B483-331C5A6E593F}" presName="composite4" presStyleCnt="0"/>
      <dgm:spPr/>
    </dgm:pt>
    <dgm:pt modelId="{95579AF6-662F-431F-B58B-EE34010936B8}" type="pres">
      <dgm:prSet presAssocID="{523F5703-6868-495A-B483-331C5A6E593F}" presName="background4" presStyleLbl="node4" presStyleIdx="8" presStyleCnt="12"/>
      <dgm:spPr/>
    </dgm:pt>
    <dgm:pt modelId="{5760BCE9-AB1D-4728-AD00-CDF562149757}" type="pres">
      <dgm:prSet presAssocID="{523F5703-6868-495A-B483-331C5A6E593F}" presName="text4" presStyleLbl="fgAcc4" presStyleIdx="8" presStyleCnt="12" custScaleX="134373">
        <dgm:presLayoutVars>
          <dgm:chPref val="3"/>
        </dgm:presLayoutVars>
      </dgm:prSet>
      <dgm:spPr/>
    </dgm:pt>
    <dgm:pt modelId="{FFFB71CD-535E-4340-AFAA-00B373529DF3}" type="pres">
      <dgm:prSet presAssocID="{523F5703-6868-495A-B483-331C5A6E593F}" presName="hierChild5" presStyleCnt="0"/>
      <dgm:spPr/>
    </dgm:pt>
    <dgm:pt modelId="{D0AE4843-8660-4C5B-B3C1-2CE71B3AB30F}" type="pres">
      <dgm:prSet presAssocID="{84C74068-0EB0-48EA-B56E-0ED57BD49422}" presName="Name23" presStyleLbl="parChTrans1D4" presStyleIdx="9" presStyleCnt="12"/>
      <dgm:spPr/>
    </dgm:pt>
    <dgm:pt modelId="{0D2F9DDE-5B99-4E0A-B86C-AB2A7F2F5033}" type="pres">
      <dgm:prSet presAssocID="{B54D7212-5EEE-4758-869D-32648AD83B51}" presName="hierRoot4" presStyleCnt="0"/>
      <dgm:spPr/>
    </dgm:pt>
    <dgm:pt modelId="{1AAFDD6B-F511-408A-91DC-B5506F6A8052}" type="pres">
      <dgm:prSet presAssocID="{B54D7212-5EEE-4758-869D-32648AD83B51}" presName="composite4" presStyleCnt="0"/>
      <dgm:spPr/>
    </dgm:pt>
    <dgm:pt modelId="{5FD9B2AF-5360-461C-894A-FF1571664C12}" type="pres">
      <dgm:prSet presAssocID="{B54D7212-5EEE-4758-869D-32648AD83B51}" presName="background4" presStyleLbl="node4" presStyleIdx="9" presStyleCnt="12"/>
      <dgm:spPr/>
    </dgm:pt>
    <dgm:pt modelId="{B7878799-F1DC-4554-AE5D-47CB77E50709}" type="pres">
      <dgm:prSet presAssocID="{B54D7212-5EEE-4758-869D-32648AD83B51}" presName="text4" presStyleLbl="fgAcc4" presStyleIdx="9" presStyleCnt="12">
        <dgm:presLayoutVars>
          <dgm:chPref val="3"/>
        </dgm:presLayoutVars>
      </dgm:prSet>
      <dgm:spPr/>
    </dgm:pt>
    <dgm:pt modelId="{69849324-92F4-48DB-8C12-AD17247532DB}" type="pres">
      <dgm:prSet presAssocID="{B54D7212-5EEE-4758-869D-32648AD83B51}" presName="hierChild5" presStyleCnt="0"/>
      <dgm:spPr/>
    </dgm:pt>
    <dgm:pt modelId="{DB3B5C08-D1F7-44C5-B95C-C648118EEA81}" type="pres">
      <dgm:prSet presAssocID="{E2A73C8A-850C-42EE-902B-B553568776FD}" presName="Name23" presStyleLbl="parChTrans1D4" presStyleIdx="10" presStyleCnt="12"/>
      <dgm:spPr/>
    </dgm:pt>
    <dgm:pt modelId="{AF9C41BC-F9FA-4884-93A9-E097BBF64C03}" type="pres">
      <dgm:prSet presAssocID="{CDF2A722-BC08-434C-9302-EEAFE8DD3294}" presName="hierRoot4" presStyleCnt="0"/>
      <dgm:spPr/>
    </dgm:pt>
    <dgm:pt modelId="{75A02C9B-7282-4DAC-89F3-DFD81F13E356}" type="pres">
      <dgm:prSet presAssocID="{CDF2A722-BC08-434C-9302-EEAFE8DD3294}" presName="composite4" presStyleCnt="0"/>
      <dgm:spPr/>
    </dgm:pt>
    <dgm:pt modelId="{FBDD335C-C949-48C2-A132-0809D66F372D}" type="pres">
      <dgm:prSet presAssocID="{CDF2A722-BC08-434C-9302-EEAFE8DD3294}" presName="background4" presStyleLbl="node4" presStyleIdx="10" presStyleCnt="12"/>
      <dgm:spPr/>
    </dgm:pt>
    <dgm:pt modelId="{ED224E1D-0067-4F05-AFE3-A9C67BD8C9A3}" type="pres">
      <dgm:prSet presAssocID="{CDF2A722-BC08-434C-9302-EEAFE8DD3294}" presName="text4" presStyleLbl="fgAcc4" presStyleIdx="10" presStyleCnt="12">
        <dgm:presLayoutVars>
          <dgm:chPref val="3"/>
        </dgm:presLayoutVars>
      </dgm:prSet>
      <dgm:spPr/>
    </dgm:pt>
    <dgm:pt modelId="{0A8B33C1-BDBF-496E-934A-6DA90A591D58}" type="pres">
      <dgm:prSet presAssocID="{CDF2A722-BC08-434C-9302-EEAFE8DD3294}" presName="hierChild5" presStyleCnt="0"/>
      <dgm:spPr/>
    </dgm:pt>
    <dgm:pt modelId="{3997403E-F5E5-4EC0-9471-3AB3C5E31471}" type="pres">
      <dgm:prSet presAssocID="{04E8429C-29B3-4049-BC32-F949230560FB}" presName="Name23" presStyleLbl="parChTrans1D4" presStyleIdx="11" presStyleCnt="12"/>
      <dgm:spPr/>
    </dgm:pt>
    <dgm:pt modelId="{A157160F-F28F-4470-81EC-50EDD75A1A3A}" type="pres">
      <dgm:prSet presAssocID="{044BDE05-49B1-4A4C-A3FC-6C14ABCC2A11}" presName="hierRoot4" presStyleCnt="0"/>
      <dgm:spPr/>
    </dgm:pt>
    <dgm:pt modelId="{1A43FDA4-162E-496D-8641-A92DC812E3CB}" type="pres">
      <dgm:prSet presAssocID="{044BDE05-49B1-4A4C-A3FC-6C14ABCC2A11}" presName="composite4" presStyleCnt="0"/>
      <dgm:spPr/>
    </dgm:pt>
    <dgm:pt modelId="{C1333C45-0B57-49A1-A0E5-46A00867DCAB}" type="pres">
      <dgm:prSet presAssocID="{044BDE05-49B1-4A4C-A3FC-6C14ABCC2A11}" presName="background4" presStyleLbl="node4" presStyleIdx="11" presStyleCnt="12"/>
      <dgm:spPr/>
    </dgm:pt>
    <dgm:pt modelId="{1103C920-D68B-49CA-B05E-821269F69490}" type="pres">
      <dgm:prSet presAssocID="{044BDE05-49B1-4A4C-A3FC-6C14ABCC2A11}" presName="text4" presStyleLbl="fgAcc4" presStyleIdx="11" presStyleCnt="12">
        <dgm:presLayoutVars>
          <dgm:chPref val="3"/>
        </dgm:presLayoutVars>
      </dgm:prSet>
      <dgm:spPr/>
    </dgm:pt>
    <dgm:pt modelId="{1804CA77-D9A6-437C-9ADC-3818E5149CD1}" type="pres">
      <dgm:prSet presAssocID="{044BDE05-49B1-4A4C-A3FC-6C14ABCC2A11}" presName="hierChild5" presStyleCnt="0"/>
      <dgm:spPr/>
    </dgm:pt>
  </dgm:ptLst>
  <dgm:cxnLst>
    <dgm:cxn modelId="{81BE3D03-53BF-4712-9331-0FBB411DD688}" type="presOf" srcId="{9D95037D-CAF6-4C4E-BA19-8D9873FDA0D0}" destId="{6FD6D4F6-6A40-470E-9FCC-70A6BAF98C9E}" srcOrd="0" destOrd="0" presId="urn:microsoft.com/office/officeart/2005/8/layout/hierarchy1"/>
    <dgm:cxn modelId="{8C1B0406-907D-4EC9-9342-253953A2344F}" type="presOf" srcId="{7C90C042-AE96-4730-9F2F-C0ADB2E8E303}" destId="{D05B2C5A-8E19-4289-B5DB-23851939C00A}" srcOrd="0" destOrd="0" presId="urn:microsoft.com/office/officeart/2005/8/layout/hierarchy1"/>
    <dgm:cxn modelId="{BC8BBC0C-ECA0-4AA3-97BA-5E63AD589885}" type="presOf" srcId="{CDF2A722-BC08-434C-9302-EEAFE8DD3294}" destId="{ED224E1D-0067-4F05-AFE3-A9C67BD8C9A3}" srcOrd="0" destOrd="0" presId="urn:microsoft.com/office/officeart/2005/8/layout/hierarchy1"/>
    <dgm:cxn modelId="{E5182411-AE4D-4303-BF92-45823DE33D60}" type="presOf" srcId="{68889E9D-D329-481B-AF93-84C32D4E0FD7}" destId="{A43C7995-EE0A-4B55-8C55-E73B9AF18DD6}" srcOrd="0" destOrd="0" presId="urn:microsoft.com/office/officeart/2005/8/layout/hierarchy1"/>
    <dgm:cxn modelId="{ADCCA717-A601-434F-A1BB-209169616658}" srcId="{E109C842-DF4D-4874-934A-75C1FC7351FB}" destId="{D6A2184B-5326-4B87-8605-1EAF8AEB37B7}" srcOrd="0" destOrd="0" parTransId="{997CA720-C083-4FA0-AC78-7626E7A31DA2}" sibTransId="{F8462B98-31A7-4EDC-8B02-FFDF92077D92}"/>
    <dgm:cxn modelId="{19E3B617-2489-4C5F-A0E1-5A2FF747567B}" type="presOf" srcId="{17D8A148-E4FA-4D45-BC42-0AECBDE79B44}" destId="{4E13EBBF-CFCF-4B42-AC2D-763F318D5A08}" srcOrd="0" destOrd="0" presId="urn:microsoft.com/office/officeart/2005/8/layout/hierarchy1"/>
    <dgm:cxn modelId="{077A6D21-899E-4ADD-ACFC-38978D06BB98}" type="presOf" srcId="{1E69CBCD-724B-4868-A5D2-38D71C261D7E}" destId="{CF237029-440B-4624-81A5-A5BA041163D8}" srcOrd="0" destOrd="0" presId="urn:microsoft.com/office/officeart/2005/8/layout/hierarchy1"/>
    <dgm:cxn modelId="{055D2225-EAFA-4C4F-9881-9A13B97C5597}" type="presOf" srcId="{FAD2DF9A-2771-41EE-82AC-8AE16847D661}" destId="{2540F739-880D-4C70-8B47-819C5AC53D6F}" srcOrd="0" destOrd="0" presId="urn:microsoft.com/office/officeart/2005/8/layout/hierarchy1"/>
    <dgm:cxn modelId="{FC4F6E25-DFBD-4007-AC37-09A626FECF76}" type="presOf" srcId="{2B0C3836-7B96-4E0F-BCE2-2FB91FB731C5}" destId="{A6EFC856-ACCC-4510-84DB-192EF9E61DA8}" srcOrd="0" destOrd="0" presId="urn:microsoft.com/office/officeart/2005/8/layout/hierarchy1"/>
    <dgm:cxn modelId="{1CFE8925-ADB8-4C21-BE8D-F866595D386C}" type="presOf" srcId="{84C74068-0EB0-48EA-B56E-0ED57BD49422}" destId="{D0AE4843-8660-4C5B-B3C1-2CE71B3AB30F}" srcOrd="0" destOrd="0" presId="urn:microsoft.com/office/officeart/2005/8/layout/hierarchy1"/>
    <dgm:cxn modelId="{7D4B1D27-F2D5-48F5-8917-F730A210F6EB}" type="presOf" srcId="{E2A73C8A-850C-42EE-902B-B553568776FD}" destId="{DB3B5C08-D1F7-44C5-B95C-C648118EEA81}" srcOrd="0" destOrd="0" presId="urn:microsoft.com/office/officeart/2005/8/layout/hierarchy1"/>
    <dgm:cxn modelId="{4C6BFC29-3522-47A2-94BC-C43233572BA0}" type="presOf" srcId="{044BDE05-49B1-4A4C-A3FC-6C14ABCC2A11}" destId="{1103C920-D68B-49CA-B05E-821269F69490}" srcOrd="0" destOrd="0" presId="urn:microsoft.com/office/officeart/2005/8/layout/hierarchy1"/>
    <dgm:cxn modelId="{A9BDA42F-700F-46E1-9D81-9B119B996291}" srcId="{D8A15F87-AEDD-4DB1-BE18-EC822D0CA7E4}" destId="{949F779A-C81B-4090-AB09-24AAD6F05920}" srcOrd="1" destOrd="0" parTransId="{9D95037D-CAF6-4C4E-BA19-8D9873FDA0D0}" sibTransId="{4FC4B6F6-1AF1-44DB-AA32-31FB86D5A3A9}"/>
    <dgm:cxn modelId="{27B63232-1B62-413B-874B-63E10F80F7D7}" type="presOf" srcId="{D76D7421-9F51-43CE-8093-FF028D0B718E}" destId="{5B9643E3-212C-47EF-AFB2-973F1D8AF02C}" srcOrd="0" destOrd="0" presId="urn:microsoft.com/office/officeart/2005/8/layout/hierarchy1"/>
    <dgm:cxn modelId="{7F090334-7196-426A-8782-E210F0B64CBE}" srcId="{523F5703-6868-495A-B483-331C5A6E593F}" destId="{B54D7212-5EEE-4758-869D-32648AD83B51}" srcOrd="0" destOrd="0" parTransId="{84C74068-0EB0-48EA-B56E-0ED57BD49422}" sibTransId="{513C38C0-6DB4-4F02-84F2-D3B2B2F7C906}"/>
    <dgm:cxn modelId="{DB110035-0502-44FE-98AB-84843469BCA4}" type="presOf" srcId="{1FEDF1E2-3CD3-48D5-8185-AC04ABBD0A3D}" destId="{CFB98C59-4220-44BB-B9B0-52F22164B30F}" srcOrd="0" destOrd="0" presId="urn:microsoft.com/office/officeart/2005/8/layout/hierarchy1"/>
    <dgm:cxn modelId="{7A44E939-3F15-4AB0-A02B-BB6F55C5829A}" type="presOf" srcId="{B54D7212-5EEE-4758-869D-32648AD83B51}" destId="{B7878799-F1DC-4554-AE5D-47CB77E50709}" srcOrd="0" destOrd="0" presId="urn:microsoft.com/office/officeart/2005/8/layout/hierarchy1"/>
    <dgm:cxn modelId="{7095403A-67E6-473C-962B-443CF8A16834}" type="presOf" srcId="{04E8429C-29B3-4049-BC32-F949230560FB}" destId="{3997403E-F5E5-4EC0-9471-3AB3C5E31471}" srcOrd="0" destOrd="0" presId="urn:microsoft.com/office/officeart/2005/8/layout/hierarchy1"/>
    <dgm:cxn modelId="{CA4ED03A-5650-4883-8F71-33751A19A31D}" type="presOf" srcId="{A9FD1F6D-E75B-4D7B-9BC2-511C4B134A9E}" destId="{341F1C0F-3227-4AF7-A235-7B8715329ED2}" srcOrd="0" destOrd="0" presId="urn:microsoft.com/office/officeart/2005/8/layout/hierarchy1"/>
    <dgm:cxn modelId="{4D907D3B-A8DA-4E59-9F95-0E02C8819B20}" srcId="{FA61E367-4E00-4CD8-84B3-2DF6569EF614}" destId="{73C68425-05E7-4C12-A123-620DD74A9C33}" srcOrd="0" destOrd="0" parTransId="{2E309D28-DCE2-4D2C-BF93-A1C56DDCB019}" sibTransId="{78751693-52FE-4727-BBF2-3BD29DB06B60}"/>
    <dgm:cxn modelId="{C33FB23D-666C-402D-9342-86793A525ABB}" type="presOf" srcId="{C8F9C77B-5AD7-4D1C-8C82-D5C4C1D80329}" destId="{80A5ACE4-8145-45EF-85F3-0E85BB0F84D2}" srcOrd="0" destOrd="0" presId="urn:microsoft.com/office/officeart/2005/8/layout/hierarchy1"/>
    <dgm:cxn modelId="{E5D4D65D-4003-40AA-847E-0B3D54007D3E}" srcId="{523F5703-6868-495A-B483-331C5A6E593F}" destId="{044BDE05-49B1-4A4C-A3FC-6C14ABCC2A11}" srcOrd="2" destOrd="0" parTransId="{04E8429C-29B3-4049-BC32-F949230560FB}" sibTransId="{17758B9E-4893-4BE8-A722-E595A37B2B0B}"/>
    <dgm:cxn modelId="{6355F75D-4E99-4AF7-8833-3DC24C0D654C}" type="presOf" srcId="{73C68425-05E7-4C12-A123-620DD74A9C33}" destId="{67766ADD-A194-4432-A7A9-11F069D5B965}" srcOrd="0" destOrd="0" presId="urn:microsoft.com/office/officeart/2005/8/layout/hierarchy1"/>
    <dgm:cxn modelId="{DA9B3F61-F175-4E16-BCCD-FEA29C362A67}" type="presOf" srcId="{523F5703-6868-495A-B483-331C5A6E593F}" destId="{5760BCE9-AB1D-4728-AD00-CDF562149757}" srcOrd="0" destOrd="0" presId="urn:microsoft.com/office/officeart/2005/8/layout/hierarchy1"/>
    <dgm:cxn modelId="{B0A10C42-04A4-43C4-8C16-FD47B7D00E5B}" type="presOf" srcId="{A18CB1CA-2048-4069-9EFC-B61730CBA65F}" destId="{43DEEE5D-E6F2-4179-8188-995C3E6E815D}" srcOrd="0" destOrd="0" presId="urn:microsoft.com/office/officeart/2005/8/layout/hierarchy1"/>
    <dgm:cxn modelId="{9B0A6342-82D3-4B79-A844-67A906520874}" srcId="{FAD2DF9A-2771-41EE-82AC-8AE16847D661}" destId="{68889E9D-D329-481B-AF93-84C32D4E0FD7}" srcOrd="1" destOrd="0" parTransId="{607952B3-589F-44E8-A4AA-76311DB32698}" sibTransId="{7DC0CD68-DBDE-4F9E-B09C-2DB30B54A44E}"/>
    <dgm:cxn modelId="{68467C44-DA4F-4A79-9B2C-E32B2E7825C0}" type="presOf" srcId="{D6A2184B-5326-4B87-8605-1EAF8AEB37B7}" destId="{EF741AF2-A701-4F4F-B5D0-3F6DE0D42BDC}" srcOrd="0" destOrd="0" presId="urn:microsoft.com/office/officeart/2005/8/layout/hierarchy1"/>
    <dgm:cxn modelId="{7F877369-8A37-4339-88C6-0E4ABD8C68CB}" srcId="{68889E9D-D329-481B-AF93-84C32D4E0FD7}" destId="{523F5703-6868-495A-B483-331C5A6E593F}" srcOrd="1" destOrd="0" parTransId="{D76D7421-9F51-43CE-8093-FF028D0B718E}" sibTransId="{D19716A1-0958-46FB-82D3-BF6BB6E0F5CC}"/>
    <dgm:cxn modelId="{0B25096D-4B90-4A58-9C16-078C4509CF1B}" srcId="{FAD2DF9A-2771-41EE-82AC-8AE16847D661}" destId="{FA61E367-4E00-4CD8-84B3-2DF6569EF614}" srcOrd="0" destOrd="0" parTransId="{2B0C3836-7B96-4E0F-BCE2-2FB91FB731C5}" sibTransId="{B2833BA6-35FE-4A4D-8A46-7AF93346F70B}"/>
    <dgm:cxn modelId="{5BF0654D-5836-4792-B988-5B21D23CF129}" type="presOf" srcId="{28E56FA4-F9B2-44C5-B73E-D168E408D80F}" destId="{DA67402F-85C9-46EB-A8A4-A5D4E89817E4}" srcOrd="0" destOrd="0" presId="urn:microsoft.com/office/officeart/2005/8/layout/hierarchy1"/>
    <dgm:cxn modelId="{D367E06D-2922-40A2-9031-A4524F4B0170}" srcId="{FA61E367-4E00-4CD8-84B3-2DF6569EF614}" destId="{D8A15F87-AEDD-4DB1-BE18-EC822D0CA7E4}" srcOrd="1" destOrd="0" parTransId="{17D8A148-E4FA-4D45-BC42-0AECBDE79B44}" sibTransId="{6DEF916C-9F12-4741-9F32-BA4819538FFF}"/>
    <dgm:cxn modelId="{0608FF6E-C07C-45EC-AF74-635D1579F5E4}" srcId="{73C68425-05E7-4C12-A123-620DD74A9C33}" destId="{A18CB1CA-2048-4069-9EFC-B61730CBA65F}" srcOrd="0" destOrd="0" parTransId="{1FEDF1E2-3CD3-48D5-8185-AC04ABBD0A3D}" sibTransId="{29F36917-5EA2-4392-9299-1FC395A8125B}"/>
    <dgm:cxn modelId="{85BF944F-F982-4006-9960-A1619E8DF862}" type="presOf" srcId="{CB511C73-67FC-46EA-B918-D3128D8BEA61}" destId="{2A90E2CB-1107-439F-9345-F7C1191605A9}" srcOrd="0" destOrd="0" presId="urn:microsoft.com/office/officeart/2005/8/layout/hierarchy1"/>
    <dgm:cxn modelId="{4A602B56-8F4A-41E5-84A7-964EBD4DF85A}" srcId="{1E69CBCD-724B-4868-A5D2-38D71C261D7E}" destId="{A9FD1F6D-E75B-4D7B-9BC2-511C4B134A9E}" srcOrd="0" destOrd="0" parTransId="{FE4FF110-3041-4645-9009-FEEC7990A23B}" sibTransId="{64226182-62A7-4532-B36D-F04F860E553B}"/>
    <dgm:cxn modelId="{7B952B5A-96DE-495D-8B7A-C3FE8C4578E9}" srcId="{68889E9D-D329-481B-AF93-84C32D4E0FD7}" destId="{1E69CBCD-724B-4868-A5D2-38D71C261D7E}" srcOrd="0" destOrd="0" parTransId="{28E56FA4-F9B2-44C5-B73E-D168E408D80F}" sibTransId="{50B81399-5996-4839-B105-28269C4D55C4}"/>
    <dgm:cxn modelId="{57646380-AE38-43A4-B47C-795DB61E30C8}" type="presOf" srcId="{FA61E367-4E00-4CD8-84B3-2DF6569EF614}" destId="{DF26862E-F334-49E1-B006-1D136B108AE6}" srcOrd="0" destOrd="0" presId="urn:microsoft.com/office/officeart/2005/8/layout/hierarchy1"/>
    <dgm:cxn modelId="{92AF2E82-49DA-4200-A402-6C3B3CE9418F}" srcId="{E109C842-DF4D-4874-934A-75C1FC7351FB}" destId="{FAD2DF9A-2771-41EE-82AC-8AE16847D661}" srcOrd="1" destOrd="0" parTransId="{E9F0B53C-A72F-426B-BAC2-1716AD3451E8}" sibTransId="{440810F0-FAD5-4C8C-A413-C5CE333458BE}"/>
    <dgm:cxn modelId="{7C428793-B08D-4B22-AED7-32430F062EBD}" srcId="{523F5703-6868-495A-B483-331C5A6E593F}" destId="{CDF2A722-BC08-434C-9302-EEAFE8DD3294}" srcOrd="1" destOrd="0" parTransId="{E2A73C8A-850C-42EE-902B-B553568776FD}" sibTransId="{06CDE5DB-20BB-4273-A451-F58CE1ECBFC3}"/>
    <dgm:cxn modelId="{8E823F96-BA54-4BBF-85FE-B573CBD26D4F}" type="presOf" srcId="{949F779A-C81B-4090-AB09-24AAD6F05920}" destId="{C3027C78-6028-4933-B85E-4EEC9B64E5CD}" srcOrd="0" destOrd="0" presId="urn:microsoft.com/office/officeart/2005/8/layout/hierarchy1"/>
    <dgm:cxn modelId="{E9F7719C-3559-4FCB-AE67-E1D1120A72B3}" type="presOf" srcId="{607952B3-589F-44E8-A4AA-76311DB32698}" destId="{4436436E-6CDE-4D95-BFED-4C2725194863}" srcOrd="0" destOrd="0" presId="urn:microsoft.com/office/officeart/2005/8/layout/hierarchy1"/>
    <dgm:cxn modelId="{18C49EA0-8AF5-4D43-888D-9C2B8C28F20D}" type="presOf" srcId="{FE4FF110-3041-4645-9009-FEEC7990A23B}" destId="{DC155B66-3E06-4B93-87AD-64FF92E4BCEB}" srcOrd="0" destOrd="0" presId="urn:microsoft.com/office/officeart/2005/8/layout/hierarchy1"/>
    <dgm:cxn modelId="{46BDE0B3-B854-499A-808C-7E0D9C787E2C}" type="presOf" srcId="{D8A15F87-AEDD-4DB1-BE18-EC822D0CA7E4}" destId="{3D0E944D-D50E-4AF0-9738-A657EB5AC76A}" srcOrd="0" destOrd="0" presId="urn:microsoft.com/office/officeart/2005/8/layout/hierarchy1"/>
    <dgm:cxn modelId="{E963FFCB-45EA-4C6A-865C-16D6BDDCA995}" srcId="{D8A15F87-AEDD-4DB1-BE18-EC822D0CA7E4}" destId="{7C90C042-AE96-4730-9F2F-C0ADB2E8E303}" srcOrd="0" destOrd="0" parTransId="{CB511C73-67FC-46EA-B918-D3128D8BEA61}" sibTransId="{BF31E661-3309-4BBF-89B2-A5571824E9AC}"/>
    <dgm:cxn modelId="{B726A5DA-20CD-4976-9A4E-5EB3133307BF}" srcId="{C8F9C77B-5AD7-4D1C-8C82-D5C4C1D80329}" destId="{E109C842-DF4D-4874-934A-75C1FC7351FB}" srcOrd="0" destOrd="0" parTransId="{AE1763E7-869C-494E-8418-3BBF85CADE70}" sibTransId="{251AF88A-AD0D-40B1-A7E0-0C92826D4A2F}"/>
    <dgm:cxn modelId="{42E318E3-C7ED-4806-A133-5D3BAB78FBB6}" type="presOf" srcId="{8F1AEF42-44CD-4814-9FB1-4C2121B96481}" destId="{0DB36F63-04D3-42CC-A08E-1E1D6E4E2822}" srcOrd="0" destOrd="0" presId="urn:microsoft.com/office/officeart/2005/8/layout/hierarchy1"/>
    <dgm:cxn modelId="{BE3340E5-6D09-475C-AAD7-55E9975ADA46}" srcId="{73C68425-05E7-4C12-A123-620DD74A9C33}" destId="{BE303283-046E-49F3-9BAB-66A12C8E0A53}" srcOrd="1" destOrd="0" parTransId="{8F1AEF42-44CD-4814-9FB1-4C2121B96481}" sibTransId="{1A98CED0-3861-4ECD-95D9-41BDFCDBA0FD}"/>
    <dgm:cxn modelId="{118243E5-D445-488E-891C-2F645D8266BF}" type="presOf" srcId="{997CA720-C083-4FA0-AC78-7626E7A31DA2}" destId="{D5C62699-8A41-414D-AE54-E06E01E9B5F6}" srcOrd="0" destOrd="0" presId="urn:microsoft.com/office/officeart/2005/8/layout/hierarchy1"/>
    <dgm:cxn modelId="{63CEBCE7-6161-42C7-A52C-577704801932}" type="presOf" srcId="{E9F0B53C-A72F-426B-BAC2-1716AD3451E8}" destId="{CC3D6616-166B-4F1A-835D-C4983B921AF3}" srcOrd="0" destOrd="0" presId="urn:microsoft.com/office/officeart/2005/8/layout/hierarchy1"/>
    <dgm:cxn modelId="{530604F0-C824-4778-A0D0-82B1660EB72D}" type="presOf" srcId="{E109C842-DF4D-4874-934A-75C1FC7351FB}" destId="{CC76E990-510F-44BA-A3D8-7CC09CF70B5D}" srcOrd="0" destOrd="0" presId="urn:microsoft.com/office/officeart/2005/8/layout/hierarchy1"/>
    <dgm:cxn modelId="{683E9CFA-1661-4245-81E3-5DC2C94A1967}" type="presOf" srcId="{2E309D28-DCE2-4D2C-BF93-A1C56DDCB019}" destId="{38E8D6DB-B3B2-44B5-BD68-245B285F1D4D}" srcOrd="0" destOrd="0" presId="urn:microsoft.com/office/officeart/2005/8/layout/hierarchy1"/>
    <dgm:cxn modelId="{28676FFB-5850-4318-BE5F-1660095DB26D}" type="presOf" srcId="{BE303283-046E-49F3-9BAB-66A12C8E0A53}" destId="{678CB666-E6F0-486B-B4F0-76147EB28DE4}" srcOrd="0" destOrd="0" presId="urn:microsoft.com/office/officeart/2005/8/layout/hierarchy1"/>
    <dgm:cxn modelId="{3754CFB0-F10B-435A-98FF-7A3C676DB3FE}" type="presParOf" srcId="{80A5ACE4-8145-45EF-85F3-0E85BB0F84D2}" destId="{F24A1E0D-0FE4-4509-9750-81900F386085}" srcOrd="0" destOrd="0" presId="urn:microsoft.com/office/officeart/2005/8/layout/hierarchy1"/>
    <dgm:cxn modelId="{8C4BE3A8-2AAE-4A3B-BD9F-10B1E9BF143D}" type="presParOf" srcId="{F24A1E0D-0FE4-4509-9750-81900F386085}" destId="{345CE9CB-C8E8-4AB8-95C7-A5E6E0BAF347}" srcOrd="0" destOrd="0" presId="urn:microsoft.com/office/officeart/2005/8/layout/hierarchy1"/>
    <dgm:cxn modelId="{A0875EA6-D307-4320-8666-AD379E09A19A}" type="presParOf" srcId="{345CE9CB-C8E8-4AB8-95C7-A5E6E0BAF347}" destId="{04AAFA18-63F0-4988-85D0-2D7F5F495905}" srcOrd="0" destOrd="0" presId="urn:microsoft.com/office/officeart/2005/8/layout/hierarchy1"/>
    <dgm:cxn modelId="{A4967876-F6BA-4144-B8D0-899E4AAF47CC}" type="presParOf" srcId="{345CE9CB-C8E8-4AB8-95C7-A5E6E0BAF347}" destId="{CC76E990-510F-44BA-A3D8-7CC09CF70B5D}" srcOrd="1" destOrd="0" presId="urn:microsoft.com/office/officeart/2005/8/layout/hierarchy1"/>
    <dgm:cxn modelId="{A254288A-E89B-460C-93EE-A2369C1C5D69}" type="presParOf" srcId="{F24A1E0D-0FE4-4509-9750-81900F386085}" destId="{5AB75C73-C8FA-4E7A-B4F6-1518491E659D}" srcOrd="1" destOrd="0" presId="urn:microsoft.com/office/officeart/2005/8/layout/hierarchy1"/>
    <dgm:cxn modelId="{0F2F13F7-EEBF-46C2-880C-81F9BAC49B70}" type="presParOf" srcId="{5AB75C73-C8FA-4E7A-B4F6-1518491E659D}" destId="{D5C62699-8A41-414D-AE54-E06E01E9B5F6}" srcOrd="0" destOrd="0" presId="urn:microsoft.com/office/officeart/2005/8/layout/hierarchy1"/>
    <dgm:cxn modelId="{B1199C6E-46D7-4621-8BD1-A64278888596}" type="presParOf" srcId="{5AB75C73-C8FA-4E7A-B4F6-1518491E659D}" destId="{8E09DC5B-419C-40F4-A9D3-DFCCE5B399DC}" srcOrd="1" destOrd="0" presId="urn:microsoft.com/office/officeart/2005/8/layout/hierarchy1"/>
    <dgm:cxn modelId="{76D52639-5262-4EC4-B02C-A02EFA319FF7}" type="presParOf" srcId="{8E09DC5B-419C-40F4-A9D3-DFCCE5B399DC}" destId="{8E43902E-C3A6-40DD-8EBF-8FD32C0C9955}" srcOrd="0" destOrd="0" presId="urn:microsoft.com/office/officeart/2005/8/layout/hierarchy1"/>
    <dgm:cxn modelId="{5CB022B1-6D5E-4CF2-ACA1-6B739F0A1F43}" type="presParOf" srcId="{8E43902E-C3A6-40DD-8EBF-8FD32C0C9955}" destId="{B02C5496-8B1A-4517-87D9-494694F82D3E}" srcOrd="0" destOrd="0" presId="urn:microsoft.com/office/officeart/2005/8/layout/hierarchy1"/>
    <dgm:cxn modelId="{D67F9C0F-4542-43B4-B1AB-D580B5314436}" type="presParOf" srcId="{8E43902E-C3A6-40DD-8EBF-8FD32C0C9955}" destId="{EF741AF2-A701-4F4F-B5D0-3F6DE0D42BDC}" srcOrd="1" destOrd="0" presId="urn:microsoft.com/office/officeart/2005/8/layout/hierarchy1"/>
    <dgm:cxn modelId="{38BA52A2-635B-4123-BBA5-5C1031EF0241}" type="presParOf" srcId="{8E09DC5B-419C-40F4-A9D3-DFCCE5B399DC}" destId="{D185645C-4C44-4274-A77E-C0F2CEABD8F1}" srcOrd="1" destOrd="0" presId="urn:microsoft.com/office/officeart/2005/8/layout/hierarchy1"/>
    <dgm:cxn modelId="{F38EA38F-BD56-4014-95D4-8D42FE082C8C}" type="presParOf" srcId="{5AB75C73-C8FA-4E7A-B4F6-1518491E659D}" destId="{CC3D6616-166B-4F1A-835D-C4983B921AF3}" srcOrd="2" destOrd="0" presId="urn:microsoft.com/office/officeart/2005/8/layout/hierarchy1"/>
    <dgm:cxn modelId="{97B41720-6826-4CA0-A546-D0A2798CF0F0}" type="presParOf" srcId="{5AB75C73-C8FA-4E7A-B4F6-1518491E659D}" destId="{6E7C81C3-D54D-47DC-A22F-714586AE2BE4}" srcOrd="3" destOrd="0" presId="urn:microsoft.com/office/officeart/2005/8/layout/hierarchy1"/>
    <dgm:cxn modelId="{F36455FC-9445-4B20-890C-72F93A783733}" type="presParOf" srcId="{6E7C81C3-D54D-47DC-A22F-714586AE2BE4}" destId="{E16674CA-7224-4BCF-94D8-96F5FF8F6EB7}" srcOrd="0" destOrd="0" presId="urn:microsoft.com/office/officeart/2005/8/layout/hierarchy1"/>
    <dgm:cxn modelId="{1FC47E77-0F84-4D43-B1B7-E72B308E6992}" type="presParOf" srcId="{E16674CA-7224-4BCF-94D8-96F5FF8F6EB7}" destId="{09D3524B-00EB-477F-A906-B97918D328E5}" srcOrd="0" destOrd="0" presId="urn:microsoft.com/office/officeart/2005/8/layout/hierarchy1"/>
    <dgm:cxn modelId="{D346CDAB-07F0-49D8-A193-844A0FFFFFE3}" type="presParOf" srcId="{E16674CA-7224-4BCF-94D8-96F5FF8F6EB7}" destId="{2540F739-880D-4C70-8B47-819C5AC53D6F}" srcOrd="1" destOrd="0" presId="urn:microsoft.com/office/officeart/2005/8/layout/hierarchy1"/>
    <dgm:cxn modelId="{DE01E28E-3031-44D5-9799-2C36D416FD89}" type="presParOf" srcId="{6E7C81C3-D54D-47DC-A22F-714586AE2BE4}" destId="{153F37CA-E17A-4B7E-9A3D-47D04264F541}" srcOrd="1" destOrd="0" presId="urn:microsoft.com/office/officeart/2005/8/layout/hierarchy1"/>
    <dgm:cxn modelId="{5A793F8B-18FB-44F3-9130-5B07ABF38287}" type="presParOf" srcId="{153F37CA-E17A-4B7E-9A3D-47D04264F541}" destId="{A6EFC856-ACCC-4510-84DB-192EF9E61DA8}" srcOrd="0" destOrd="0" presId="urn:microsoft.com/office/officeart/2005/8/layout/hierarchy1"/>
    <dgm:cxn modelId="{6A891C2C-98AB-4F45-8812-78D5166D6F2E}" type="presParOf" srcId="{153F37CA-E17A-4B7E-9A3D-47D04264F541}" destId="{5C4D0AAB-88A0-400D-A09D-AB1F29F8EB77}" srcOrd="1" destOrd="0" presId="urn:microsoft.com/office/officeart/2005/8/layout/hierarchy1"/>
    <dgm:cxn modelId="{A6B89927-D09C-4659-AC1B-CAA41A995FBA}" type="presParOf" srcId="{5C4D0AAB-88A0-400D-A09D-AB1F29F8EB77}" destId="{7EAC2781-482B-452C-9E72-CFB1647FFF22}" srcOrd="0" destOrd="0" presId="urn:microsoft.com/office/officeart/2005/8/layout/hierarchy1"/>
    <dgm:cxn modelId="{E201695B-0CD9-41F9-8CB2-B88C7A915CC4}" type="presParOf" srcId="{7EAC2781-482B-452C-9E72-CFB1647FFF22}" destId="{AA05AB12-323C-4EC7-9AAE-F6C167ED2F24}" srcOrd="0" destOrd="0" presId="urn:microsoft.com/office/officeart/2005/8/layout/hierarchy1"/>
    <dgm:cxn modelId="{7B0E16E6-4546-4FBD-A69A-012B5FA8DCF7}" type="presParOf" srcId="{7EAC2781-482B-452C-9E72-CFB1647FFF22}" destId="{DF26862E-F334-49E1-B006-1D136B108AE6}" srcOrd="1" destOrd="0" presId="urn:microsoft.com/office/officeart/2005/8/layout/hierarchy1"/>
    <dgm:cxn modelId="{681135D0-8677-4BE6-B266-C8E05DB64803}" type="presParOf" srcId="{5C4D0AAB-88A0-400D-A09D-AB1F29F8EB77}" destId="{B18520FF-86FF-421C-B466-6536844BBCAC}" srcOrd="1" destOrd="0" presId="urn:microsoft.com/office/officeart/2005/8/layout/hierarchy1"/>
    <dgm:cxn modelId="{A7B6EBEC-F678-4BB1-A57B-5C1F58112AC8}" type="presParOf" srcId="{B18520FF-86FF-421C-B466-6536844BBCAC}" destId="{38E8D6DB-B3B2-44B5-BD68-245B285F1D4D}" srcOrd="0" destOrd="0" presId="urn:microsoft.com/office/officeart/2005/8/layout/hierarchy1"/>
    <dgm:cxn modelId="{98FE1D70-3E00-45A9-A41C-A142C2DD3857}" type="presParOf" srcId="{B18520FF-86FF-421C-B466-6536844BBCAC}" destId="{02CE8FA6-10ED-4E7E-A533-6566CFB9A90C}" srcOrd="1" destOrd="0" presId="urn:microsoft.com/office/officeart/2005/8/layout/hierarchy1"/>
    <dgm:cxn modelId="{17C50D8C-AD07-4A66-B45F-2BB4306CE4C1}" type="presParOf" srcId="{02CE8FA6-10ED-4E7E-A533-6566CFB9A90C}" destId="{DDFE3686-0292-4B23-92DE-30EA3D7DB1F9}" srcOrd="0" destOrd="0" presId="urn:microsoft.com/office/officeart/2005/8/layout/hierarchy1"/>
    <dgm:cxn modelId="{5C43D2C1-35F5-4FF3-AD57-DF2CF693C4E9}" type="presParOf" srcId="{DDFE3686-0292-4B23-92DE-30EA3D7DB1F9}" destId="{78B236F7-9A9F-47E1-9F07-31C60A9EB8C2}" srcOrd="0" destOrd="0" presId="urn:microsoft.com/office/officeart/2005/8/layout/hierarchy1"/>
    <dgm:cxn modelId="{A156BF53-EE66-42AC-923E-B1F18670E84A}" type="presParOf" srcId="{DDFE3686-0292-4B23-92DE-30EA3D7DB1F9}" destId="{67766ADD-A194-4432-A7A9-11F069D5B965}" srcOrd="1" destOrd="0" presId="urn:microsoft.com/office/officeart/2005/8/layout/hierarchy1"/>
    <dgm:cxn modelId="{F575E8B5-656F-4EFF-9F5A-D6FA951D32B0}" type="presParOf" srcId="{02CE8FA6-10ED-4E7E-A533-6566CFB9A90C}" destId="{B00BE78D-595A-43D6-B57D-FFBBAE2A78BA}" srcOrd="1" destOrd="0" presId="urn:microsoft.com/office/officeart/2005/8/layout/hierarchy1"/>
    <dgm:cxn modelId="{49C41B94-56BB-410E-8B89-84F5B2372EF4}" type="presParOf" srcId="{B00BE78D-595A-43D6-B57D-FFBBAE2A78BA}" destId="{CFB98C59-4220-44BB-B9B0-52F22164B30F}" srcOrd="0" destOrd="0" presId="urn:microsoft.com/office/officeart/2005/8/layout/hierarchy1"/>
    <dgm:cxn modelId="{5F41E863-A06D-4A08-9988-290A8F0812B4}" type="presParOf" srcId="{B00BE78D-595A-43D6-B57D-FFBBAE2A78BA}" destId="{43ECD03C-03AC-49DA-9A4B-868DD8E2CA99}" srcOrd="1" destOrd="0" presId="urn:microsoft.com/office/officeart/2005/8/layout/hierarchy1"/>
    <dgm:cxn modelId="{9E8C2788-1F7B-47AC-B5D6-B2502C02CF89}" type="presParOf" srcId="{43ECD03C-03AC-49DA-9A4B-868DD8E2CA99}" destId="{E68ACD10-D7AB-4E4E-AB27-68F7D8F22882}" srcOrd="0" destOrd="0" presId="urn:microsoft.com/office/officeart/2005/8/layout/hierarchy1"/>
    <dgm:cxn modelId="{A5ED3C92-F263-4E84-96CD-F09FB6F6D909}" type="presParOf" srcId="{E68ACD10-D7AB-4E4E-AB27-68F7D8F22882}" destId="{9A1CC577-1548-482B-B7A4-47D02F050469}" srcOrd="0" destOrd="0" presId="urn:microsoft.com/office/officeart/2005/8/layout/hierarchy1"/>
    <dgm:cxn modelId="{B5543CD9-E721-46A1-9BD3-2D830F2E4E71}" type="presParOf" srcId="{E68ACD10-D7AB-4E4E-AB27-68F7D8F22882}" destId="{43DEEE5D-E6F2-4179-8188-995C3E6E815D}" srcOrd="1" destOrd="0" presId="urn:microsoft.com/office/officeart/2005/8/layout/hierarchy1"/>
    <dgm:cxn modelId="{46D2151C-669D-4396-82F5-E1E2B4B3EF0B}" type="presParOf" srcId="{43ECD03C-03AC-49DA-9A4B-868DD8E2CA99}" destId="{F35BB6EC-BDB9-49C2-AC4F-5073CD6A1E28}" srcOrd="1" destOrd="0" presId="urn:microsoft.com/office/officeart/2005/8/layout/hierarchy1"/>
    <dgm:cxn modelId="{1CE085F5-85D2-44DD-8FD1-EDE5D3241378}" type="presParOf" srcId="{B00BE78D-595A-43D6-B57D-FFBBAE2A78BA}" destId="{0DB36F63-04D3-42CC-A08E-1E1D6E4E2822}" srcOrd="2" destOrd="0" presId="urn:microsoft.com/office/officeart/2005/8/layout/hierarchy1"/>
    <dgm:cxn modelId="{F8292128-9D47-478F-B836-0460F3F91056}" type="presParOf" srcId="{B00BE78D-595A-43D6-B57D-FFBBAE2A78BA}" destId="{6D39F739-1EF6-437D-92BA-F7C9466B7E6D}" srcOrd="3" destOrd="0" presId="urn:microsoft.com/office/officeart/2005/8/layout/hierarchy1"/>
    <dgm:cxn modelId="{CFD803EA-0675-4DF8-95BC-C639FD18967C}" type="presParOf" srcId="{6D39F739-1EF6-437D-92BA-F7C9466B7E6D}" destId="{BE73F52C-9B96-4850-B6B4-6C16BA4075E9}" srcOrd="0" destOrd="0" presId="urn:microsoft.com/office/officeart/2005/8/layout/hierarchy1"/>
    <dgm:cxn modelId="{E2EC779B-12AE-494A-A935-D338E48706EB}" type="presParOf" srcId="{BE73F52C-9B96-4850-B6B4-6C16BA4075E9}" destId="{4AAE161A-3AAC-4A2C-82FF-B9E743E0E7CF}" srcOrd="0" destOrd="0" presId="urn:microsoft.com/office/officeart/2005/8/layout/hierarchy1"/>
    <dgm:cxn modelId="{3191B374-0B52-4DB8-9CE7-5B2D96B858AC}" type="presParOf" srcId="{BE73F52C-9B96-4850-B6B4-6C16BA4075E9}" destId="{678CB666-E6F0-486B-B4F0-76147EB28DE4}" srcOrd="1" destOrd="0" presId="urn:microsoft.com/office/officeart/2005/8/layout/hierarchy1"/>
    <dgm:cxn modelId="{BA36D1A2-4944-4428-BA36-C2DABCF43F10}" type="presParOf" srcId="{6D39F739-1EF6-437D-92BA-F7C9466B7E6D}" destId="{DFF06C54-7090-454E-B4D2-66A590D30FB4}" srcOrd="1" destOrd="0" presId="urn:microsoft.com/office/officeart/2005/8/layout/hierarchy1"/>
    <dgm:cxn modelId="{8688F090-F38A-4297-98CE-4F8DE4B2C239}" type="presParOf" srcId="{B18520FF-86FF-421C-B466-6536844BBCAC}" destId="{4E13EBBF-CFCF-4B42-AC2D-763F318D5A08}" srcOrd="2" destOrd="0" presId="urn:microsoft.com/office/officeart/2005/8/layout/hierarchy1"/>
    <dgm:cxn modelId="{BFE68151-84CA-47BD-BF47-3C320143F157}" type="presParOf" srcId="{B18520FF-86FF-421C-B466-6536844BBCAC}" destId="{3F8C11B2-EF24-4904-AB65-A51AA3F99FFE}" srcOrd="3" destOrd="0" presId="urn:microsoft.com/office/officeart/2005/8/layout/hierarchy1"/>
    <dgm:cxn modelId="{5FE9A858-46F9-4861-A085-A6B4B2FA48F2}" type="presParOf" srcId="{3F8C11B2-EF24-4904-AB65-A51AA3F99FFE}" destId="{E4DF6107-08E1-4B67-8F6C-8F1516453454}" srcOrd="0" destOrd="0" presId="urn:microsoft.com/office/officeart/2005/8/layout/hierarchy1"/>
    <dgm:cxn modelId="{42739442-A9CE-4DE3-BC85-4789CCDDF70C}" type="presParOf" srcId="{E4DF6107-08E1-4B67-8F6C-8F1516453454}" destId="{6FA0F4EB-7B95-4C80-A348-F48AE57E9EAF}" srcOrd="0" destOrd="0" presId="urn:microsoft.com/office/officeart/2005/8/layout/hierarchy1"/>
    <dgm:cxn modelId="{3BBA24A4-2941-4192-A6DA-0083674F7B19}" type="presParOf" srcId="{E4DF6107-08E1-4B67-8F6C-8F1516453454}" destId="{3D0E944D-D50E-4AF0-9738-A657EB5AC76A}" srcOrd="1" destOrd="0" presId="urn:microsoft.com/office/officeart/2005/8/layout/hierarchy1"/>
    <dgm:cxn modelId="{8B06A0E2-4574-42A1-8AB4-1B955EF40AE8}" type="presParOf" srcId="{3F8C11B2-EF24-4904-AB65-A51AA3F99FFE}" destId="{2B3372D1-DFCA-47E9-898F-DC4AC1E37AD2}" srcOrd="1" destOrd="0" presId="urn:microsoft.com/office/officeart/2005/8/layout/hierarchy1"/>
    <dgm:cxn modelId="{BD5B48EF-363D-4E09-A77D-A52EC89808DF}" type="presParOf" srcId="{2B3372D1-DFCA-47E9-898F-DC4AC1E37AD2}" destId="{2A90E2CB-1107-439F-9345-F7C1191605A9}" srcOrd="0" destOrd="0" presId="urn:microsoft.com/office/officeart/2005/8/layout/hierarchy1"/>
    <dgm:cxn modelId="{BC1323DE-58F3-4503-9D18-D96F9F458017}" type="presParOf" srcId="{2B3372D1-DFCA-47E9-898F-DC4AC1E37AD2}" destId="{F647E5E9-C27F-4F01-B021-D1867B96D88C}" srcOrd="1" destOrd="0" presId="urn:microsoft.com/office/officeart/2005/8/layout/hierarchy1"/>
    <dgm:cxn modelId="{DD3CA4DC-9477-4E1D-BD84-8A5610873799}" type="presParOf" srcId="{F647E5E9-C27F-4F01-B021-D1867B96D88C}" destId="{ED0C6B9A-7A22-4CA7-AD4B-C74943C30BA8}" srcOrd="0" destOrd="0" presId="urn:microsoft.com/office/officeart/2005/8/layout/hierarchy1"/>
    <dgm:cxn modelId="{BE4084F6-2A3B-4E14-992D-3BCB222DA095}" type="presParOf" srcId="{ED0C6B9A-7A22-4CA7-AD4B-C74943C30BA8}" destId="{4BAD7874-3DAF-47F0-8419-9A9391976DDF}" srcOrd="0" destOrd="0" presId="urn:microsoft.com/office/officeart/2005/8/layout/hierarchy1"/>
    <dgm:cxn modelId="{76A576A6-DBF2-4695-B338-DE8D1D8A7642}" type="presParOf" srcId="{ED0C6B9A-7A22-4CA7-AD4B-C74943C30BA8}" destId="{D05B2C5A-8E19-4289-B5DB-23851939C00A}" srcOrd="1" destOrd="0" presId="urn:microsoft.com/office/officeart/2005/8/layout/hierarchy1"/>
    <dgm:cxn modelId="{565B0666-A4D7-41B3-9D8B-381B98267F32}" type="presParOf" srcId="{F647E5E9-C27F-4F01-B021-D1867B96D88C}" destId="{5706280A-B609-4B6B-8ED6-CB3D0F4FEF3D}" srcOrd="1" destOrd="0" presId="urn:microsoft.com/office/officeart/2005/8/layout/hierarchy1"/>
    <dgm:cxn modelId="{45936C55-E3E1-47C6-9909-B9F1FB752659}" type="presParOf" srcId="{2B3372D1-DFCA-47E9-898F-DC4AC1E37AD2}" destId="{6FD6D4F6-6A40-470E-9FCC-70A6BAF98C9E}" srcOrd="2" destOrd="0" presId="urn:microsoft.com/office/officeart/2005/8/layout/hierarchy1"/>
    <dgm:cxn modelId="{C07AFF95-7552-4499-84BD-B30A41B8F7B4}" type="presParOf" srcId="{2B3372D1-DFCA-47E9-898F-DC4AC1E37AD2}" destId="{859449C4-EB9D-4E25-B988-99E6EBC02FD3}" srcOrd="3" destOrd="0" presId="urn:microsoft.com/office/officeart/2005/8/layout/hierarchy1"/>
    <dgm:cxn modelId="{4231A222-17AB-4898-8376-A99DE1C8CC67}" type="presParOf" srcId="{859449C4-EB9D-4E25-B988-99E6EBC02FD3}" destId="{2CEE9840-B782-46BA-9B21-B1C78A0142C2}" srcOrd="0" destOrd="0" presId="urn:microsoft.com/office/officeart/2005/8/layout/hierarchy1"/>
    <dgm:cxn modelId="{6FEEF711-BE79-41E5-A5C3-6FF6A7A6DE71}" type="presParOf" srcId="{2CEE9840-B782-46BA-9B21-B1C78A0142C2}" destId="{08764D7D-4C59-48F9-8F17-2540D8396F34}" srcOrd="0" destOrd="0" presId="urn:microsoft.com/office/officeart/2005/8/layout/hierarchy1"/>
    <dgm:cxn modelId="{ED72C0E5-8D94-45E2-9BCE-AC11FD0859A4}" type="presParOf" srcId="{2CEE9840-B782-46BA-9B21-B1C78A0142C2}" destId="{C3027C78-6028-4933-B85E-4EEC9B64E5CD}" srcOrd="1" destOrd="0" presId="urn:microsoft.com/office/officeart/2005/8/layout/hierarchy1"/>
    <dgm:cxn modelId="{4DA98D29-7CB2-4C6C-BFFB-0C425DC98DCA}" type="presParOf" srcId="{859449C4-EB9D-4E25-B988-99E6EBC02FD3}" destId="{E3F681BA-6BA1-447A-80D3-7D78C1F71B70}" srcOrd="1" destOrd="0" presId="urn:microsoft.com/office/officeart/2005/8/layout/hierarchy1"/>
    <dgm:cxn modelId="{69BD7F16-5561-4CBB-8040-DE952D3BD7C9}" type="presParOf" srcId="{153F37CA-E17A-4B7E-9A3D-47D04264F541}" destId="{4436436E-6CDE-4D95-BFED-4C2725194863}" srcOrd="2" destOrd="0" presId="urn:microsoft.com/office/officeart/2005/8/layout/hierarchy1"/>
    <dgm:cxn modelId="{F3247F28-64CA-4431-B1BD-4B9D0A3E7DA3}" type="presParOf" srcId="{153F37CA-E17A-4B7E-9A3D-47D04264F541}" destId="{C1ED6E50-ED94-4B65-863B-38B8DE33F68D}" srcOrd="3" destOrd="0" presId="urn:microsoft.com/office/officeart/2005/8/layout/hierarchy1"/>
    <dgm:cxn modelId="{14B358E9-9926-4A6B-84D5-16DD0CF8AC87}" type="presParOf" srcId="{C1ED6E50-ED94-4B65-863B-38B8DE33F68D}" destId="{A6F5D357-9B0F-42C1-9892-213DE8DF1233}" srcOrd="0" destOrd="0" presId="urn:microsoft.com/office/officeart/2005/8/layout/hierarchy1"/>
    <dgm:cxn modelId="{9F86EBB7-68D4-4DD5-8D46-E8EAE45E8D33}" type="presParOf" srcId="{A6F5D357-9B0F-42C1-9892-213DE8DF1233}" destId="{40000CE0-B1C7-48C9-AF87-E5AC362B1169}" srcOrd="0" destOrd="0" presId="urn:microsoft.com/office/officeart/2005/8/layout/hierarchy1"/>
    <dgm:cxn modelId="{495991D3-A7E8-4802-89F9-01AEFC44A67C}" type="presParOf" srcId="{A6F5D357-9B0F-42C1-9892-213DE8DF1233}" destId="{A43C7995-EE0A-4B55-8C55-E73B9AF18DD6}" srcOrd="1" destOrd="0" presId="urn:microsoft.com/office/officeart/2005/8/layout/hierarchy1"/>
    <dgm:cxn modelId="{B6C74A2A-89CD-47FE-8775-EDF98D7F73D5}" type="presParOf" srcId="{C1ED6E50-ED94-4B65-863B-38B8DE33F68D}" destId="{51A905D0-97BB-4E42-B745-AD88BFBAE9BF}" srcOrd="1" destOrd="0" presId="urn:microsoft.com/office/officeart/2005/8/layout/hierarchy1"/>
    <dgm:cxn modelId="{D34F1338-6996-4DCC-8EE1-E1D7FEE663A8}" type="presParOf" srcId="{51A905D0-97BB-4E42-B745-AD88BFBAE9BF}" destId="{DA67402F-85C9-46EB-A8A4-A5D4E89817E4}" srcOrd="0" destOrd="0" presId="urn:microsoft.com/office/officeart/2005/8/layout/hierarchy1"/>
    <dgm:cxn modelId="{56779F24-84A3-4D01-8774-B0F613A4505B}" type="presParOf" srcId="{51A905D0-97BB-4E42-B745-AD88BFBAE9BF}" destId="{4E9A45B0-E529-498B-B9AD-33E8FEC9DB63}" srcOrd="1" destOrd="0" presId="urn:microsoft.com/office/officeart/2005/8/layout/hierarchy1"/>
    <dgm:cxn modelId="{2FF54909-B247-450A-93BF-3C5C82360E5C}" type="presParOf" srcId="{4E9A45B0-E529-498B-B9AD-33E8FEC9DB63}" destId="{4879F727-BEDA-48D5-82BF-FB6D4F544D95}" srcOrd="0" destOrd="0" presId="urn:microsoft.com/office/officeart/2005/8/layout/hierarchy1"/>
    <dgm:cxn modelId="{1950ADC9-0ECB-4BF5-B873-6A8B6D42D231}" type="presParOf" srcId="{4879F727-BEDA-48D5-82BF-FB6D4F544D95}" destId="{E6AFA5F8-F0FA-4179-8235-23184592B669}" srcOrd="0" destOrd="0" presId="urn:microsoft.com/office/officeart/2005/8/layout/hierarchy1"/>
    <dgm:cxn modelId="{85B6C0F0-5F26-483B-9E77-9C4444753033}" type="presParOf" srcId="{4879F727-BEDA-48D5-82BF-FB6D4F544D95}" destId="{CF237029-440B-4624-81A5-A5BA041163D8}" srcOrd="1" destOrd="0" presId="urn:microsoft.com/office/officeart/2005/8/layout/hierarchy1"/>
    <dgm:cxn modelId="{1589FA00-6187-4289-900F-EED1C22884E2}" type="presParOf" srcId="{4E9A45B0-E529-498B-B9AD-33E8FEC9DB63}" destId="{2519DAD4-2238-4374-A880-ABED05C00428}" srcOrd="1" destOrd="0" presId="urn:microsoft.com/office/officeart/2005/8/layout/hierarchy1"/>
    <dgm:cxn modelId="{5FFDD872-31D2-49D7-947C-7624BA666364}" type="presParOf" srcId="{2519DAD4-2238-4374-A880-ABED05C00428}" destId="{DC155B66-3E06-4B93-87AD-64FF92E4BCEB}" srcOrd="0" destOrd="0" presId="urn:microsoft.com/office/officeart/2005/8/layout/hierarchy1"/>
    <dgm:cxn modelId="{CF6FD1B7-1523-40D1-B61A-FD9DC3F0F164}" type="presParOf" srcId="{2519DAD4-2238-4374-A880-ABED05C00428}" destId="{85D74C60-ABF6-4457-BD58-B37CBD64EF9C}" srcOrd="1" destOrd="0" presId="urn:microsoft.com/office/officeart/2005/8/layout/hierarchy1"/>
    <dgm:cxn modelId="{BFF9E136-2FDD-4200-9166-9ADC30D0F6BB}" type="presParOf" srcId="{85D74C60-ABF6-4457-BD58-B37CBD64EF9C}" destId="{0C5B35FE-9D1E-4658-885F-E5746A411003}" srcOrd="0" destOrd="0" presId="urn:microsoft.com/office/officeart/2005/8/layout/hierarchy1"/>
    <dgm:cxn modelId="{8D7F24F4-D7EB-4008-8D28-5169E6B6FAAD}" type="presParOf" srcId="{0C5B35FE-9D1E-4658-885F-E5746A411003}" destId="{0FFDABD6-31C4-4061-88B4-E8216447B88D}" srcOrd="0" destOrd="0" presId="urn:microsoft.com/office/officeart/2005/8/layout/hierarchy1"/>
    <dgm:cxn modelId="{C40623AB-0DD5-4609-A33F-F428826CBD42}" type="presParOf" srcId="{0C5B35FE-9D1E-4658-885F-E5746A411003}" destId="{341F1C0F-3227-4AF7-A235-7B8715329ED2}" srcOrd="1" destOrd="0" presId="urn:microsoft.com/office/officeart/2005/8/layout/hierarchy1"/>
    <dgm:cxn modelId="{870403F0-4D92-413F-BCE6-A3D3BBABF7AE}" type="presParOf" srcId="{85D74C60-ABF6-4457-BD58-B37CBD64EF9C}" destId="{FE0007A4-C4D6-4A36-A474-BA63BEC562FC}" srcOrd="1" destOrd="0" presId="urn:microsoft.com/office/officeart/2005/8/layout/hierarchy1"/>
    <dgm:cxn modelId="{D6B82E0A-7D9B-498A-A1BC-206479BCAE1E}" type="presParOf" srcId="{51A905D0-97BB-4E42-B745-AD88BFBAE9BF}" destId="{5B9643E3-212C-47EF-AFB2-973F1D8AF02C}" srcOrd="2" destOrd="0" presId="urn:microsoft.com/office/officeart/2005/8/layout/hierarchy1"/>
    <dgm:cxn modelId="{C873D44A-8A40-42F1-A898-CAED5CEF884D}" type="presParOf" srcId="{51A905D0-97BB-4E42-B745-AD88BFBAE9BF}" destId="{D010951F-8DED-4C5B-A136-6D57C0E2E402}" srcOrd="3" destOrd="0" presId="urn:microsoft.com/office/officeart/2005/8/layout/hierarchy1"/>
    <dgm:cxn modelId="{3958635C-27D0-49D1-A1DB-4805871E730F}" type="presParOf" srcId="{D010951F-8DED-4C5B-A136-6D57C0E2E402}" destId="{597047E5-926F-4E76-A26C-7FA0AAB2DE61}" srcOrd="0" destOrd="0" presId="urn:microsoft.com/office/officeart/2005/8/layout/hierarchy1"/>
    <dgm:cxn modelId="{58C0EFA4-48FC-4577-A445-B90F51252420}" type="presParOf" srcId="{597047E5-926F-4E76-A26C-7FA0AAB2DE61}" destId="{95579AF6-662F-431F-B58B-EE34010936B8}" srcOrd="0" destOrd="0" presId="urn:microsoft.com/office/officeart/2005/8/layout/hierarchy1"/>
    <dgm:cxn modelId="{454F790A-AC71-4CB2-9C41-3001A01ECD34}" type="presParOf" srcId="{597047E5-926F-4E76-A26C-7FA0AAB2DE61}" destId="{5760BCE9-AB1D-4728-AD00-CDF562149757}" srcOrd="1" destOrd="0" presId="urn:microsoft.com/office/officeart/2005/8/layout/hierarchy1"/>
    <dgm:cxn modelId="{E8C34D96-B91B-42A1-8231-DCE2C528656B}" type="presParOf" srcId="{D010951F-8DED-4C5B-A136-6D57C0E2E402}" destId="{FFFB71CD-535E-4340-AFAA-00B373529DF3}" srcOrd="1" destOrd="0" presId="urn:microsoft.com/office/officeart/2005/8/layout/hierarchy1"/>
    <dgm:cxn modelId="{35295873-F6DA-4EE2-8F19-AA92D4F1CC24}" type="presParOf" srcId="{FFFB71CD-535E-4340-AFAA-00B373529DF3}" destId="{D0AE4843-8660-4C5B-B3C1-2CE71B3AB30F}" srcOrd="0" destOrd="0" presId="urn:microsoft.com/office/officeart/2005/8/layout/hierarchy1"/>
    <dgm:cxn modelId="{DBE57028-6B68-4F12-96AD-81E493EBA598}" type="presParOf" srcId="{FFFB71CD-535E-4340-AFAA-00B373529DF3}" destId="{0D2F9DDE-5B99-4E0A-B86C-AB2A7F2F5033}" srcOrd="1" destOrd="0" presId="urn:microsoft.com/office/officeart/2005/8/layout/hierarchy1"/>
    <dgm:cxn modelId="{B9A84B57-FEE1-44EC-9FA9-328B1E4E2261}" type="presParOf" srcId="{0D2F9DDE-5B99-4E0A-B86C-AB2A7F2F5033}" destId="{1AAFDD6B-F511-408A-91DC-B5506F6A8052}" srcOrd="0" destOrd="0" presId="urn:microsoft.com/office/officeart/2005/8/layout/hierarchy1"/>
    <dgm:cxn modelId="{8805EBBB-A0B3-4D6D-947B-B13233065CA9}" type="presParOf" srcId="{1AAFDD6B-F511-408A-91DC-B5506F6A8052}" destId="{5FD9B2AF-5360-461C-894A-FF1571664C12}" srcOrd="0" destOrd="0" presId="urn:microsoft.com/office/officeart/2005/8/layout/hierarchy1"/>
    <dgm:cxn modelId="{145572D5-9EC3-4A45-94EB-B6C03D85A42C}" type="presParOf" srcId="{1AAFDD6B-F511-408A-91DC-B5506F6A8052}" destId="{B7878799-F1DC-4554-AE5D-47CB77E50709}" srcOrd="1" destOrd="0" presId="urn:microsoft.com/office/officeart/2005/8/layout/hierarchy1"/>
    <dgm:cxn modelId="{9C7D5F34-72AF-402F-9458-584C670FD10F}" type="presParOf" srcId="{0D2F9DDE-5B99-4E0A-B86C-AB2A7F2F5033}" destId="{69849324-92F4-48DB-8C12-AD17247532DB}" srcOrd="1" destOrd="0" presId="urn:microsoft.com/office/officeart/2005/8/layout/hierarchy1"/>
    <dgm:cxn modelId="{1583BBB7-9CB0-4ADA-AB8D-066DB0A630C2}" type="presParOf" srcId="{FFFB71CD-535E-4340-AFAA-00B373529DF3}" destId="{DB3B5C08-D1F7-44C5-B95C-C648118EEA81}" srcOrd="2" destOrd="0" presId="urn:microsoft.com/office/officeart/2005/8/layout/hierarchy1"/>
    <dgm:cxn modelId="{FC4282DE-42B0-4E95-9780-0B01256EFC19}" type="presParOf" srcId="{FFFB71CD-535E-4340-AFAA-00B373529DF3}" destId="{AF9C41BC-F9FA-4884-93A9-E097BBF64C03}" srcOrd="3" destOrd="0" presId="urn:microsoft.com/office/officeart/2005/8/layout/hierarchy1"/>
    <dgm:cxn modelId="{18384BFB-E7A4-4F99-B845-E4CF7771BDC7}" type="presParOf" srcId="{AF9C41BC-F9FA-4884-93A9-E097BBF64C03}" destId="{75A02C9B-7282-4DAC-89F3-DFD81F13E356}" srcOrd="0" destOrd="0" presId="urn:microsoft.com/office/officeart/2005/8/layout/hierarchy1"/>
    <dgm:cxn modelId="{EF7E5545-90E1-45DC-9C6D-5F8E7EAFEAD1}" type="presParOf" srcId="{75A02C9B-7282-4DAC-89F3-DFD81F13E356}" destId="{FBDD335C-C949-48C2-A132-0809D66F372D}" srcOrd="0" destOrd="0" presId="urn:microsoft.com/office/officeart/2005/8/layout/hierarchy1"/>
    <dgm:cxn modelId="{E98E3E12-3AB1-48A7-A6B0-A6A56EE7219C}" type="presParOf" srcId="{75A02C9B-7282-4DAC-89F3-DFD81F13E356}" destId="{ED224E1D-0067-4F05-AFE3-A9C67BD8C9A3}" srcOrd="1" destOrd="0" presId="urn:microsoft.com/office/officeart/2005/8/layout/hierarchy1"/>
    <dgm:cxn modelId="{A63D1E9C-FC07-4DE0-A702-69E76406E07C}" type="presParOf" srcId="{AF9C41BC-F9FA-4884-93A9-E097BBF64C03}" destId="{0A8B33C1-BDBF-496E-934A-6DA90A591D58}" srcOrd="1" destOrd="0" presId="urn:microsoft.com/office/officeart/2005/8/layout/hierarchy1"/>
    <dgm:cxn modelId="{96EC6C08-636D-4E2E-A1F2-EB0EED68F413}" type="presParOf" srcId="{FFFB71CD-535E-4340-AFAA-00B373529DF3}" destId="{3997403E-F5E5-4EC0-9471-3AB3C5E31471}" srcOrd="4" destOrd="0" presId="urn:microsoft.com/office/officeart/2005/8/layout/hierarchy1"/>
    <dgm:cxn modelId="{79FAC1D5-078E-4FFC-8675-F7517F605073}" type="presParOf" srcId="{FFFB71CD-535E-4340-AFAA-00B373529DF3}" destId="{A157160F-F28F-4470-81EC-50EDD75A1A3A}" srcOrd="5" destOrd="0" presId="urn:microsoft.com/office/officeart/2005/8/layout/hierarchy1"/>
    <dgm:cxn modelId="{0BA5E4BE-3B41-4EAC-B89B-A140B702CD6F}" type="presParOf" srcId="{A157160F-F28F-4470-81EC-50EDD75A1A3A}" destId="{1A43FDA4-162E-496D-8641-A92DC812E3CB}" srcOrd="0" destOrd="0" presId="urn:microsoft.com/office/officeart/2005/8/layout/hierarchy1"/>
    <dgm:cxn modelId="{1048A8C8-9315-44FC-8D60-8CFD19CC1271}" type="presParOf" srcId="{1A43FDA4-162E-496D-8641-A92DC812E3CB}" destId="{C1333C45-0B57-49A1-A0E5-46A00867DCAB}" srcOrd="0" destOrd="0" presId="urn:microsoft.com/office/officeart/2005/8/layout/hierarchy1"/>
    <dgm:cxn modelId="{263B030F-8F1C-4871-9D57-9E2180AC1F66}" type="presParOf" srcId="{1A43FDA4-162E-496D-8641-A92DC812E3CB}" destId="{1103C920-D68B-49CA-B05E-821269F69490}" srcOrd="1" destOrd="0" presId="urn:microsoft.com/office/officeart/2005/8/layout/hierarchy1"/>
    <dgm:cxn modelId="{3B1E3168-8A75-4C83-A70F-6D1265D029B0}" type="presParOf" srcId="{A157160F-F28F-4470-81EC-50EDD75A1A3A}" destId="{1804CA77-D9A6-437C-9ADC-3818E5149CD1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997403E-F5E5-4EC0-9471-3AB3C5E31471}">
      <dsp:nvSpPr>
        <dsp:cNvPr id="0" name=""/>
        <dsp:cNvSpPr/>
      </dsp:nvSpPr>
      <dsp:spPr>
        <a:xfrm>
          <a:off x="5892022" y="3051322"/>
          <a:ext cx="918955" cy="2186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9016"/>
              </a:lnTo>
              <a:lnTo>
                <a:pt x="918955" y="149016"/>
              </a:lnTo>
              <a:lnTo>
                <a:pt x="918955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B3B5C08-D1F7-44C5-B95C-C648118EEA81}">
      <dsp:nvSpPr>
        <dsp:cNvPr id="0" name=""/>
        <dsp:cNvSpPr/>
      </dsp:nvSpPr>
      <dsp:spPr>
        <a:xfrm>
          <a:off x="5846302" y="3051322"/>
          <a:ext cx="91440" cy="218669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0AE4843-8660-4C5B-B3C1-2CE71B3AB30F}">
      <dsp:nvSpPr>
        <dsp:cNvPr id="0" name=""/>
        <dsp:cNvSpPr/>
      </dsp:nvSpPr>
      <dsp:spPr>
        <a:xfrm>
          <a:off x="4973066" y="3051322"/>
          <a:ext cx="918955" cy="218669"/>
        </a:xfrm>
        <a:custGeom>
          <a:avLst/>
          <a:gdLst/>
          <a:ahLst/>
          <a:cxnLst/>
          <a:rect l="0" t="0" r="0" b="0"/>
          <a:pathLst>
            <a:path>
              <a:moveTo>
                <a:pt x="918955" y="0"/>
              </a:moveTo>
              <a:lnTo>
                <a:pt x="918955" y="149016"/>
              </a:lnTo>
              <a:lnTo>
                <a:pt x="0" y="149016"/>
              </a:lnTo>
              <a:lnTo>
                <a:pt x="0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B9643E3-212C-47EF-AFB2-973F1D8AF02C}">
      <dsp:nvSpPr>
        <dsp:cNvPr id="0" name=""/>
        <dsp:cNvSpPr/>
      </dsp:nvSpPr>
      <dsp:spPr>
        <a:xfrm>
          <a:off x="4918183" y="2355213"/>
          <a:ext cx="973838" cy="2186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9016"/>
              </a:lnTo>
              <a:lnTo>
                <a:pt x="973838" y="149016"/>
              </a:lnTo>
              <a:lnTo>
                <a:pt x="973838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C155B66-3E06-4B93-87AD-64FF92E4BCEB}">
      <dsp:nvSpPr>
        <dsp:cNvPr id="0" name=""/>
        <dsp:cNvSpPr/>
      </dsp:nvSpPr>
      <dsp:spPr>
        <a:xfrm>
          <a:off x="4008345" y="3039963"/>
          <a:ext cx="91440" cy="23002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160375"/>
              </a:lnTo>
              <a:lnTo>
                <a:pt x="45765" y="160375"/>
              </a:lnTo>
              <a:lnTo>
                <a:pt x="45765" y="230027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A67402F-85C9-46EB-A8A4-A5D4E89817E4}">
      <dsp:nvSpPr>
        <dsp:cNvPr id="0" name=""/>
        <dsp:cNvSpPr/>
      </dsp:nvSpPr>
      <dsp:spPr>
        <a:xfrm>
          <a:off x="4054065" y="2355213"/>
          <a:ext cx="864117" cy="207311"/>
        </a:xfrm>
        <a:custGeom>
          <a:avLst/>
          <a:gdLst/>
          <a:ahLst/>
          <a:cxnLst/>
          <a:rect l="0" t="0" r="0" b="0"/>
          <a:pathLst>
            <a:path>
              <a:moveTo>
                <a:pt x="864117" y="0"/>
              </a:moveTo>
              <a:lnTo>
                <a:pt x="864117" y="137658"/>
              </a:lnTo>
              <a:lnTo>
                <a:pt x="0" y="137658"/>
              </a:lnTo>
              <a:lnTo>
                <a:pt x="0" y="207311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436436E-6CDE-4D95-BFED-4C2725194863}">
      <dsp:nvSpPr>
        <dsp:cNvPr id="0" name=""/>
        <dsp:cNvSpPr/>
      </dsp:nvSpPr>
      <dsp:spPr>
        <a:xfrm>
          <a:off x="3346026" y="1659104"/>
          <a:ext cx="1572157" cy="2186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9016"/>
              </a:lnTo>
              <a:lnTo>
                <a:pt x="1572157" y="149016"/>
              </a:lnTo>
              <a:lnTo>
                <a:pt x="1572157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FD6D4F6-6A40-470E-9FCC-70A6BAF98C9E}">
      <dsp:nvSpPr>
        <dsp:cNvPr id="0" name=""/>
        <dsp:cNvSpPr/>
      </dsp:nvSpPr>
      <dsp:spPr>
        <a:xfrm>
          <a:off x="2675677" y="3051322"/>
          <a:ext cx="459477" cy="2186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9016"/>
              </a:lnTo>
              <a:lnTo>
                <a:pt x="459477" y="149016"/>
              </a:lnTo>
              <a:lnTo>
                <a:pt x="459477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A90E2CB-1107-439F-9345-F7C1191605A9}">
      <dsp:nvSpPr>
        <dsp:cNvPr id="0" name=""/>
        <dsp:cNvSpPr/>
      </dsp:nvSpPr>
      <dsp:spPr>
        <a:xfrm>
          <a:off x="2216200" y="3051322"/>
          <a:ext cx="459477" cy="218669"/>
        </a:xfrm>
        <a:custGeom>
          <a:avLst/>
          <a:gdLst/>
          <a:ahLst/>
          <a:cxnLst/>
          <a:rect l="0" t="0" r="0" b="0"/>
          <a:pathLst>
            <a:path>
              <a:moveTo>
                <a:pt x="459477" y="0"/>
              </a:moveTo>
              <a:lnTo>
                <a:pt x="459477" y="149016"/>
              </a:lnTo>
              <a:lnTo>
                <a:pt x="0" y="149016"/>
              </a:lnTo>
              <a:lnTo>
                <a:pt x="0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E13EBBF-CFCF-4B42-AC2D-763F318D5A08}">
      <dsp:nvSpPr>
        <dsp:cNvPr id="0" name=""/>
        <dsp:cNvSpPr/>
      </dsp:nvSpPr>
      <dsp:spPr>
        <a:xfrm>
          <a:off x="1773868" y="2355213"/>
          <a:ext cx="901809" cy="2186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9016"/>
              </a:lnTo>
              <a:lnTo>
                <a:pt x="901809" y="149016"/>
              </a:lnTo>
              <a:lnTo>
                <a:pt x="901809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DB36F63-04D3-42CC-A08E-1E1D6E4E2822}">
      <dsp:nvSpPr>
        <dsp:cNvPr id="0" name=""/>
        <dsp:cNvSpPr/>
      </dsp:nvSpPr>
      <dsp:spPr>
        <a:xfrm>
          <a:off x="898397" y="3069727"/>
          <a:ext cx="398846" cy="20026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30611"/>
              </a:lnTo>
              <a:lnTo>
                <a:pt x="398846" y="130611"/>
              </a:lnTo>
              <a:lnTo>
                <a:pt x="398846" y="200264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FB98C59-4220-44BB-B9B0-52F22164B30F}">
      <dsp:nvSpPr>
        <dsp:cNvPr id="0" name=""/>
        <dsp:cNvSpPr/>
      </dsp:nvSpPr>
      <dsp:spPr>
        <a:xfrm>
          <a:off x="378289" y="3069727"/>
          <a:ext cx="520108" cy="200264"/>
        </a:xfrm>
        <a:custGeom>
          <a:avLst/>
          <a:gdLst/>
          <a:ahLst/>
          <a:cxnLst/>
          <a:rect l="0" t="0" r="0" b="0"/>
          <a:pathLst>
            <a:path>
              <a:moveTo>
                <a:pt x="520108" y="0"/>
              </a:moveTo>
              <a:lnTo>
                <a:pt x="520108" y="130611"/>
              </a:lnTo>
              <a:lnTo>
                <a:pt x="0" y="130611"/>
              </a:lnTo>
              <a:lnTo>
                <a:pt x="0" y="200264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8E8D6DB-B3B2-44B5-BD68-245B285F1D4D}">
      <dsp:nvSpPr>
        <dsp:cNvPr id="0" name=""/>
        <dsp:cNvSpPr/>
      </dsp:nvSpPr>
      <dsp:spPr>
        <a:xfrm>
          <a:off x="898397" y="2355213"/>
          <a:ext cx="875470" cy="237074"/>
        </a:xfrm>
        <a:custGeom>
          <a:avLst/>
          <a:gdLst/>
          <a:ahLst/>
          <a:cxnLst/>
          <a:rect l="0" t="0" r="0" b="0"/>
          <a:pathLst>
            <a:path>
              <a:moveTo>
                <a:pt x="875470" y="0"/>
              </a:moveTo>
              <a:lnTo>
                <a:pt x="875470" y="167422"/>
              </a:lnTo>
              <a:lnTo>
                <a:pt x="0" y="167422"/>
              </a:lnTo>
              <a:lnTo>
                <a:pt x="0" y="237074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6EFC856-ACCC-4510-84DB-192EF9E61DA8}">
      <dsp:nvSpPr>
        <dsp:cNvPr id="0" name=""/>
        <dsp:cNvSpPr/>
      </dsp:nvSpPr>
      <dsp:spPr>
        <a:xfrm>
          <a:off x="1773868" y="1659104"/>
          <a:ext cx="1572157" cy="218669"/>
        </a:xfrm>
        <a:custGeom>
          <a:avLst/>
          <a:gdLst/>
          <a:ahLst/>
          <a:cxnLst/>
          <a:rect l="0" t="0" r="0" b="0"/>
          <a:pathLst>
            <a:path>
              <a:moveTo>
                <a:pt x="1572157" y="0"/>
              </a:moveTo>
              <a:lnTo>
                <a:pt x="1572157" y="149016"/>
              </a:lnTo>
              <a:lnTo>
                <a:pt x="0" y="149016"/>
              </a:lnTo>
              <a:lnTo>
                <a:pt x="0" y="218669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C3D6616-166B-4F1A-835D-C4983B921AF3}">
      <dsp:nvSpPr>
        <dsp:cNvPr id="0" name=""/>
        <dsp:cNvSpPr/>
      </dsp:nvSpPr>
      <dsp:spPr>
        <a:xfrm>
          <a:off x="2886548" y="962995"/>
          <a:ext cx="459477" cy="21866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49016"/>
              </a:lnTo>
              <a:lnTo>
                <a:pt x="459477" y="149016"/>
              </a:lnTo>
              <a:lnTo>
                <a:pt x="459477" y="218669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5C62699-8A41-414D-AE54-E06E01E9B5F6}">
      <dsp:nvSpPr>
        <dsp:cNvPr id="0" name=""/>
        <dsp:cNvSpPr/>
      </dsp:nvSpPr>
      <dsp:spPr>
        <a:xfrm>
          <a:off x="2427070" y="962995"/>
          <a:ext cx="459477" cy="218669"/>
        </a:xfrm>
        <a:custGeom>
          <a:avLst/>
          <a:gdLst/>
          <a:ahLst/>
          <a:cxnLst/>
          <a:rect l="0" t="0" r="0" b="0"/>
          <a:pathLst>
            <a:path>
              <a:moveTo>
                <a:pt x="459477" y="0"/>
              </a:moveTo>
              <a:lnTo>
                <a:pt x="459477" y="149016"/>
              </a:lnTo>
              <a:lnTo>
                <a:pt x="0" y="149016"/>
              </a:lnTo>
              <a:lnTo>
                <a:pt x="0" y="218669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4AAFA18-63F0-4988-85D0-2D7F5F495905}">
      <dsp:nvSpPr>
        <dsp:cNvPr id="0" name=""/>
        <dsp:cNvSpPr/>
      </dsp:nvSpPr>
      <dsp:spPr>
        <a:xfrm>
          <a:off x="2510612" y="485556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C76E990-510F-44BA-A3D8-7CC09CF70B5D}">
      <dsp:nvSpPr>
        <dsp:cNvPr id="0" name=""/>
        <dsp:cNvSpPr/>
      </dsp:nvSpPr>
      <dsp:spPr>
        <a:xfrm>
          <a:off x="2594153" y="564920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ponder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85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608137" y="578904"/>
        <a:ext cx="723904" cy="449471"/>
      </dsp:txXfrm>
    </dsp:sp>
    <dsp:sp modelId="{B02C5496-8B1A-4517-87D9-494694F82D3E}">
      <dsp:nvSpPr>
        <dsp:cNvPr id="0" name=""/>
        <dsp:cNvSpPr/>
      </dsp:nvSpPr>
      <dsp:spPr>
        <a:xfrm>
          <a:off x="2051134" y="1181665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EF741AF2-A701-4F4F-B5D0-3F6DE0D42BDC}">
      <dsp:nvSpPr>
        <dsp:cNvPr id="0" name=""/>
        <dsp:cNvSpPr/>
      </dsp:nvSpPr>
      <dsp:spPr>
        <a:xfrm>
          <a:off x="2134675" y="1261029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-RT(-)</a:t>
          </a:r>
          <a:r>
            <a:rPr kumimoji="1" lang="ja-JP" alt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10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148659" y="1275013"/>
        <a:ext cx="723904" cy="449471"/>
      </dsp:txXfrm>
    </dsp:sp>
    <dsp:sp modelId="{09D3524B-00EB-477F-A906-B97918D328E5}">
      <dsp:nvSpPr>
        <dsp:cNvPr id="0" name=""/>
        <dsp:cNvSpPr/>
      </dsp:nvSpPr>
      <dsp:spPr>
        <a:xfrm>
          <a:off x="2970089" y="1181665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540F739-880D-4C70-8B47-819C5AC53D6F}">
      <dsp:nvSpPr>
        <dsp:cNvPr id="0" name=""/>
        <dsp:cNvSpPr/>
      </dsp:nvSpPr>
      <dsp:spPr>
        <a:xfrm>
          <a:off x="3053631" y="1261029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-RT (+)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75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067615" y="1275013"/>
        <a:ext cx="723904" cy="449471"/>
      </dsp:txXfrm>
    </dsp:sp>
    <dsp:sp modelId="{AA05AB12-323C-4EC7-9AAE-F6C167ED2F24}">
      <dsp:nvSpPr>
        <dsp:cNvPr id="0" name=""/>
        <dsp:cNvSpPr/>
      </dsp:nvSpPr>
      <dsp:spPr>
        <a:xfrm>
          <a:off x="1397932" y="1877774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DF26862E-F334-49E1-B006-1D136B108AE6}">
      <dsp:nvSpPr>
        <dsp:cNvPr id="0" name=""/>
        <dsp:cNvSpPr/>
      </dsp:nvSpPr>
      <dsp:spPr>
        <a:xfrm>
          <a:off x="1481473" y="1957138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Easy to extract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16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495457" y="1971122"/>
        <a:ext cx="723904" cy="449471"/>
      </dsp:txXfrm>
    </dsp:sp>
    <dsp:sp modelId="{78B236F7-9A9F-47E1-9F07-31C60A9EB8C2}">
      <dsp:nvSpPr>
        <dsp:cNvPr id="0" name=""/>
        <dsp:cNvSpPr/>
      </dsp:nvSpPr>
      <dsp:spPr>
        <a:xfrm>
          <a:off x="379541" y="2592288"/>
          <a:ext cx="103771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67766ADD-A194-4432-A7A9-11F069D5B965}">
      <dsp:nvSpPr>
        <dsp:cNvPr id="0" name=""/>
        <dsp:cNvSpPr/>
      </dsp:nvSpPr>
      <dsp:spPr>
        <a:xfrm>
          <a:off x="463083" y="2671652"/>
          <a:ext cx="103771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+)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13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77067" y="2685636"/>
        <a:ext cx="1009744" cy="449471"/>
      </dsp:txXfrm>
    </dsp:sp>
    <dsp:sp modelId="{9A1CC577-1548-482B-B7A4-47D02F050469}">
      <dsp:nvSpPr>
        <dsp:cNvPr id="0" name=""/>
        <dsp:cNvSpPr/>
      </dsp:nvSpPr>
      <dsp:spPr>
        <a:xfrm>
          <a:off x="2352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3DEEE5D-E6F2-4179-8188-995C3E6E815D}">
      <dsp:nvSpPr>
        <dsp:cNvPr id="0" name=""/>
        <dsp:cNvSpPr/>
      </dsp:nvSpPr>
      <dsp:spPr>
        <a:xfrm>
          <a:off x="85894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 2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6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99878" y="3363340"/>
        <a:ext cx="723904" cy="449471"/>
      </dsp:txXfrm>
    </dsp:sp>
    <dsp:sp modelId="{4AAE161A-3AAC-4A2C-82FF-B9E743E0E7CF}">
      <dsp:nvSpPr>
        <dsp:cNvPr id="0" name=""/>
        <dsp:cNvSpPr/>
      </dsp:nvSpPr>
      <dsp:spPr>
        <a:xfrm>
          <a:off x="921308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678CB666-E6F0-486B-B4F0-76147EB28DE4}">
      <dsp:nvSpPr>
        <dsp:cNvPr id="0" name=""/>
        <dsp:cNvSpPr/>
      </dsp:nvSpPr>
      <dsp:spPr>
        <a:xfrm>
          <a:off x="1004849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3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6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018833" y="3363340"/>
        <a:ext cx="723904" cy="449471"/>
      </dsp:txXfrm>
    </dsp:sp>
    <dsp:sp modelId="{6FA0F4EB-7B95-4C80-A348-F48AE57E9EAF}">
      <dsp:nvSpPr>
        <dsp:cNvPr id="0" name=""/>
        <dsp:cNvSpPr/>
      </dsp:nvSpPr>
      <dsp:spPr>
        <a:xfrm>
          <a:off x="2122528" y="2573883"/>
          <a:ext cx="1106297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D0E944D-D50E-4AF0-9738-A657EB5AC76A}">
      <dsp:nvSpPr>
        <dsp:cNvPr id="0" name=""/>
        <dsp:cNvSpPr/>
      </dsp:nvSpPr>
      <dsp:spPr>
        <a:xfrm>
          <a:off x="2206070" y="2653247"/>
          <a:ext cx="1106297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-)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3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220054" y="2667231"/>
        <a:ext cx="1078329" cy="449471"/>
      </dsp:txXfrm>
    </dsp:sp>
    <dsp:sp modelId="{4BAD7874-3DAF-47F0-8419-9A9391976DDF}">
      <dsp:nvSpPr>
        <dsp:cNvPr id="0" name=""/>
        <dsp:cNvSpPr/>
      </dsp:nvSpPr>
      <dsp:spPr>
        <a:xfrm>
          <a:off x="1840263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D05B2C5A-8E19-4289-B5DB-23851939C00A}">
      <dsp:nvSpPr>
        <dsp:cNvPr id="0" name=""/>
        <dsp:cNvSpPr/>
      </dsp:nvSpPr>
      <dsp:spPr>
        <a:xfrm>
          <a:off x="1923805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2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2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937789" y="3363340"/>
        <a:ext cx="723904" cy="449471"/>
      </dsp:txXfrm>
    </dsp:sp>
    <dsp:sp modelId="{08764D7D-4C59-48F9-8F17-2540D8396F34}">
      <dsp:nvSpPr>
        <dsp:cNvPr id="0" name=""/>
        <dsp:cNvSpPr/>
      </dsp:nvSpPr>
      <dsp:spPr>
        <a:xfrm>
          <a:off x="2759219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3027C78-6028-4933-B85E-4EEC9B64E5CD}">
      <dsp:nvSpPr>
        <dsp:cNvPr id="0" name=""/>
        <dsp:cNvSpPr/>
      </dsp:nvSpPr>
      <dsp:spPr>
        <a:xfrm>
          <a:off x="2842760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 3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1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856744" y="3363340"/>
        <a:ext cx="723904" cy="449471"/>
      </dsp:txXfrm>
    </dsp:sp>
    <dsp:sp modelId="{40000CE0-B1C7-48C9-AF87-E5AC362B1169}">
      <dsp:nvSpPr>
        <dsp:cNvPr id="0" name=""/>
        <dsp:cNvSpPr/>
      </dsp:nvSpPr>
      <dsp:spPr>
        <a:xfrm>
          <a:off x="4542247" y="1877774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43C7995-EE0A-4B55-8C55-E73B9AF18DD6}">
      <dsp:nvSpPr>
        <dsp:cNvPr id="0" name=""/>
        <dsp:cNvSpPr/>
      </dsp:nvSpPr>
      <dsp:spPr>
        <a:xfrm>
          <a:off x="4625788" y="1957138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Difficult to extract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59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639772" y="1971122"/>
        <a:ext cx="723904" cy="449471"/>
      </dsp:txXfrm>
    </dsp:sp>
    <dsp:sp modelId="{E6AFA5F8-F0FA-4179-8235-23184592B669}">
      <dsp:nvSpPr>
        <dsp:cNvPr id="0" name=""/>
        <dsp:cNvSpPr/>
      </dsp:nvSpPr>
      <dsp:spPr>
        <a:xfrm>
          <a:off x="3439143" y="2562524"/>
          <a:ext cx="1229845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F237029-440B-4624-81A5-A5BA041163D8}">
      <dsp:nvSpPr>
        <dsp:cNvPr id="0" name=""/>
        <dsp:cNvSpPr/>
      </dsp:nvSpPr>
      <dsp:spPr>
        <a:xfrm>
          <a:off x="3522684" y="2641889"/>
          <a:ext cx="1229845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+)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N=7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536668" y="2655873"/>
        <a:ext cx="1201877" cy="449471"/>
      </dsp:txXfrm>
    </dsp:sp>
    <dsp:sp modelId="{0FFDABD6-31C4-4061-88B4-E8216447B88D}">
      <dsp:nvSpPr>
        <dsp:cNvPr id="0" name=""/>
        <dsp:cNvSpPr/>
      </dsp:nvSpPr>
      <dsp:spPr>
        <a:xfrm>
          <a:off x="3678174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41F1C0F-3227-4AF7-A235-7B8715329ED2}">
      <dsp:nvSpPr>
        <dsp:cNvPr id="0" name=""/>
        <dsp:cNvSpPr/>
      </dsp:nvSpPr>
      <dsp:spPr>
        <a:xfrm>
          <a:off x="3761716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 2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7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775700" y="3363340"/>
        <a:ext cx="723904" cy="449471"/>
      </dsp:txXfrm>
    </dsp:sp>
    <dsp:sp modelId="{95579AF6-662F-431F-B58B-EE34010936B8}">
      <dsp:nvSpPr>
        <dsp:cNvPr id="0" name=""/>
        <dsp:cNvSpPr/>
      </dsp:nvSpPr>
      <dsp:spPr>
        <a:xfrm>
          <a:off x="5386865" y="2573883"/>
          <a:ext cx="1010313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760BCE9-AB1D-4728-AD00-CDF562149757}">
      <dsp:nvSpPr>
        <dsp:cNvPr id="0" name=""/>
        <dsp:cNvSpPr/>
      </dsp:nvSpPr>
      <dsp:spPr>
        <a:xfrm>
          <a:off x="5470406" y="2653247"/>
          <a:ext cx="1010313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-RT tag (-)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52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484390" y="2667231"/>
        <a:ext cx="982345" cy="449471"/>
      </dsp:txXfrm>
    </dsp:sp>
    <dsp:sp modelId="{5FD9B2AF-5360-461C-894A-FF1571664C12}">
      <dsp:nvSpPr>
        <dsp:cNvPr id="0" name=""/>
        <dsp:cNvSpPr/>
      </dsp:nvSpPr>
      <dsp:spPr>
        <a:xfrm>
          <a:off x="4597130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B7878799-F1DC-4554-AE5D-47CB77E50709}">
      <dsp:nvSpPr>
        <dsp:cNvPr id="0" name=""/>
        <dsp:cNvSpPr/>
      </dsp:nvSpPr>
      <dsp:spPr>
        <a:xfrm>
          <a:off x="4680671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 1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15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694655" y="3363340"/>
        <a:ext cx="723904" cy="449471"/>
      </dsp:txXfrm>
    </dsp:sp>
    <dsp:sp modelId="{FBDD335C-C949-48C2-A132-0809D66F372D}">
      <dsp:nvSpPr>
        <dsp:cNvPr id="0" name=""/>
        <dsp:cNvSpPr/>
      </dsp:nvSpPr>
      <dsp:spPr>
        <a:xfrm>
          <a:off x="5516085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ED224E1D-0067-4F05-AFE3-A9C67BD8C9A3}">
      <dsp:nvSpPr>
        <dsp:cNvPr id="0" name=""/>
        <dsp:cNvSpPr/>
      </dsp:nvSpPr>
      <dsp:spPr>
        <a:xfrm>
          <a:off x="5599627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 2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36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613611" y="3363340"/>
        <a:ext cx="723904" cy="449471"/>
      </dsp:txXfrm>
    </dsp:sp>
    <dsp:sp modelId="{C1333C45-0B57-49A1-A0E5-46A00867DCAB}">
      <dsp:nvSpPr>
        <dsp:cNvPr id="0" name=""/>
        <dsp:cNvSpPr/>
      </dsp:nvSpPr>
      <dsp:spPr>
        <a:xfrm>
          <a:off x="6435041" y="3269991"/>
          <a:ext cx="751872" cy="47743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103C920-D68B-49CA-B05E-821269F69490}">
      <dsp:nvSpPr>
        <dsp:cNvPr id="0" name=""/>
        <dsp:cNvSpPr/>
      </dsp:nvSpPr>
      <dsp:spPr>
        <a:xfrm>
          <a:off x="6518582" y="3349356"/>
          <a:ext cx="751872" cy="47743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Group 3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N=1</a:t>
          </a:r>
          <a:endParaRPr kumimoji="1" lang="ja-JP" alt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6532566" y="3363340"/>
        <a:ext cx="723904" cy="44947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80DAB1-01F6-4A94-86C1-72B47F8E7321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F1D6FF-00E5-482D-8E2D-12676C56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2038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F1D6FF-00E5-482D-8E2D-12676C5626E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6346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789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3176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3803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3252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1282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6244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468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8572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9832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7215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991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68DAB1-6B0C-439E-B378-180DCA011A15}" type="datetimeFigureOut">
              <a:rPr kumimoji="1" lang="ja-JP" altLang="en-US" smtClean="0"/>
              <a:t>2020/10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4FDC2-C4BD-4500-98A7-9B072410E4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1294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テキスト ボックス 27"/>
          <p:cNvSpPr txBox="1"/>
          <p:nvPr/>
        </p:nvSpPr>
        <p:spPr>
          <a:xfrm>
            <a:off x="107504" y="116632"/>
            <a:ext cx="2013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Supplemental Figure 1. 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A49ECC6-B92E-4195-948A-2DE52EC0DD52}"/>
              </a:ext>
            </a:extLst>
          </p:cNvPr>
          <p:cNvGrpSpPr/>
          <p:nvPr/>
        </p:nvGrpSpPr>
        <p:grpSpPr>
          <a:xfrm>
            <a:off x="1051502" y="1151495"/>
            <a:ext cx="6069276" cy="4999286"/>
            <a:chOff x="1051502" y="1151495"/>
            <a:chExt cx="6069276" cy="4999286"/>
          </a:xfrm>
        </p:grpSpPr>
        <p:sp>
          <p:nvSpPr>
            <p:cNvPr id="18" name="Rectangle 17"/>
            <p:cNvSpPr>
              <a:spLocks noChangeArrowheads="1"/>
            </p:cNvSpPr>
            <p:nvPr/>
          </p:nvSpPr>
          <p:spPr bwMode="auto">
            <a:xfrm>
              <a:off x="1655609" y="4743447"/>
              <a:ext cx="2741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600" b="1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Times New Roman" panose="02020603050405020304" pitchFamily="18" charset="0"/>
                  <a:ea typeface="ＭＳ Ｐゴシック" pitchFamily="50" charset="-128"/>
                  <a:cs typeface="Times New Roman" pitchFamily="18" charset="0"/>
                </a:rPr>
                <a:t>50-</a:t>
              </a:r>
              <a:endParaRPr kumimoji="1" lang="ja-JP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Ｐゴシック" pitchFamily="50" charset="-128"/>
                <a:cs typeface="Times New Roman" pitchFamily="18" charset="0"/>
              </a:endParaRPr>
            </a:p>
          </p:txBody>
        </p:sp>
        <p:sp>
          <p:nvSpPr>
            <p:cNvPr id="19" name="Rectangle 18"/>
            <p:cNvSpPr>
              <a:spLocks noChangeArrowheads="1"/>
            </p:cNvSpPr>
            <p:nvPr/>
          </p:nvSpPr>
          <p:spPr bwMode="auto">
            <a:xfrm>
              <a:off x="1539930" y="4086622"/>
              <a:ext cx="47929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600" b="1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Times New Roman" panose="02020603050405020304" pitchFamily="18" charset="0"/>
                  <a:ea typeface="ＭＳ Ｐゴシック" pitchFamily="50" charset="-128"/>
                  <a:cs typeface="Times New Roman" pitchFamily="18" charset="0"/>
                </a:rPr>
                <a:t>31-40</a:t>
              </a:r>
              <a:endParaRPr kumimoji="1" lang="ja-JP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Ｐゴシック" pitchFamily="50" charset="-128"/>
                <a:cs typeface="Times New Roman" pitchFamily="18" charset="0"/>
              </a:endParaRPr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>
              <a:off x="1539930" y="3415065"/>
              <a:ext cx="47929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600" b="1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Times New Roman" panose="02020603050405020304" pitchFamily="18" charset="0"/>
                  <a:ea typeface="ＭＳ Ｐゴシック" pitchFamily="50" charset="-128"/>
                  <a:cs typeface="Times New Roman" pitchFamily="18" charset="0"/>
                </a:rPr>
                <a:t>21-30</a:t>
              </a:r>
              <a:endParaRPr kumimoji="1" lang="ja-JP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Ｐゴシック" pitchFamily="50" charset="-128"/>
                <a:cs typeface="Times New Roman" pitchFamily="18" charset="0"/>
              </a:endParaRPr>
            </a:p>
          </p:txBody>
        </p:sp>
        <p:sp>
          <p:nvSpPr>
            <p:cNvPr id="21" name="Rectangle 20"/>
            <p:cNvSpPr>
              <a:spLocks noChangeArrowheads="1"/>
            </p:cNvSpPr>
            <p:nvPr/>
          </p:nvSpPr>
          <p:spPr bwMode="auto">
            <a:xfrm>
              <a:off x="1539930" y="2773636"/>
              <a:ext cx="46794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600" b="1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Times New Roman" panose="02020603050405020304" pitchFamily="18" charset="0"/>
                  <a:ea typeface="ＭＳ Ｐゴシック" pitchFamily="50" charset="-128"/>
                  <a:cs typeface="Times New Roman" pitchFamily="18" charset="0"/>
                </a:rPr>
                <a:t>11-20</a:t>
              </a:r>
              <a:endParaRPr kumimoji="1" lang="ja-JP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Ｐゴシック" pitchFamily="50" charset="-128"/>
                <a:cs typeface="Times New Roman" pitchFamily="18" charset="0"/>
              </a:endParaRP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1604168" y="2132207"/>
              <a:ext cx="3767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600" b="1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Times New Roman" panose="02020603050405020304" pitchFamily="18" charset="0"/>
                  <a:ea typeface="ＭＳ Ｐゴシック" pitchFamily="50" charset="-128"/>
                  <a:cs typeface="Times New Roman" pitchFamily="18" charset="0"/>
                </a:rPr>
                <a:t>1-10</a:t>
              </a:r>
              <a:endParaRPr kumimoji="1" lang="ja-JP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ＭＳ Ｐゴシック" pitchFamily="50" charset="-128"/>
                <a:cs typeface="Times New Roman" pitchFamily="18" charset="0"/>
              </a:endParaRPr>
            </a:p>
          </p:txBody>
        </p:sp>
        <p:sp>
          <p:nvSpPr>
            <p:cNvPr id="29" name="正方形/長方形 28"/>
            <p:cNvSpPr/>
            <p:nvPr/>
          </p:nvSpPr>
          <p:spPr>
            <a:xfrm>
              <a:off x="3635896" y="5843004"/>
              <a:ext cx="125547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b="1" dirty="0">
                  <a:latin typeface="Times New Roman" pitchFamily="18" charset="0"/>
                  <a:cs typeface="Times New Roman" pitchFamily="18" charset="0"/>
                </a:rPr>
                <a:t>Institution No</a:t>
              </a:r>
              <a:endParaRPr lang="ja-JP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 rot="16200000">
              <a:off x="-354541" y="2557538"/>
              <a:ext cx="31198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Times New Roman" pitchFamily="18" charset="0"/>
                  <a:cs typeface="Times New Roman" pitchFamily="18" charset="0"/>
                </a:rPr>
                <a:t>Re-RT PT No in 2018</a:t>
              </a:r>
              <a:endParaRPr kumimoji="1" lang="en-US" altLang="ja-JP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503" name="グループ化 502">
              <a:extLst>
                <a:ext uri="{FF2B5EF4-FFF2-40B4-BE49-F238E27FC236}">
                  <a16:creationId xmlns:a16="http://schemas.microsoft.com/office/drawing/2014/main" id="{2EFCD58E-8225-4860-809F-3D2A4798D45D}"/>
                </a:ext>
              </a:extLst>
            </p:cNvPr>
            <p:cNvGrpSpPr/>
            <p:nvPr/>
          </p:nvGrpSpPr>
          <p:grpSpPr>
            <a:xfrm>
              <a:off x="2153441" y="1340768"/>
              <a:ext cx="4967337" cy="4347490"/>
              <a:chOff x="2493963" y="1655763"/>
              <a:chExt cx="4967337" cy="2999808"/>
            </a:xfrm>
          </p:grpSpPr>
          <p:sp>
            <p:nvSpPr>
              <p:cNvPr id="304" name="Freeform 6">
                <a:extLst>
                  <a:ext uri="{FF2B5EF4-FFF2-40B4-BE49-F238E27FC236}">
                    <a16:creationId xmlns:a16="http://schemas.microsoft.com/office/drawing/2014/main" id="{300FDE19-C331-4602-B300-C34B4426315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616325" y="1655763"/>
                <a:ext cx="3717925" cy="2763838"/>
              </a:xfrm>
              <a:custGeom>
                <a:avLst/>
                <a:gdLst>
                  <a:gd name="T0" fmla="*/ 0 w 2342"/>
                  <a:gd name="T1" fmla="*/ 0 h 1741"/>
                  <a:gd name="T2" fmla="*/ 0 w 2342"/>
                  <a:gd name="T3" fmla="*/ 1741 h 1741"/>
                  <a:gd name="T4" fmla="*/ 585 w 2342"/>
                  <a:gd name="T5" fmla="*/ 0 h 1741"/>
                  <a:gd name="T6" fmla="*/ 585 w 2342"/>
                  <a:gd name="T7" fmla="*/ 1741 h 1741"/>
                  <a:gd name="T8" fmla="*/ 1171 w 2342"/>
                  <a:gd name="T9" fmla="*/ 0 h 1741"/>
                  <a:gd name="T10" fmla="*/ 1171 w 2342"/>
                  <a:gd name="T11" fmla="*/ 1741 h 1741"/>
                  <a:gd name="T12" fmla="*/ 1757 w 2342"/>
                  <a:gd name="T13" fmla="*/ 0 h 1741"/>
                  <a:gd name="T14" fmla="*/ 1757 w 2342"/>
                  <a:gd name="T15" fmla="*/ 1741 h 1741"/>
                  <a:gd name="T16" fmla="*/ 2342 w 2342"/>
                  <a:gd name="T17" fmla="*/ 0 h 1741"/>
                  <a:gd name="T18" fmla="*/ 2342 w 2342"/>
                  <a:gd name="T19" fmla="*/ 1741 h 17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42" h="1741">
                    <a:moveTo>
                      <a:pt x="0" y="0"/>
                    </a:moveTo>
                    <a:lnTo>
                      <a:pt x="0" y="1741"/>
                    </a:lnTo>
                    <a:moveTo>
                      <a:pt x="585" y="0"/>
                    </a:moveTo>
                    <a:lnTo>
                      <a:pt x="585" y="1741"/>
                    </a:lnTo>
                    <a:moveTo>
                      <a:pt x="1171" y="0"/>
                    </a:moveTo>
                    <a:lnTo>
                      <a:pt x="1171" y="1741"/>
                    </a:lnTo>
                    <a:moveTo>
                      <a:pt x="1757" y="0"/>
                    </a:moveTo>
                    <a:lnTo>
                      <a:pt x="1757" y="1741"/>
                    </a:lnTo>
                    <a:moveTo>
                      <a:pt x="2342" y="0"/>
                    </a:moveTo>
                    <a:lnTo>
                      <a:pt x="2342" y="1741"/>
                    </a:lnTo>
                  </a:path>
                </a:pathLst>
              </a:custGeom>
              <a:noFill/>
              <a:ln w="11113" cap="flat">
                <a:solidFill>
                  <a:srgbClr val="E0E5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5" name="Rectangle 7">
                <a:extLst>
                  <a:ext uri="{FF2B5EF4-FFF2-40B4-BE49-F238E27FC236}">
                    <a16:creationId xmlns:a16="http://schemas.microsoft.com/office/drawing/2014/main" id="{6048F421-2A18-4B5F-A9BD-7DAD1A9187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35425"/>
                <a:ext cx="185738" cy="1588"/>
              </a:xfrm>
              <a:prstGeom prst="rect">
                <a:avLst/>
              </a:prstGeom>
              <a:solidFill>
                <a:srgbClr val="59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6" name="Rectangle 8">
                <a:extLst>
                  <a:ext uri="{FF2B5EF4-FFF2-40B4-BE49-F238E27FC236}">
                    <a16:creationId xmlns:a16="http://schemas.microsoft.com/office/drawing/2014/main" id="{62882ED2-D550-49BA-AE49-6E0CC4585F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37013"/>
                <a:ext cx="185738" cy="1588"/>
              </a:xfrm>
              <a:prstGeom prst="rect">
                <a:avLst/>
              </a:prstGeom>
              <a:solidFill>
                <a:srgbClr val="58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7" name="Rectangle 9">
                <a:extLst>
                  <a:ext uri="{FF2B5EF4-FFF2-40B4-BE49-F238E27FC236}">
                    <a16:creationId xmlns:a16="http://schemas.microsoft.com/office/drawing/2014/main" id="{700F6875-3DC3-41B9-804D-2AE57A47AD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38600"/>
                <a:ext cx="185738" cy="1588"/>
              </a:xfrm>
              <a:prstGeom prst="rect">
                <a:avLst/>
              </a:prstGeom>
              <a:solidFill>
                <a:srgbClr val="5876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8" name="Rectangle 10">
                <a:extLst>
                  <a:ext uri="{FF2B5EF4-FFF2-40B4-BE49-F238E27FC236}">
                    <a16:creationId xmlns:a16="http://schemas.microsoft.com/office/drawing/2014/main" id="{5A3C8AEE-6A33-427D-A5D3-988AD1526A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40188"/>
                <a:ext cx="185738" cy="1588"/>
              </a:xfrm>
              <a:prstGeom prst="rect">
                <a:avLst/>
              </a:prstGeom>
              <a:solidFill>
                <a:srgbClr val="57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9" name="Rectangle 11">
                <a:extLst>
                  <a:ext uri="{FF2B5EF4-FFF2-40B4-BE49-F238E27FC236}">
                    <a16:creationId xmlns:a16="http://schemas.microsoft.com/office/drawing/2014/main" id="{C214DDCF-9222-4093-853C-61E2E3E6C2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41775"/>
                <a:ext cx="185738" cy="1588"/>
              </a:xfrm>
              <a:prstGeom prst="rect">
                <a:avLst/>
              </a:prstGeom>
              <a:solidFill>
                <a:srgbClr val="56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0" name="Rectangle 12">
                <a:extLst>
                  <a:ext uri="{FF2B5EF4-FFF2-40B4-BE49-F238E27FC236}">
                    <a16:creationId xmlns:a16="http://schemas.microsoft.com/office/drawing/2014/main" id="{88EFFD00-80EC-47E4-8730-7F3E52E30B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43363"/>
                <a:ext cx="185738" cy="3175"/>
              </a:xfrm>
              <a:prstGeom prst="rect">
                <a:avLst/>
              </a:prstGeom>
              <a:solidFill>
                <a:srgbClr val="55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1" name="Rectangle 13">
                <a:extLst>
                  <a:ext uri="{FF2B5EF4-FFF2-40B4-BE49-F238E27FC236}">
                    <a16:creationId xmlns:a16="http://schemas.microsoft.com/office/drawing/2014/main" id="{95BB97D9-08E8-4261-B8A9-3A1B6BF1B8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46538"/>
                <a:ext cx="185738" cy="1588"/>
              </a:xfrm>
              <a:prstGeom prst="rect">
                <a:avLst/>
              </a:prstGeom>
              <a:solidFill>
                <a:srgbClr val="54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2" name="Rectangle 14">
                <a:extLst>
                  <a:ext uri="{FF2B5EF4-FFF2-40B4-BE49-F238E27FC236}">
                    <a16:creationId xmlns:a16="http://schemas.microsoft.com/office/drawing/2014/main" id="{82829367-BC4D-408E-9689-06F7557336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48125"/>
                <a:ext cx="185738" cy="1588"/>
              </a:xfrm>
              <a:prstGeom prst="rect">
                <a:avLst/>
              </a:prstGeom>
              <a:solidFill>
                <a:srgbClr val="5374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3" name="Rectangle 15">
                <a:extLst>
                  <a:ext uri="{FF2B5EF4-FFF2-40B4-BE49-F238E27FC236}">
                    <a16:creationId xmlns:a16="http://schemas.microsoft.com/office/drawing/2014/main" id="{52F0983A-716D-4E0F-BFB0-F741D966B7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49713"/>
                <a:ext cx="185738" cy="3175"/>
              </a:xfrm>
              <a:prstGeom prst="rect">
                <a:avLst/>
              </a:prstGeom>
              <a:solidFill>
                <a:srgbClr val="5273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4" name="Rectangle 16">
                <a:extLst>
                  <a:ext uri="{FF2B5EF4-FFF2-40B4-BE49-F238E27FC236}">
                    <a16:creationId xmlns:a16="http://schemas.microsoft.com/office/drawing/2014/main" id="{6C65AD1D-9519-4348-9D9A-AA2E9B1675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52888"/>
                <a:ext cx="185738" cy="1588"/>
              </a:xfrm>
              <a:prstGeom prst="rect">
                <a:avLst/>
              </a:prstGeom>
              <a:solidFill>
                <a:srgbClr val="51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5" name="Rectangle 17">
                <a:extLst>
                  <a:ext uri="{FF2B5EF4-FFF2-40B4-BE49-F238E27FC236}">
                    <a16:creationId xmlns:a16="http://schemas.microsoft.com/office/drawing/2014/main" id="{CF5D00BB-F6D7-4EC3-BDB3-2E8E3ABD44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54475"/>
                <a:ext cx="185738" cy="1588"/>
              </a:xfrm>
              <a:prstGeom prst="rect">
                <a:avLst/>
              </a:prstGeom>
              <a:solidFill>
                <a:srgbClr val="50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6" name="Rectangle 18">
                <a:extLst>
                  <a:ext uri="{FF2B5EF4-FFF2-40B4-BE49-F238E27FC236}">
                    <a16:creationId xmlns:a16="http://schemas.microsoft.com/office/drawing/2014/main" id="{971FBAFD-7D39-43CB-8B58-7DE08E215C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56063"/>
                <a:ext cx="185738" cy="1588"/>
              </a:xfrm>
              <a:prstGeom prst="rect">
                <a:avLst/>
              </a:prstGeom>
              <a:solidFill>
                <a:srgbClr val="4F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7" name="Rectangle 19">
                <a:extLst>
                  <a:ext uri="{FF2B5EF4-FFF2-40B4-BE49-F238E27FC236}">
                    <a16:creationId xmlns:a16="http://schemas.microsoft.com/office/drawing/2014/main" id="{FD7E51FB-168A-44E5-94DD-C4A21A7741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57650"/>
                <a:ext cx="185738" cy="3175"/>
              </a:xfrm>
              <a:prstGeom prst="rect">
                <a:avLst/>
              </a:prstGeom>
              <a:solidFill>
                <a:srgbClr val="4E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8" name="Rectangle 20">
                <a:extLst>
                  <a:ext uri="{FF2B5EF4-FFF2-40B4-BE49-F238E27FC236}">
                    <a16:creationId xmlns:a16="http://schemas.microsoft.com/office/drawing/2014/main" id="{C0C02319-4176-445F-9655-00952AFE08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60825"/>
                <a:ext cx="185738" cy="1588"/>
              </a:xfrm>
              <a:prstGeom prst="rect">
                <a:avLst/>
              </a:prstGeom>
              <a:solidFill>
                <a:srgbClr val="4D71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9" name="Rectangle 21">
                <a:extLst>
                  <a:ext uri="{FF2B5EF4-FFF2-40B4-BE49-F238E27FC236}">
                    <a16:creationId xmlns:a16="http://schemas.microsoft.com/office/drawing/2014/main" id="{947AA698-69C8-4F08-A47D-BBE8F979B8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62413"/>
                <a:ext cx="185738" cy="1588"/>
              </a:xfrm>
              <a:prstGeom prst="rect">
                <a:avLst/>
              </a:prstGeom>
              <a:solidFill>
                <a:srgbClr val="4D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0" name="Rectangle 22">
                <a:extLst>
                  <a:ext uri="{FF2B5EF4-FFF2-40B4-BE49-F238E27FC236}">
                    <a16:creationId xmlns:a16="http://schemas.microsoft.com/office/drawing/2014/main" id="{64E836C8-1EE0-4FB3-ABC1-65E02AB093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64000"/>
                <a:ext cx="185738" cy="1588"/>
              </a:xfrm>
              <a:prstGeom prst="rect">
                <a:avLst/>
              </a:prstGeom>
              <a:solidFill>
                <a:srgbClr val="4C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1" name="Rectangle 23">
                <a:extLst>
                  <a:ext uri="{FF2B5EF4-FFF2-40B4-BE49-F238E27FC236}">
                    <a16:creationId xmlns:a16="http://schemas.microsoft.com/office/drawing/2014/main" id="{29BCE3F3-02CA-43F7-8687-32C479DE51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65588"/>
                <a:ext cx="185738" cy="1588"/>
              </a:xfrm>
              <a:prstGeom prst="rect">
                <a:avLst/>
              </a:prstGeom>
              <a:solidFill>
                <a:srgbClr val="4B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2" name="Rectangle 24">
                <a:extLst>
                  <a:ext uri="{FF2B5EF4-FFF2-40B4-BE49-F238E27FC236}">
                    <a16:creationId xmlns:a16="http://schemas.microsoft.com/office/drawing/2014/main" id="{B28A16A6-20AB-4C34-AE7C-DDCB15ACA3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67175"/>
                <a:ext cx="185738" cy="1588"/>
              </a:xfrm>
              <a:prstGeom prst="rect">
                <a:avLst/>
              </a:prstGeom>
              <a:solidFill>
                <a:srgbClr val="4A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3" name="Rectangle 25">
                <a:extLst>
                  <a:ext uri="{FF2B5EF4-FFF2-40B4-BE49-F238E27FC236}">
                    <a16:creationId xmlns:a16="http://schemas.microsoft.com/office/drawing/2014/main" id="{BB40319C-4A1F-40AC-B863-B2F5B2F21A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68763"/>
                <a:ext cx="185738" cy="1588"/>
              </a:xfrm>
              <a:prstGeom prst="rect">
                <a:avLst/>
              </a:prstGeom>
              <a:solidFill>
                <a:srgbClr val="49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4" name="Rectangle 26">
                <a:extLst>
                  <a:ext uri="{FF2B5EF4-FFF2-40B4-BE49-F238E27FC236}">
                    <a16:creationId xmlns:a16="http://schemas.microsoft.com/office/drawing/2014/main" id="{B89C4AFC-757A-4D73-92B8-C744EDDC00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70350"/>
                <a:ext cx="185738" cy="3175"/>
              </a:xfrm>
              <a:prstGeom prst="rect">
                <a:avLst/>
              </a:prstGeom>
              <a:solidFill>
                <a:srgbClr val="48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5" name="Rectangle 27">
                <a:extLst>
                  <a:ext uri="{FF2B5EF4-FFF2-40B4-BE49-F238E27FC236}">
                    <a16:creationId xmlns:a16="http://schemas.microsoft.com/office/drawing/2014/main" id="{C0808C41-192D-4B3D-B241-D8F8A49C90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73525"/>
                <a:ext cx="185738" cy="1588"/>
              </a:xfrm>
              <a:prstGeom prst="rect">
                <a:avLst/>
              </a:prstGeom>
              <a:solidFill>
                <a:srgbClr val="47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6" name="Rectangle 28">
                <a:extLst>
                  <a:ext uri="{FF2B5EF4-FFF2-40B4-BE49-F238E27FC236}">
                    <a16:creationId xmlns:a16="http://schemas.microsoft.com/office/drawing/2014/main" id="{D9403965-0932-4F17-BC65-DB3B172780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75113"/>
                <a:ext cx="185738" cy="1588"/>
              </a:xfrm>
              <a:prstGeom prst="rect">
                <a:avLst/>
              </a:prstGeom>
              <a:solidFill>
                <a:srgbClr val="46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7" name="Rectangle 29">
                <a:extLst>
                  <a:ext uri="{FF2B5EF4-FFF2-40B4-BE49-F238E27FC236}">
                    <a16:creationId xmlns:a16="http://schemas.microsoft.com/office/drawing/2014/main" id="{7E257A55-42E1-4751-AAF9-60E16174B4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76700"/>
                <a:ext cx="185738" cy="1588"/>
              </a:xfrm>
              <a:prstGeom prst="rect">
                <a:avLst/>
              </a:prstGeom>
              <a:solidFill>
                <a:srgbClr val="46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8" name="Rectangle 30">
                <a:extLst>
                  <a:ext uri="{FF2B5EF4-FFF2-40B4-BE49-F238E27FC236}">
                    <a16:creationId xmlns:a16="http://schemas.microsoft.com/office/drawing/2014/main" id="{E23BF3E4-33AF-4DE7-B6D3-EFC0CD14F5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78288"/>
                <a:ext cx="185738" cy="1588"/>
              </a:xfrm>
              <a:prstGeom prst="rect">
                <a:avLst/>
              </a:prstGeom>
              <a:solidFill>
                <a:srgbClr val="45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9" name="Rectangle 31">
                <a:extLst>
                  <a:ext uri="{FF2B5EF4-FFF2-40B4-BE49-F238E27FC236}">
                    <a16:creationId xmlns:a16="http://schemas.microsoft.com/office/drawing/2014/main" id="{E853F944-B1D5-4F6D-BBFC-8AFB1BFBC1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79875"/>
                <a:ext cx="185738" cy="1588"/>
              </a:xfrm>
              <a:prstGeom prst="rect">
                <a:avLst/>
              </a:prstGeom>
              <a:solidFill>
                <a:srgbClr val="44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0" name="Rectangle 32">
                <a:extLst>
                  <a:ext uri="{FF2B5EF4-FFF2-40B4-BE49-F238E27FC236}">
                    <a16:creationId xmlns:a16="http://schemas.microsoft.com/office/drawing/2014/main" id="{394831AC-5735-464B-89D3-848001E5CC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81463"/>
                <a:ext cx="185738" cy="4763"/>
              </a:xfrm>
              <a:prstGeom prst="rect">
                <a:avLst/>
              </a:prstGeom>
              <a:solidFill>
                <a:srgbClr val="43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1" name="Rectangle 33">
                <a:extLst>
                  <a:ext uri="{FF2B5EF4-FFF2-40B4-BE49-F238E27FC236}">
                    <a16:creationId xmlns:a16="http://schemas.microsoft.com/office/drawing/2014/main" id="{424BD910-58D0-44AB-B596-2B79B579E7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86225"/>
                <a:ext cx="185738" cy="1588"/>
              </a:xfrm>
              <a:prstGeom prst="rect">
                <a:avLst/>
              </a:prstGeom>
              <a:solidFill>
                <a:srgbClr val="42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2" name="Rectangle 34">
                <a:extLst>
                  <a:ext uri="{FF2B5EF4-FFF2-40B4-BE49-F238E27FC236}">
                    <a16:creationId xmlns:a16="http://schemas.microsoft.com/office/drawing/2014/main" id="{ED526BC1-25FE-4F8E-9E20-9EC2469430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87813"/>
                <a:ext cx="185738" cy="1588"/>
              </a:xfrm>
              <a:prstGeom prst="rect">
                <a:avLst/>
              </a:prstGeom>
              <a:solidFill>
                <a:srgbClr val="41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3" name="Rectangle 35">
                <a:extLst>
                  <a:ext uri="{FF2B5EF4-FFF2-40B4-BE49-F238E27FC236}">
                    <a16:creationId xmlns:a16="http://schemas.microsoft.com/office/drawing/2014/main" id="{B483A580-EBAD-452D-81DC-1A0AE953FF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89400"/>
                <a:ext cx="185738" cy="1588"/>
              </a:xfrm>
              <a:prstGeom prst="rect">
                <a:avLst/>
              </a:prstGeom>
              <a:solidFill>
                <a:srgbClr val="40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4" name="Rectangle 36">
                <a:extLst>
                  <a:ext uri="{FF2B5EF4-FFF2-40B4-BE49-F238E27FC236}">
                    <a16:creationId xmlns:a16="http://schemas.microsoft.com/office/drawing/2014/main" id="{17C9F49C-05A7-4F82-AAA5-CA4E1D8A58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90988"/>
                <a:ext cx="185738" cy="1588"/>
              </a:xfrm>
              <a:prstGeom prst="rect">
                <a:avLst/>
              </a:prstGeom>
              <a:solidFill>
                <a:srgbClr val="3F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5" name="Rectangle 37">
                <a:extLst>
                  <a:ext uri="{FF2B5EF4-FFF2-40B4-BE49-F238E27FC236}">
                    <a16:creationId xmlns:a16="http://schemas.microsoft.com/office/drawing/2014/main" id="{163BBB52-952A-4C06-9E13-213AFBA91F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92575"/>
                <a:ext cx="185738" cy="1588"/>
              </a:xfrm>
              <a:prstGeom prst="rect">
                <a:avLst/>
              </a:prstGeom>
              <a:solidFill>
                <a:srgbClr val="3E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6" name="Rectangle 38">
                <a:extLst>
                  <a:ext uri="{FF2B5EF4-FFF2-40B4-BE49-F238E27FC236}">
                    <a16:creationId xmlns:a16="http://schemas.microsoft.com/office/drawing/2014/main" id="{7EED6DF3-BADC-40C7-97F4-0C7C9A2BB2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94163"/>
                <a:ext cx="185738" cy="1588"/>
              </a:xfrm>
              <a:prstGeom prst="rect">
                <a:avLst/>
              </a:prstGeom>
              <a:solidFill>
                <a:srgbClr val="3D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7" name="Rectangle 39">
                <a:extLst>
                  <a:ext uri="{FF2B5EF4-FFF2-40B4-BE49-F238E27FC236}">
                    <a16:creationId xmlns:a16="http://schemas.microsoft.com/office/drawing/2014/main" id="{90E78790-E504-4C57-A193-FB9E83C124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095750"/>
                <a:ext cx="185738" cy="4763"/>
              </a:xfrm>
              <a:prstGeom prst="rect">
                <a:avLst/>
              </a:prstGeom>
              <a:solidFill>
                <a:srgbClr val="3C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8" name="Rectangle 40">
                <a:extLst>
                  <a:ext uri="{FF2B5EF4-FFF2-40B4-BE49-F238E27FC236}">
                    <a16:creationId xmlns:a16="http://schemas.microsoft.com/office/drawing/2014/main" id="{2065ADF8-DDEF-48A7-88D0-26AA680BE2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00513"/>
                <a:ext cx="185738" cy="1588"/>
              </a:xfrm>
              <a:prstGeom prst="rect">
                <a:avLst/>
              </a:prstGeom>
              <a:solidFill>
                <a:srgbClr val="3B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9" name="Rectangle 41">
                <a:extLst>
                  <a:ext uri="{FF2B5EF4-FFF2-40B4-BE49-F238E27FC236}">
                    <a16:creationId xmlns:a16="http://schemas.microsoft.com/office/drawing/2014/main" id="{CA9F050F-4B4A-466E-BFBD-0E1430A4DE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02100"/>
                <a:ext cx="185738" cy="1588"/>
              </a:xfrm>
              <a:prstGeom prst="rect">
                <a:avLst/>
              </a:prstGeom>
              <a:solidFill>
                <a:srgbClr val="3A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0" name="Rectangle 42">
                <a:extLst>
                  <a:ext uri="{FF2B5EF4-FFF2-40B4-BE49-F238E27FC236}">
                    <a16:creationId xmlns:a16="http://schemas.microsoft.com/office/drawing/2014/main" id="{2D9BB354-9DCA-45D8-9613-7AD934E26D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03688"/>
                <a:ext cx="185738" cy="1588"/>
              </a:xfrm>
              <a:prstGeom prst="rect">
                <a:avLst/>
              </a:prstGeom>
              <a:solidFill>
                <a:srgbClr val="39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1" name="Rectangle 43">
                <a:extLst>
                  <a:ext uri="{FF2B5EF4-FFF2-40B4-BE49-F238E27FC236}">
                    <a16:creationId xmlns:a16="http://schemas.microsoft.com/office/drawing/2014/main" id="{6B2270AF-1B40-4D71-B580-26EC511EBF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05275"/>
                <a:ext cx="185738" cy="1588"/>
              </a:xfrm>
              <a:prstGeom prst="rect">
                <a:avLst/>
              </a:prstGeom>
              <a:solidFill>
                <a:srgbClr val="38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2" name="Rectangle 44">
                <a:extLst>
                  <a:ext uri="{FF2B5EF4-FFF2-40B4-BE49-F238E27FC236}">
                    <a16:creationId xmlns:a16="http://schemas.microsoft.com/office/drawing/2014/main" id="{5F070B1F-33DD-454D-A199-1069B7B57C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06863"/>
                <a:ext cx="185738" cy="1588"/>
              </a:xfrm>
              <a:prstGeom prst="rect">
                <a:avLst/>
              </a:prstGeom>
              <a:solidFill>
                <a:srgbClr val="37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3" name="Rectangle 45">
                <a:extLst>
                  <a:ext uri="{FF2B5EF4-FFF2-40B4-BE49-F238E27FC236}">
                    <a16:creationId xmlns:a16="http://schemas.microsoft.com/office/drawing/2014/main" id="{6A1E8803-F66B-41BE-A211-0E6D0D246A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08450"/>
                <a:ext cx="185738" cy="1588"/>
              </a:xfrm>
              <a:prstGeom prst="rect">
                <a:avLst/>
              </a:prstGeom>
              <a:solidFill>
                <a:srgbClr val="36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4" name="Rectangle 46">
                <a:extLst>
                  <a:ext uri="{FF2B5EF4-FFF2-40B4-BE49-F238E27FC236}">
                    <a16:creationId xmlns:a16="http://schemas.microsoft.com/office/drawing/2014/main" id="{2CE97F51-EA4B-4CC3-B984-3002A8CEDC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10038"/>
                <a:ext cx="185738" cy="4763"/>
              </a:xfrm>
              <a:prstGeom prst="rect">
                <a:avLst/>
              </a:prstGeom>
              <a:solidFill>
                <a:srgbClr val="3563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5" name="Rectangle 47">
                <a:extLst>
                  <a:ext uri="{FF2B5EF4-FFF2-40B4-BE49-F238E27FC236}">
                    <a16:creationId xmlns:a16="http://schemas.microsoft.com/office/drawing/2014/main" id="{9597B1E9-2B5B-4BAF-935B-C47EBEDC3B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14800"/>
                <a:ext cx="185738" cy="3175"/>
              </a:xfrm>
              <a:prstGeom prst="rect">
                <a:avLst/>
              </a:prstGeom>
              <a:solidFill>
                <a:srgbClr val="35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6" name="Rectangle 48">
                <a:extLst>
                  <a:ext uri="{FF2B5EF4-FFF2-40B4-BE49-F238E27FC236}">
                    <a16:creationId xmlns:a16="http://schemas.microsoft.com/office/drawing/2014/main" id="{78C61A02-630C-4AAF-8300-6DB42F2B10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17975"/>
                <a:ext cx="185738" cy="1588"/>
              </a:xfrm>
              <a:prstGeom prst="rect">
                <a:avLst/>
              </a:prstGeom>
              <a:solidFill>
                <a:srgbClr val="34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7" name="Rectangle 49">
                <a:extLst>
                  <a:ext uri="{FF2B5EF4-FFF2-40B4-BE49-F238E27FC236}">
                    <a16:creationId xmlns:a16="http://schemas.microsoft.com/office/drawing/2014/main" id="{99B7CAA7-FEFF-4E44-8247-392B00FA8C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19563"/>
                <a:ext cx="185738" cy="4763"/>
              </a:xfrm>
              <a:prstGeom prst="rect">
                <a:avLst/>
              </a:prstGeom>
              <a:solidFill>
                <a:srgbClr val="3461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8" name="Rectangle 50">
                <a:extLst>
                  <a:ext uri="{FF2B5EF4-FFF2-40B4-BE49-F238E27FC236}">
                    <a16:creationId xmlns:a16="http://schemas.microsoft.com/office/drawing/2014/main" id="{D8045FA0-2E06-425A-A341-2DCB2A9F06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24325"/>
                <a:ext cx="185738" cy="3175"/>
              </a:xfrm>
              <a:prstGeom prst="rect">
                <a:avLst/>
              </a:prstGeom>
              <a:solidFill>
                <a:srgbClr val="3361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9" name="Rectangle 51">
                <a:extLst>
                  <a:ext uri="{FF2B5EF4-FFF2-40B4-BE49-F238E27FC236}">
                    <a16:creationId xmlns:a16="http://schemas.microsoft.com/office/drawing/2014/main" id="{1F1FCBAD-6504-4336-8C1D-A208C67A9A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27500"/>
                <a:ext cx="185738" cy="1588"/>
              </a:xfrm>
              <a:prstGeom prst="rect">
                <a:avLst/>
              </a:prstGeom>
              <a:solidFill>
                <a:srgbClr val="3360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0" name="Rectangle 52">
                <a:extLst>
                  <a:ext uri="{FF2B5EF4-FFF2-40B4-BE49-F238E27FC236}">
                    <a16:creationId xmlns:a16="http://schemas.microsoft.com/office/drawing/2014/main" id="{25ACE77C-064E-4C43-8BBE-A7BE379B3E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29088"/>
                <a:ext cx="185738" cy="4763"/>
              </a:xfrm>
              <a:prstGeom prst="rect">
                <a:avLst/>
              </a:prstGeom>
              <a:solidFill>
                <a:srgbClr val="3260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1" name="Rectangle 53">
                <a:extLst>
                  <a:ext uri="{FF2B5EF4-FFF2-40B4-BE49-F238E27FC236}">
                    <a16:creationId xmlns:a16="http://schemas.microsoft.com/office/drawing/2014/main" id="{A068DC75-B54A-428D-8CF5-3E273DF9D4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33850"/>
                <a:ext cx="185738" cy="1588"/>
              </a:xfrm>
              <a:prstGeom prst="rect">
                <a:avLst/>
              </a:prstGeom>
              <a:solidFill>
                <a:srgbClr val="32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2" name="Rectangle 54">
                <a:extLst>
                  <a:ext uri="{FF2B5EF4-FFF2-40B4-BE49-F238E27FC236}">
                    <a16:creationId xmlns:a16="http://schemas.microsoft.com/office/drawing/2014/main" id="{16DF7DB8-6404-4551-B113-48EED2D723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35438"/>
                <a:ext cx="185738" cy="4763"/>
              </a:xfrm>
              <a:prstGeom prst="rect">
                <a:avLst/>
              </a:prstGeom>
              <a:solidFill>
                <a:srgbClr val="31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3" name="Rectangle 55">
                <a:extLst>
                  <a:ext uri="{FF2B5EF4-FFF2-40B4-BE49-F238E27FC236}">
                    <a16:creationId xmlns:a16="http://schemas.microsoft.com/office/drawing/2014/main" id="{8CAFD228-AF6F-488D-8E82-54A52B494B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40200"/>
                <a:ext cx="185738" cy="3175"/>
              </a:xfrm>
              <a:prstGeom prst="rect">
                <a:avLst/>
              </a:prstGeom>
              <a:solidFill>
                <a:srgbClr val="315E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4" name="Rectangle 56">
                <a:extLst>
                  <a:ext uri="{FF2B5EF4-FFF2-40B4-BE49-F238E27FC236}">
                    <a16:creationId xmlns:a16="http://schemas.microsoft.com/office/drawing/2014/main" id="{148FE7EB-18EC-4371-8DC4-5E7B6782CE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43375"/>
                <a:ext cx="185738" cy="3175"/>
              </a:xfrm>
              <a:prstGeom prst="rect">
                <a:avLst/>
              </a:prstGeom>
              <a:solidFill>
                <a:srgbClr val="305D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5" name="Rectangle 57">
                <a:extLst>
                  <a:ext uri="{FF2B5EF4-FFF2-40B4-BE49-F238E27FC236}">
                    <a16:creationId xmlns:a16="http://schemas.microsoft.com/office/drawing/2014/main" id="{27AC875A-926A-4233-8895-A6F45FB89C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46550"/>
                <a:ext cx="185738" cy="1588"/>
              </a:xfrm>
              <a:prstGeom prst="rect">
                <a:avLst/>
              </a:prstGeom>
              <a:solidFill>
                <a:srgbClr val="305D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6" name="Rectangle 58">
                <a:extLst>
                  <a:ext uri="{FF2B5EF4-FFF2-40B4-BE49-F238E27FC236}">
                    <a16:creationId xmlns:a16="http://schemas.microsoft.com/office/drawing/2014/main" id="{0D6F9C83-6892-4256-A81B-3A90905C05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48138"/>
                <a:ext cx="185738" cy="6350"/>
              </a:xfrm>
              <a:prstGeom prst="rect">
                <a:avLst/>
              </a:prstGeom>
              <a:solidFill>
                <a:srgbClr val="2F5C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7" name="Rectangle 59">
                <a:extLst>
                  <a:ext uri="{FF2B5EF4-FFF2-40B4-BE49-F238E27FC236}">
                    <a16:creationId xmlns:a16="http://schemas.microsoft.com/office/drawing/2014/main" id="{74B1D053-DA3F-460E-8517-3118C65845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54488"/>
                <a:ext cx="185738" cy="1588"/>
              </a:xfrm>
              <a:prstGeom prst="rect">
                <a:avLst/>
              </a:prstGeom>
              <a:solidFill>
                <a:srgbClr val="2F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8" name="Rectangle 60">
                <a:extLst>
                  <a:ext uri="{FF2B5EF4-FFF2-40B4-BE49-F238E27FC236}">
                    <a16:creationId xmlns:a16="http://schemas.microsoft.com/office/drawing/2014/main" id="{1080FBE0-2E24-41FC-8763-3BB69FB3D9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56075"/>
                <a:ext cx="185738" cy="1588"/>
              </a:xfrm>
              <a:prstGeom prst="rect">
                <a:avLst/>
              </a:prstGeom>
              <a:solidFill>
                <a:srgbClr val="2E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9" name="Rectangle 61">
                <a:extLst>
                  <a:ext uri="{FF2B5EF4-FFF2-40B4-BE49-F238E27FC236}">
                    <a16:creationId xmlns:a16="http://schemas.microsoft.com/office/drawing/2014/main" id="{D7437EBA-8E98-4931-8B77-78A943F138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57663"/>
                <a:ext cx="185738" cy="4763"/>
              </a:xfrm>
              <a:prstGeom prst="rect">
                <a:avLst/>
              </a:prstGeom>
              <a:solidFill>
                <a:srgbClr val="2E5A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0" name="Rectangle 62">
                <a:extLst>
                  <a:ext uri="{FF2B5EF4-FFF2-40B4-BE49-F238E27FC236}">
                    <a16:creationId xmlns:a16="http://schemas.microsoft.com/office/drawing/2014/main" id="{CF8ADB8D-D537-40A8-BC11-95223B0C5A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62425"/>
                <a:ext cx="185738" cy="1588"/>
              </a:xfrm>
              <a:prstGeom prst="rect">
                <a:avLst/>
              </a:prstGeom>
              <a:solidFill>
                <a:srgbClr val="2D5A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1" name="Rectangle 63">
                <a:extLst>
                  <a:ext uri="{FF2B5EF4-FFF2-40B4-BE49-F238E27FC236}">
                    <a16:creationId xmlns:a16="http://schemas.microsoft.com/office/drawing/2014/main" id="{1D63731E-3C97-4D93-96CD-4129FCE2D3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64013"/>
                <a:ext cx="185738" cy="4763"/>
              </a:xfrm>
              <a:prstGeom prst="rect">
                <a:avLst/>
              </a:prstGeom>
              <a:solidFill>
                <a:srgbClr val="2D59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2" name="Rectangle 64">
                <a:extLst>
                  <a:ext uri="{FF2B5EF4-FFF2-40B4-BE49-F238E27FC236}">
                    <a16:creationId xmlns:a16="http://schemas.microsoft.com/office/drawing/2014/main" id="{F7281939-BCA4-4FA6-9BFB-2DBE5733B9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68775"/>
                <a:ext cx="185738" cy="3175"/>
              </a:xfrm>
              <a:prstGeom prst="rect">
                <a:avLst/>
              </a:prstGeom>
              <a:solidFill>
                <a:srgbClr val="2C59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3" name="Rectangle 65">
                <a:extLst>
                  <a:ext uri="{FF2B5EF4-FFF2-40B4-BE49-F238E27FC236}">
                    <a16:creationId xmlns:a16="http://schemas.microsoft.com/office/drawing/2014/main" id="{B38623CC-3764-456E-9FD8-96BC6915C5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71950"/>
                <a:ext cx="185738" cy="3175"/>
              </a:xfrm>
              <a:prstGeom prst="rect">
                <a:avLst/>
              </a:prstGeom>
              <a:solidFill>
                <a:srgbClr val="2C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4" name="Rectangle 66">
                <a:extLst>
                  <a:ext uri="{FF2B5EF4-FFF2-40B4-BE49-F238E27FC236}">
                    <a16:creationId xmlns:a16="http://schemas.microsoft.com/office/drawing/2014/main" id="{B878A9E6-3074-44B0-9077-BE1C6DD921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75125"/>
                <a:ext cx="185738" cy="1588"/>
              </a:xfrm>
              <a:prstGeom prst="rect">
                <a:avLst/>
              </a:prstGeom>
              <a:solidFill>
                <a:srgbClr val="2B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5" name="Rectangle 67">
                <a:extLst>
                  <a:ext uri="{FF2B5EF4-FFF2-40B4-BE49-F238E27FC236}">
                    <a16:creationId xmlns:a16="http://schemas.microsoft.com/office/drawing/2014/main" id="{D03EE294-FF0B-43CC-9A62-F1A1DB7C5B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76713"/>
                <a:ext cx="185738" cy="6350"/>
              </a:xfrm>
              <a:prstGeom prst="rect">
                <a:avLst/>
              </a:prstGeom>
              <a:solidFill>
                <a:srgbClr val="2B57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6" name="Rectangle 68">
                <a:extLst>
                  <a:ext uri="{FF2B5EF4-FFF2-40B4-BE49-F238E27FC236}">
                    <a16:creationId xmlns:a16="http://schemas.microsoft.com/office/drawing/2014/main" id="{93730567-9EF3-41E8-B47D-CB0754B487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83063"/>
                <a:ext cx="185738" cy="3175"/>
              </a:xfrm>
              <a:prstGeom prst="rect">
                <a:avLst/>
              </a:prstGeom>
              <a:solidFill>
                <a:srgbClr val="2A56A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7" name="Rectangle 69">
                <a:extLst>
                  <a:ext uri="{FF2B5EF4-FFF2-40B4-BE49-F238E27FC236}">
                    <a16:creationId xmlns:a16="http://schemas.microsoft.com/office/drawing/2014/main" id="{D943827A-4111-4B45-A6E9-182BD57434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4186238"/>
                <a:ext cx="185738" cy="1588"/>
              </a:xfrm>
              <a:prstGeom prst="rect">
                <a:avLst/>
              </a:prstGeom>
              <a:solidFill>
                <a:srgbClr val="2955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8" name="Rectangle 70">
                <a:extLst>
                  <a:ext uri="{FF2B5EF4-FFF2-40B4-BE49-F238E27FC236}">
                    <a16:creationId xmlns:a16="http://schemas.microsoft.com/office/drawing/2014/main" id="{0CA3C3A7-2EDE-4C75-BAC2-E2AEBB9F46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73463"/>
                <a:ext cx="371475" cy="3175"/>
              </a:xfrm>
              <a:prstGeom prst="rect">
                <a:avLst/>
              </a:prstGeom>
              <a:solidFill>
                <a:srgbClr val="59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9" name="Rectangle 71">
                <a:extLst>
                  <a:ext uri="{FF2B5EF4-FFF2-40B4-BE49-F238E27FC236}">
                    <a16:creationId xmlns:a16="http://schemas.microsoft.com/office/drawing/2014/main" id="{C205FD73-860C-42EB-83FE-23177DDB60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76638"/>
                <a:ext cx="371475" cy="1588"/>
              </a:xfrm>
              <a:prstGeom prst="rect">
                <a:avLst/>
              </a:prstGeom>
              <a:solidFill>
                <a:srgbClr val="58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0" name="Rectangle 72">
                <a:extLst>
                  <a:ext uri="{FF2B5EF4-FFF2-40B4-BE49-F238E27FC236}">
                    <a16:creationId xmlns:a16="http://schemas.microsoft.com/office/drawing/2014/main" id="{8F6059BA-14E4-4F9F-8DE1-FF4F07689F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78225"/>
                <a:ext cx="371475" cy="1588"/>
              </a:xfrm>
              <a:prstGeom prst="rect">
                <a:avLst/>
              </a:prstGeom>
              <a:solidFill>
                <a:srgbClr val="5876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1" name="Rectangle 73">
                <a:extLst>
                  <a:ext uri="{FF2B5EF4-FFF2-40B4-BE49-F238E27FC236}">
                    <a16:creationId xmlns:a16="http://schemas.microsoft.com/office/drawing/2014/main" id="{2D5B3407-CAE8-4200-9FFC-11F902060D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79813"/>
                <a:ext cx="371475" cy="1588"/>
              </a:xfrm>
              <a:prstGeom prst="rect">
                <a:avLst/>
              </a:prstGeom>
              <a:solidFill>
                <a:srgbClr val="57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2" name="Rectangle 74">
                <a:extLst>
                  <a:ext uri="{FF2B5EF4-FFF2-40B4-BE49-F238E27FC236}">
                    <a16:creationId xmlns:a16="http://schemas.microsoft.com/office/drawing/2014/main" id="{00DD51EF-D94E-4B5D-92CF-65264B7BB0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81400"/>
                <a:ext cx="371475" cy="1588"/>
              </a:xfrm>
              <a:prstGeom prst="rect">
                <a:avLst/>
              </a:prstGeom>
              <a:solidFill>
                <a:srgbClr val="56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3" name="Rectangle 75">
                <a:extLst>
                  <a:ext uri="{FF2B5EF4-FFF2-40B4-BE49-F238E27FC236}">
                    <a16:creationId xmlns:a16="http://schemas.microsoft.com/office/drawing/2014/main" id="{F7EE2C92-80A0-4B8E-8EBD-568A1B154E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82988"/>
                <a:ext cx="371475" cy="1588"/>
              </a:xfrm>
              <a:prstGeom prst="rect">
                <a:avLst/>
              </a:prstGeom>
              <a:solidFill>
                <a:srgbClr val="55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4" name="Rectangle 76">
                <a:extLst>
                  <a:ext uri="{FF2B5EF4-FFF2-40B4-BE49-F238E27FC236}">
                    <a16:creationId xmlns:a16="http://schemas.microsoft.com/office/drawing/2014/main" id="{D42EAF18-80F1-45C6-902A-F0F5B3053B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84575"/>
                <a:ext cx="371475" cy="1588"/>
              </a:xfrm>
              <a:prstGeom prst="rect">
                <a:avLst/>
              </a:prstGeom>
              <a:solidFill>
                <a:srgbClr val="54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5" name="Rectangle 77">
                <a:extLst>
                  <a:ext uri="{FF2B5EF4-FFF2-40B4-BE49-F238E27FC236}">
                    <a16:creationId xmlns:a16="http://schemas.microsoft.com/office/drawing/2014/main" id="{60EAF92E-6C46-434B-89D6-B274AA70E7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86163"/>
                <a:ext cx="371475" cy="3175"/>
              </a:xfrm>
              <a:prstGeom prst="rect">
                <a:avLst/>
              </a:prstGeom>
              <a:solidFill>
                <a:srgbClr val="5374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6" name="Rectangle 78">
                <a:extLst>
                  <a:ext uri="{FF2B5EF4-FFF2-40B4-BE49-F238E27FC236}">
                    <a16:creationId xmlns:a16="http://schemas.microsoft.com/office/drawing/2014/main" id="{0A91720A-8778-460D-904C-4AC04C3BED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89338"/>
                <a:ext cx="371475" cy="3175"/>
              </a:xfrm>
              <a:prstGeom prst="rect">
                <a:avLst/>
              </a:prstGeom>
              <a:solidFill>
                <a:srgbClr val="5273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7" name="Rectangle 79">
                <a:extLst>
                  <a:ext uri="{FF2B5EF4-FFF2-40B4-BE49-F238E27FC236}">
                    <a16:creationId xmlns:a16="http://schemas.microsoft.com/office/drawing/2014/main" id="{12F2F6F8-3360-4B7E-A33C-F5D8BAE808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92513"/>
                <a:ext cx="371475" cy="1588"/>
              </a:xfrm>
              <a:prstGeom prst="rect">
                <a:avLst/>
              </a:prstGeom>
              <a:solidFill>
                <a:srgbClr val="51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8" name="Rectangle 80">
                <a:extLst>
                  <a:ext uri="{FF2B5EF4-FFF2-40B4-BE49-F238E27FC236}">
                    <a16:creationId xmlns:a16="http://schemas.microsoft.com/office/drawing/2014/main" id="{A1A6E354-FBC8-4179-8A3D-22FB3784CF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94100"/>
                <a:ext cx="371475" cy="1588"/>
              </a:xfrm>
              <a:prstGeom prst="rect">
                <a:avLst/>
              </a:prstGeom>
              <a:solidFill>
                <a:srgbClr val="50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9" name="Rectangle 81">
                <a:extLst>
                  <a:ext uri="{FF2B5EF4-FFF2-40B4-BE49-F238E27FC236}">
                    <a16:creationId xmlns:a16="http://schemas.microsoft.com/office/drawing/2014/main" id="{F981D519-9C51-4368-9BD3-ECA2129878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95688"/>
                <a:ext cx="371475" cy="1588"/>
              </a:xfrm>
              <a:prstGeom prst="rect">
                <a:avLst/>
              </a:prstGeom>
              <a:solidFill>
                <a:srgbClr val="4F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0" name="Rectangle 82">
                <a:extLst>
                  <a:ext uri="{FF2B5EF4-FFF2-40B4-BE49-F238E27FC236}">
                    <a16:creationId xmlns:a16="http://schemas.microsoft.com/office/drawing/2014/main" id="{653D7784-05F9-49FB-A1A5-2328BEE56E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97275"/>
                <a:ext cx="371475" cy="1588"/>
              </a:xfrm>
              <a:prstGeom prst="rect">
                <a:avLst/>
              </a:prstGeom>
              <a:solidFill>
                <a:srgbClr val="4E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1" name="Rectangle 83">
                <a:extLst>
                  <a:ext uri="{FF2B5EF4-FFF2-40B4-BE49-F238E27FC236}">
                    <a16:creationId xmlns:a16="http://schemas.microsoft.com/office/drawing/2014/main" id="{9D6CF076-844B-441F-B6FC-0A046BCD2A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598863"/>
                <a:ext cx="371475" cy="1588"/>
              </a:xfrm>
              <a:prstGeom prst="rect">
                <a:avLst/>
              </a:prstGeom>
              <a:solidFill>
                <a:srgbClr val="4D71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2" name="Rectangle 84">
                <a:extLst>
                  <a:ext uri="{FF2B5EF4-FFF2-40B4-BE49-F238E27FC236}">
                    <a16:creationId xmlns:a16="http://schemas.microsoft.com/office/drawing/2014/main" id="{B09FBCBE-D981-41BD-9CE6-B28E844C65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00450"/>
                <a:ext cx="371475" cy="3175"/>
              </a:xfrm>
              <a:prstGeom prst="rect">
                <a:avLst/>
              </a:prstGeom>
              <a:solidFill>
                <a:srgbClr val="4D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3" name="Rectangle 85">
                <a:extLst>
                  <a:ext uri="{FF2B5EF4-FFF2-40B4-BE49-F238E27FC236}">
                    <a16:creationId xmlns:a16="http://schemas.microsoft.com/office/drawing/2014/main" id="{7133D0E8-00AB-4465-BBB9-6B3BC8F944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03625"/>
                <a:ext cx="371475" cy="1588"/>
              </a:xfrm>
              <a:prstGeom prst="rect">
                <a:avLst/>
              </a:prstGeom>
              <a:solidFill>
                <a:srgbClr val="4C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4" name="Rectangle 86">
                <a:extLst>
                  <a:ext uri="{FF2B5EF4-FFF2-40B4-BE49-F238E27FC236}">
                    <a16:creationId xmlns:a16="http://schemas.microsoft.com/office/drawing/2014/main" id="{9FFF578C-AC76-4F43-B70A-FB7EBA315F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05213"/>
                <a:ext cx="371475" cy="1588"/>
              </a:xfrm>
              <a:prstGeom prst="rect">
                <a:avLst/>
              </a:prstGeom>
              <a:solidFill>
                <a:srgbClr val="4B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5" name="Rectangle 87">
                <a:extLst>
                  <a:ext uri="{FF2B5EF4-FFF2-40B4-BE49-F238E27FC236}">
                    <a16:creationId xmlns:a16="http://schemas.microsoft.com/office/drawing/2014/main" id="{FD9A5FEA-D352-4185-B9E8-EA275478EA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06800"/>
                <a:ext cx="371475" cy="1588"/>
              </a:xfrm>
              <a:prstGeom prst="rect">
                <a:avLst/>
              </a:prstGeom>
              <a:solidFill>
                <a:srgbClr val="4A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6" name="Rectangle 88">
                <a:extLst>
                  <a:ext uri="{FF2B5EF4-FFF2-40B4-BE49-F238E27FC236}">
                    <a16:creationId xmlns:a16="http://schemas.microsoft.com/office/drawing/2014/main" id="{253299C4-654E-4896-8337-2DAAD51F0E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08388"/>
                <a:ext cx="371475" cy="1588"/>
              </a:xfrm>
              <a:prstGeom prst="rect">
                <a:avLst/>
              </a:prstGeom>
              <a:solidFill>
                <a:srgbClr val="49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7" name="Rectangle 89">
                <a:extLst>
                  <a:ext uri="{FF2B5EF4-FFF2-40B4-BE49-F238E27FC236}">
                    <a16:creationId xmlns:a16="http://schemas.microsoft.com/office/drawing/2014/main" id="{2A564B9E-67CE-4F47-BAEB-B732E4F9E6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09975"/>
                <a:ext cx="371475" cy="1588"/>
              </a:xfrm>
              <a:prstGeom prst="rect">
                <a:avLst/>
              </a:prstGeom>
              <a:solidFill>
                <a:srgbClr val="48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8" name="Rectangle 90">
                <a:extLst>
                  <a:ext uri="{FF2B5EF4-FFF2-40B4-BE49-F238E27FC236}">
                    <a16:creationId xmlns:a16="http://schemas.microsoft.com/office/drawing/2014/main" id="{34289FA8-F22E-4E47-A05A-5F546A1830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11563"/>
                <a:ext cx="371475" cy="1588"/>
              </a:xfrm>
              <a:prstGeom prst="rect">
                <a:avLst/>
              </a:prstGeom>
              <a:solidFill>
                <a:srgbClr val="47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9" name="Rectangle 91">
                <a:extLst>
                  <a:ext uri="{FF2B5EF4-FFF2-40B4-BE49-F238E27FC236}">
                    <a16:creationId xmlns:a16="http://schemas.microsoft.com/office/drawing/2014/main" id="{C2F21264-DAA0-44A5-8479-B3D8D8C572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13150"/>
                <a:ext cx="371475" cy="3175"/>
              </a:xfrm>
              <a:prstGeom prst="rect">
                <a:avLst/>
              </a:prstGeom>
              <a:solidFill>
                <a:srgbClr val="46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0" name="Rectangle 92">
                <a:extLst>
                  <a:ext uri="{FF2B5EF4-FFF2-40B4-BE49-F238E27FC236}">
                    <a16:creationId xmlns:a16="http://schemas.microsoft.com/office/drawing/2014/main" id="{6A65FA9C-31E2-4FA3-9E76-6254FAC3D9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16325"/>
                <a:ext cx="371475" cy="1588"/>
              </a:xfrm>
              <a:prstGeom prst="rect">
                <a:avLst/>
              </a:prstGeom>
              <a:solidFill>
                <a:srgbClr val="46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1" name="Rectangle 93">
                <a:extLst>
                  <a:ext uri="{FF2B5EF4-FFF2-40B4-BE49-F238E27FC236}">
                    <a16:creationId xmlns:a16="http://schemas.microsoft.com/office/drawing/2014/main" id="{1CA46532-06BE-44A3-8DF8-97563A3F1B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17913"/>
                <a:ext cx="371475" cy="1588"/>
              </a:xfrm>
              <a:prstGeom prst="rect">
                <a:avLst/>
              </a:prstGeom>
              <a:solidFill>
                <a:srgbClr val="45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2" name="Rectangle 94">
                <a:extLst>
                  <a:ext uri="{FF2B5EF4-FFF2-40B4-BE49-F238E27FC236}">
                    <a16:creationId xmlns:a16="http://schemas.microsoft.com/office/drawing/2014/main" id="{80D92E75-485A-4E36-8F70-5547161CB9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19500"/>
                <a:ext cx="371475" cy="1588"/>
              </a:xfrm>
              <a:prstGeom prst="rect">
                <a:avLst/>
              </a:prstGeom>
              <a:solidFill>
                <a:srgbClr val="44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3" name="Rectangle 95">
                <a:extLst>
                  <a:ext uri="{FF2B5EF4-FFF2-40B4-BE49-F238E27FC236}">
                    <a16:creationId xmlns:a16="http://schemas.microsoft.com/office/drawing/2014/main" id="{50327DE9-4C11-4BA1-91F3-B1D63390A8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21088"/>
                <a:ext cx="371475" cy="3175"/>
              </a:xfrm>
              <a:prstGeom prst="rect">
                <a:avLst/>
              </a:prstGeom>
              <a:solidFill>
                <a:srgbClr val="43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4" name="Rectangle 96">
                <a:extLst>
                  <a:ext uri="{FF2B5EF4-FFF2-40B4-BE49-F238E27FC236}">
                    <a16:creationId xmlns:a16="http://schemas.microsoft.com/office/drawing/2014/main" id="{D80A99AD-DBA6-49AE-AC64-9FA6F36641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24263"/>
                <a:ext cx="371475" cy="1588"/>
              </a:xfrm>
              <a:prstGeom prst="rect">
                <a:avLst/>
              </a:prstGeom>
              <a:solidFill>
                <a:srgbClr val="42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5" name="Rectangle 97">
                <a:extLst>
                  <a:ext uri="{FF2B5EF4-FFF2-40B4-BE49-F238E27FC236}">
                    <a16:creationId xmlns:a16="http://schemas.microsoft.com/office/drawing/2014/main" id="{33182C81-D5D8-4DAA-8279-66BBE71707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25850"/>
                <a:ext cx="371475" cy="1588"/>
              </a:xfrm>
              <a:prstGeom prst="rect">
                <a:avLst/>
              </a:prstGeom>
              <a:solidFill>
                <a:srgbClr val="41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6" name="Rectangle 98">
                <a:extLst>
                  <a:ext uri="{FF2B5EF4-FFF2-40B4-BE49-F238E27FC236}">
                    <a16:creationId xmlns:a16="http://schemas.microsoft.com/office/drawing/2014/main" id="{51C9F539-08F8-4BE9-B381-27675406B5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27438"/>
                <a:ext cx="371475" cy="3175"/>
              </a:xfrm>
              <a:prstGeom prst="rect">
                <a:avLst/>
              </a:prstGeom>
              <a:solidFill>
                <a:srgbClr val="40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7" name="Rectangle 99">
                <a:extLst>
                  <a:ext uri="{FF2B5EF4-FFF2-40B4-BE49-F238E27FC236}">
                    <a16:creationId xmlns:a16="http://schemas.microsoft.com/office/drawing/2014/main" id="{9C81E197-CB00-4CA2-AF22-A07794E80A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30613"/>
                <a:ext cx="371475" cy="1588"/>
              </a:xfrm>
              <a:prstGeom prst="rect">
                <a:avLst/>
              </a:prstGeom>
              <a:solidFill>
                <a:srgbClr val="3F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8" name="Rectangle 100">
                <a:extLst>
                  <a:ext uri="{FF2B5EF4-FFF2-40B4-BE49-F238E27FC236}">
                    <a16:creationId xmlns:a16="http://schemas.microsoft.com/office/drawing/2014/main" id="{A23689B0-7D31-4785-8706-0265AB03A8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32200"/>
                <a:ext cx="371475" cy="1588"/>
              </a:xfrm>
              <a:prstGeom prst="rect">
                <a:avLst/>
              </a:prstGeom>
              <a:solidFill>
                <a:srgbClr val="3E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9" name="Rectangle 101">
                <a:extLst>
                  <a:ext uri="{FF2B5EF4-FFF2-40B4-BE49-F238E27FC236}">
                    <a16:creationId xmlns:a16="http://schemas.microsoft.com/office/drawing/2014/main" id="{16A05CCF-722B-436B-A026-308411EA4C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33788"/>
                <a:ext cx="371475" cy="1588"/>
              </a:xfrm>
              <a:prstGeom prst="rect">
                <a:avLst/>
              </a:prstGeom>
              <a:solidFill>
                <a:srgbClr val="3D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0" name="Rectangle 102">
                <a:extLst>
                  <a:ext uri="{FF2B5EF4-FFF2-40B4-BE49-F238E27FC236}">
                    <a16:creationId xmlns:a16="http://schemas.microsoft.com/office/drawing/2014/main" id="{AD3463FF-C62B-4F8C-B4F2-094362074A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35375"/>
                <a:ext cx="371475" cy="3175"/>
              </a:xfrm>
              <a:prstGeom prst="rect">
                <a:avLst/>
              </a:prstGeom>
              <a:solidFill>
                <a:srgbClr val="3C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1" name="Rectangle 103">
                <a:extLst>
                  <a:ext uri="{FF2B5EF4-FFF2-40B4-BE49-F238E27FC236}">
                    <a16:creationId xmlns:a16="http://schemas.microsoft.com/office/drawing/2014/main" id="{1F7374A3-DE7A-4E60-8B9A-8A8398CA56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38550"/>
                <a:ext cx="371475" cy="1588"/>
              </a:xfrm>
              <a:prstGeom prst="rect">
                <a:avLst/>
              </a:prstGeom>
              <a:solidFill>
                <a:srgbClr val="3B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2" name="Rectangle 104">
                <a:extLst>
                  <a:ext uri="{FF2B5EF4-FFF2-40B4-BE49-F238E27FC236}">
                    <a16:creationId xmlns:a16="http://schemas.microsoft.com/office/drawing/2014/main" id="{D2105A87-08B3-4B3C-AF9F-92873B1A4C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40138"/>
                <a:ext cx="371475" cy="3175"/>
              </a:xfrm>
              <a:prstGeom prst="rect">
                <a:avLst/>
              </a:prstGeom>
              <a:solidFill>
                <a:srgbClr val="3A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3" name="Rectangle 105">
                <a:extLst>
                  <a:ext uri="{FF2B5EF4-FFF2-40B4-BE49-F238E27FC236}">
                    <a16:creationId xmlns:a16="http://schemas.microsoft.com/office/drawing/2014/main" id="{E089F3F1-8703-4301-84E3-B2B189DEB0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43313"/>
                <a:ext cx="371475" cy="1588"/>
              </a:xfrm>
              <a:prstGeom prst="rect">
                <a:avLst/>
              </a:prstGeom>
              <a:solidFill>
                <a:srgbClr val="39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4" name="Rectangle 106">
                <a:extLst>
                  <a:ext uri="{FF2B5EF4-FFF2-40B4-BE49-F238E27FC236}">
                    <a16:creationId xmlns:a16="http://schemas.microsoft.com/office/drawing/2014/main" id="{D6F3D8C0-22BD-42B1-901D-95AABE7C76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44900"/>
                <a:ext cx="371475" cy="1588"/>
              </a:xfrm>
              <a:prstGeom prst="rect">
                <a:avLst/>
              </a:prstGeom>
              <a:solidFill>
                <a:srgbClr val="38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5" name="Rectangle 107">
                <a:extLst>
                  <a:ext uri="{FF2B5EF4-FFF2-40B4-BE49-F238E27FC236}">
                    <a16:creationId xmlns:a16="http://schemas.microsoft.com/office/drawing/2014/main" id="{14ACC663-C6F9-4FBE-B172-675AB0FD5B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46488"/>
                <a:ext cx="371475" cy="1588"/>
              </a:xfrm>
              <a:prstGeom prst="rect">
                <a:avLst/>
              </a:prstGeom>
              <a:solidFill>
                <a:srgbClr val="37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6" name="Rectangle 108">
                <a:extLst>
                  <a:ext uri="{FF2B5EF4-FFF2-40B4-BE49-F238E27FC236}">
                    <a16:creationId xmlns:a16="http://schemas.microsoft.com/office/drawing/2014/main" id="{6757F9CA-E54A-4DC6-AC29-8568EA06AE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48075"/>
                <a:ext cx="371475" cy="1588"/>
              </a:xfrm>
              <a:prstGeom prst="rect">
                <a:avLst/>
              </a:prstGeom>
              <a:solidFill>
                <a:srgbClr val="36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7" name="Rectangle 109">
                <a:extLst>
                  <a:ext uri="{FF2B5EF4-FFF2-40B4-BE49-F238E27FC236}">
                    <a16:creationId xmlns:a16="http://schemas.microsoft.com/office/drawing/2014/main" id="{C9B1D445-97D9-41D7-A27D-E4905E464D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49663"/>
                <a:ext cx="371475" cy="3175"/>
              </a:xfrm>
              <a:prstGeom prst="rect">
                <a:avLst/>
              </a:prstGeom>
              <a:solidFill>
                <a:srgbClr val="3563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8" name="Rectangle 110">
                <a:extLst>
                  <a:ext uri="{FF2B5EF4-FFF2-40B4-BE49-F238E27FC236}">
                    <a16:creationId xmlns:a16="http://schemas.microsoft.com/office/drawing/2014/main" id="{B3567ECC-3EED-41D4-B2FB-3A47251C49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52838"/>
                <a:ext cx="371475" cy="4763"/>
              </a:xfrm>
              <a:prstGeom prst="rect">
                <a:avLst/>
              </a:prstGeom>
              <a:solidFill>
                <a:srgbClr val="35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9" name="Rectangle 111">
                <a:extLst>
                  <a:ext uri="{FF2B5EF4-FFF2-40B4-BE49-F238E27FC236}">
                    <a16:creationId xmlns:a16="http://schemas.microsoft.com/office/drawing/2014/main" id="{C93CCB89-1BCE-4695-BDEE-9BC17FA950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57600"/>
                <a:ext cx="371475" cy="1588"/>
              </a:xfrm>
              <a:prstGeom prst="rect">
                <a:avLst/>
              </a:prstGeom>
              <a:solidFill>
                <a:srgbClr val="34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Rectangle 112">
                <a:extLst>
                  <a:ext uri="{FF2B5EF4-FFF2-40B4-BE49-F238E27FC236}">
                    <a16:creationId xmlns:a16="http://schemas.microsoft.com/office/drawing/2014/main" id="{B78D3635-A402-45A0-BF8B-2715B0293F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59188"/>
                <a:ext cx="371475" cy="4763"/>
              </a:xfrm>
              <a:prstGeom prst="rect">
                <a:avLst/>
              </a:prstGeom>
              <a:solidFill>
                <a:srgbClr val="3461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1" name="Rectangle 113">
                <a:extLst>
                  <a:ext uri="{FF2B5EF4-FFF2-40B4-BE49-F238E27FC236}">
                    <a16:creationId xmlns:a16="http://schemas.microsoft.com/office/drawing/2014/main" id="{E9F61B32-C8F4-4CF8-ABB4-011BC88B01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63950"/>
                <a:ext cx="371475" cy="1588"/>
              </a:xfrm>
              <a:prstGeom prst="rect">
                <a:avLst/>
              </a:prstGeom>
              <a:solidFill>
                <a:srgbClr val="3361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Rectangle 114">
                <a:extLst>
                  <a:ext uri="{FF2B5EF4-FFF2-40B4-BE49-F238E27FC236}">
                    <a16:creationId xmlns:a16="http://schemas.microsoft.com/office/drawing/2014/main" id="{913D9AAB-9BD3-408F-951E-01A56513FD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65538"/>
                <a:ext cx="371475" cy="1588"/>
              </a:xfrm>
              <a:prstGeom prst="rect">
                <a:avLst/>
              </a:prstGeom>
              <a:solidFill>
                <a:srgbClr val="3360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3" name="Rectangle 115">
                <a:extLst>
                  <a:ext uri="{FF2B5EF4-FFF2-40B4-BE49-F238E27FC236}">
                    <a16:creationId xmlns:a16="http://schemas.microsoft.com/office/drawing/2014/main" id="{E2145F21-775F-4072-B3C2-BA5F688466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67125"/>
                <a:ext cx="371475" cy="6350"/>
              </a:xfrm>
              <a:prstGeom prst="rect">
                <a:avLst/>
              </a:prstGeom>
              <a:solidFill>
                <a:srgbClr val="3260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4" name="Rectangle 116">
                <a:extLst>
                  <a:ext uri="{FF2B5EF4-FFF2-40B4-BE49-F238E27FC236}">
                    <a16:creationId xmlns:a16="http://schemas.microsoft.com/office/drawing/2014/main" id="{6815E7B9-B544-41B7-BBD2-630C1033AD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73475"/>
                <a:ext cx="371475" cy="1588"/>
              </a:xfrm>
              <a:prstGeom prst="rect">
                <a:avLst/>
              </a:prstGeom>
              <a:solidFill>
                <a:srgbClr val="32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5" name="Rectangle 117">
                <a:extLst>
                  <a:ext uri="{FF2B5EF4-FFF2-40B4-BE49-F238E27FC236}">
                    <a16:creationId xmlns:a16="http://schemas.microsoft.com/office/drawing/2014/main" id="{5CFBC454-A404-4F16-98FE-BF635AE6DD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75063"/>
                <a:ext cx="371475" cy="3175"/>
              </a:xfrm>
              <a:prstGeom prst="rect">
                <a:avLst/>
              </a:prstGeom>
              <a:solidFill>
                <a:srgbClr val="31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6" name="Rectangle 118">
                <a:extLst>
                  <a:ext uri="{FF2B5EF4-FFF2-40B4-BE49-F238E27FC236}">
                    <a16:creationId xmlns:a16="http://schemas.microsoft.com/office/drawing/2014/main" id="{5BD72A2A-9BD1-4D5B-ACBE-5E4408A21D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78238"/>
                <a:ext cx="371475" cy="3175"/>
              </a:xfrm>
              <a:prstGeom prst="rect">
                <a:avLst/>
              </a:prstGeom>
              <a:solidFill>
                <a:srgbClr val="315E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7" name="Rectangle 119">
                <a:extLst>
                  <a:ext uri="{FF2B5EF4-FFF2-40B4-BE49-F238E27FC236}">
                    <a16:creationId xmlns:a16="http://schemas.microsoft.com/office/drawing/2014/main" id="{F087ADD8-6977-44DB-B438-E85D9D21DB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81413"/>
                <a:ext cx="371475" cy="4763"/>
              </a:xfrm>
              <a:prstGeom prst="rect">
                <a:avLst/>
              </a:prstGeom>
              <a:solidFill>
                <a:srgbClr val="305D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8" name="Rectangle 120">
                <a:extLst>
                  <a:ext uri="{FF2B5EF4-FFF2-40B4-BE49-F238E27FC236}">
                    <a16:creationId xmlns:a16="http://schemas.microsoft.com/office/drawing/2014/main" id="{A4383EC5-313F-46F2-84E0-D15163F445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86175"/>
                <a:ext cx="371475" cy="1588"/>
              </a:xfrm>
              <a:prstGeom prst="rect">
                <a:avLst/>
              </a:prstGeom>
              <a:solidFill>
                <a:srgbClr val="305D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9" name="Rectangle 121">
                <a:extLst>
                  <a:ext uri="{FF2B5EF4-FFF2-40B4-BE49-F238E27FC236}">
                    <a16:creationId xmlns:a16="http://schemas.microsoft.com/office/drawing/2014/main" id="{E997DBAA-9A90-4807-A0B7-74814D982F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87763"/>
                <a:ext cx="371475" cy="4763"/>
              </a:xfrm>
              <a:prstGeom prst="rect">
                <a:avLst/>
              </a:prstGeom>
              <a:solidFill>
                <a:srgbClr val="2F5C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0" name="Rectangle 122">
                <a:extLst>
                  <a:ext uri="{FF2B5EF4-FFF2-40B4-BE49-F238E27FC236}">
                    <a16:creationId xmlns:a16="http://schemas.microsoft.com/office/drawing/2014/main" id="{57C3C8E0-E7D4-4997-A2F9-A9D96FEC95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92525"/>
                <a:ext cx="371475" cy="1588"/>
              </a:xfrm>
              <a:prstGeom prst="rect">
                <a:avLst/>
              </a:prstGeom>
              <a:solidFill>
                <a:srgbClr val="2F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1" name="Rectangle 123">
                <a:extLst>
                  <a:ext uri="{FF2B5EF4-FFF2-40B4-BE49-F238E27FC236}">
                    <a16:creationId xmlns:a16="http://schemas.microsoft.com/office/drawing/2014/main" id="{EE0DFAEC-6F2C-4F1F-9CEF-55A46523DF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94113"/>
                <a:ext cx="371475" cy="3175"/>
              </a:xfrm>
              <a:prstGeom prst="rect">
                <a:avLst/>
              </a:prstGeom>
              <a:solidFill>
                <a:srgbClr val="2E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2" name="Rectangle 124">
                <a:extLst>
                  <a:ext uri="{FF2B5EF4-FFF2-40B4-BE49-F238E27FC236}">
                    <a16:creationId xmlns:a16="http://schemas.microsoft.com/office/drawing/2014/main" id="{770FF8FB-E625-459C-95A6-2308D461B6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697288"/>
                <a:ext cx="371475" cy="4763"/>
              </a:xfrm>
              <a:prstGeom prst="rect">
                <a:avLst/>
              </a:prstGeom>
              <a:solidFill>
                <a:srgbClr val="2E5A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3" name="Rectangle 125">
                <a:extLst>
                  <a:ext uri="{FF2B5EF4-FFF2-40B4-BE49-F238E27FC236}">
                    <a16:creationId xmlns:a16="http://schemas.microsoft.com/office/drawing/2014/main" id="{0427BB87-EA55-43FB-AA88-0967EAE779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02050"/>
                <a:ext cx="371475" cy="1588"/>
              </a:xfrm>
              <a:prstGeom prst="rect">
                <a:avLst/>
              </a:prstGeom>
              <a:solidFill>
                <a:srgbClr val="2D5A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4" name="Rectangle 126">
                <a:extLst>
                  <a:ext uri="{FF2B5EF4-FFF2-40B4-BE49-F238E27FC236}">
                    <a16:creationId xmlns:a16="http://schemas.microsoft.com/office/drawing/2014/main" id="{283B9714-7AC3-4127-9AE1-3A10CF9210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03638"/>
                <a:ext cx="371475" cy="3175"/>
              </a:xfrm>
              <a:prstGeom prst="rect">
                <a:avLst/>
              </a:prstGeom>
              <a:solidFill>
                <a:srgbClr val="2D59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5" name="Rectangle 127">
                <a:extLst>
                  <a:ext uri="{FF2B5EF4-FFF2-40B4-BE49-F238E27FC236}">
                    <a16:creationId xmlns:a16="http://schemas.microsoft.com/office/drawing/2014/main" id="{2E3C7583-5126-4511-B397-92F028FD0C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06813"/>
                <a:ext cx="371475" cy="4763"/>
              </a:xfrm>
              <a:prstGeom prst="rect">
                <a:avLst/>
              </a:prstGeom>
              <a:solidFill>
                <a:srgbClr val="2C59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6" name="Rectangle 128">
                <a:extLst>
                  <a:ext uri="{FF2B5EF4-FFF2-40B4-BE49-F238E27FC236}">
                    <a16:creationId xmlns:a16="http://schemas.microsoft.com/office/drawing/2014/main" id="{AF09351C-A7ED-4DE5-B2FA-646800EC51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11575"/>
                <a:ext cx="371475" cy="3175"/>
              </a:xfrm>
              <a:prstGeom prst="rect">
                <a:avLst/>
              </a:prstGeom>
              <a:solidFill>
                <a:srgbClr val="2C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7" name="Rectangle 129">
                <a:extLst>
                  <a:ext uri="{FF2B5EF4-FFF2-40B4-BE49-F238E27FC236}">
                    <a16:creationId xmlns:a16="http://schemas.microsoft.com/office/drawing/2014/main" id="{38EC75C7-399D-4229-B577-8120BE8548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14750"/>
                <a:ext cx="371475" cy="1588"/>
              </a:xfrm>
              <a:prstGeom prst="rect">
                <a:avLst/>
              </a:prstGeom>
              <a:solidFill>
                <a:srgbClr val="2B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Rectangle 130">
                <a:extLst>
                  <a:ext uri="{FF2B5EF4-FFF2-40B4-BE49-F238E27FC236}">
                    <a16:creationId xmlns:a16="http://schemas.microsoft.com/office/drawing/2014/main" id="{62E1AEFB-E7D6-4160-B03E-3D803D9A77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16338"/>
                <a:ext cx="371475" cy="4763"/>
              </a:xfrm>
              <a:prstGeom prst="rect">
                <a:avLst/>
              </a:prstGeom>
              <a:solidFill>
                <a:srgbClr val="2B57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9" name="Rectangle 131">
                <a:extLst>
                  <a:ext uri="{FF2B5EF4-FFF2-40B4-BE49-F238E27FC236}">
                    <a16:creationId xmlns:a16="http://schemas.microsoft.com/office/drawing/2014/main" id="{2BCFD598-0F47-4681-839E-CC84BD3B47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21100"/>
                <a:ext cx="371475" cy="4763"/>
              </a:xfrm>
              <a:prstGeom prst="rect">
                <a:avLst/>
              </a:prstGeom>
              <a:solidFill>
                <a:srgbClr val="2A56A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0" name="Rectangle 132">
                <a:extLst>
                  <a:ext uri="{FF2B5EF4-FFF2-40B4-BE49-F238E27FC236}">
                    <a16:creationId xmlns:a16="http://schemas.microsoft.com/office/drawing/2014/main" id="{C935C7DE-3040-430A-A471-4557F187EC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725863"/>
                <a:ext cx="371475" cy="1588"/>
              </a:xfrm>
              <a:prstGeom prst="rect">
                <a:avLst/>
              </a:prstGeom>
              <a:solidFill>
                <a:srgbClr val="2955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1" name="Rectangle 133">
                <a:extLst>
                  <a:ext uri="{FF2B5EF4-FFF2-40B4-BE49-F238E27FC236}">
                    <a16:creationId xmlns:a16="http://schemas.microsoft.com/office/drawing/2014/main" id="{A714FED1-1480-4A38-9666-F9FEE879C4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13088"/>
                <a:ext cx="742950" cy="1588"/>
              </a:xfrm>
              <a:prstGeom prst="rect">
                <a:avLst/>
              </a:prstGeom>
              <a:solidFill>
                <a:srgbClr val="59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2" name="Rectangle 134">
                <a:extLst>
                  <a:ext uri="{FF2B5EF4-FFF2-40B4-BE49-F238E27FC236}">
                    <a16:creationId xmlns:a16="http://schemas.microsoft.com/office/drawing/2014/main" id="{B34C69AF-B1FC-432D-AFCE-A5B7748C90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14675"/>
                <a:ext cx="742950" cy="1588"/>
              </a:xfrm>
              <a:prstGeom prst="rect">
                <a:avLst/>
              </a:prstGeom>
              <a:solidFill>
                <a:srgbClr val="58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3" name="Rectangle 135">
                <a:extLst>
                  <a:ext uri="{FF2B5EF4-FFF2-40B4-BE49-F238E27FC236}">
                    <a16:creationId xmlns:a16="http://schemas.microsoft.com/office/drawing/2014/main" id="{ABE76CCA-EF62-4868-BC1A-B3B967B199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16263"/>
                <a:ext cx="742950" cy="3175"/>
              </a:xfrm>
              <a:prstGeom prst="rect">
                <a:avLst/>
              </a:prstGeom>
              <a:solidFill>
                <a:srgbClr val="5876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4" name="Rectangle 136">
                <a:extLst>
                  <a:ext uri="{FF2B5EF4-FFF2-40B4-BE49-F238E27FC236}">
                    <a16:creationId xmlns:a16="http://schemas.microsoft.com/office/drawing/2014/main" id="{D0A445DC-B985-4001-AACE-45398684FB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19438"/>
                <a:ext cx="742950" cy="1588"/>
              </a:xfrm>
              <a:prstGeom prst="rect">
                <a:avLst/>
              </a:prstGeom>
              <a:solidFill>
                <a:srgbClr val="57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5" name="Rectangle 137">
                <a:extLst>
                  <a:ext uri="{FF2B5EF4-FFF2-40B4-BE49-F238E27FC236}">
                    <a16:creationId xmlns:a16="http://schemas.microsoft.com/office/drawing/2014/main" id="{C7C9789F-7596-4B67-AB48-FFEE647DBD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21025"/>
                <a:ext cx="742950" cy="1588"/>
              </a:xfrm>
              <a:prstGeom prst="rect">
                <a:avLst/>
              </a:prstGeom>
              <a:solidFill>
                <a:srgbClr val="56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6" name="Rectangle 138">
                <a:extLst>
                  <a:ext uri="{FF2B5EF4-FFF2-40B4-BE49-F238E27FC236}">
                    <a16:creationId xmlns:a16="http://schemas.microsoft.com/office/drawing/2014/main" id="{B777569E-8032-483E-B0FE-52AEACD570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22613"/>
                <a:ext cx="742950" cy="1588"/>
              </a:xfrm>
              <a:prstGeom prst="rect">
                <a:avLst/>
              </a:prstGeom>
              <a:solidFill>
                <a:srgbClr val="55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7" name="Rectangle 139">
                <a:extLst>
                  <a:ext uri="{FF2B5EF4-FFF2-40B4-BE49-F238E27FC236}">
                    <a16:creationId xmlns:a16="http://schemas.microsoft.com/office/drawing/2014/main" id="{3E97723B-367E-407C-9955-ABB0D4938F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24200"/>
                <a:ext cx="742950" cy="1588"/>
              </a:xfrm>
              <a:prstGeom prst="rect">
                <a:avLst/>
              </a:prstGeom>
              <a:solidFill>
                <a:srgbClr val="54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8" name="Rectangle 140">
                <a:extLst>
                  <a:ext uri="{FF2B5EF4-FFF2-40B4-BE49-F238E27FC236}">
                    <a16:creationId xmlns:a16="http://schemas.microsoft.com/office/drawing/2014/main" id="{38F44815-35C1-4D25-B44B-5763D2CE10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25788"/>
                <a:ext cx="742950" cy="1588"/>
              </a:xfrm>
              <a:prstGeom prst="rect">
                <a:avLst/>
              </a:prstGeom>
              <a:solidFill>
                <a:srgbClr val="5374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9" name="Rectangle 141">
                <a:extLst>
                  <a:ext uri="{FF2B5EF4-FFF2-40B4-BE49-F238E27FC236}">
                    <a16:creationId xmlns:a16="http://schemas.microsoft.com/office/drawing/2014/main" id="{0681CFD2-5B09-4871-A899-5543CEA620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27375"/>
                <a:ext cx="742950" cy="4763"/>
              </a:xfrm>
              <a:prstGeom prst="rect">
                <a:avLst/>
              </a:prstGeom>
              <a:solidFill>
                <a:srgbClr val="5273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0" name="Rectangle 142">
                <a:extLst>
                  <a:ext uri="{FF2B5EF4-FFF2-40B4-BE49-F238E27FC236}">
                    <a16:creationId xmlns:a16="http://schemas.microsoft.com/office/drawing/2014/main" id="{CD6773DC-67EA-487D-B011-2C0D717E1B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32138"/>
                <a:ext cx="742950" cy="1588"/>
              </a:xfrm>
              <a:prstGeom prst="rect">
                <a:avLst/>
              </a:prstGeom>
              <a:solidFill>
                <a:srgbClr val="51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1" name="Rectangle 143">
                <a:extLst>
                  <a:ext uri="{FF2B5EF4-FFF2-40B4-BE49-F238E27FC236}">
                    <a16:creationId xmlns:a16="http://schemas.microsoft.com/office/drawing/2014/main" id="{8A77A4B0-55CD-4746-B044-7625A740B9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33725"/>
                <a:ext cx="742950" cy="1588"/>
              </a:xfrm>
              <a:prstGeom prst="rect">
                <a:avLst/>
              </a:prstGeom>
              <a:solidFill>
                <a:srgbClr val="50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2" name="Rectangle 144">
                <a:extLst>
                  <a:ext uri="{FF2B5EF4-FFF2-40B4-BE49-F238E27FC236}">
                    <a16:creationId xmlns:a16="http://schemas.microsoft.com/office/drawing/2014/main" id="{BDD3BEB5-04C6-4545-9D87-A83A1ADC6E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35313"/>
                <a:ext cx="742950" cy="1588"/>
              </a:xfrm>
              <a:prstGeom prst="rect">
                <a:avLst/>
              </a:prstGeom>
              <a:solidFill>
                <a:srgbClr val="4F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3" name="Rectangle 145">
                <a:extLst>
                  <a:ext uri="{FF2B5EF4-FFF2-40B4-BE49-F238E27FC236}">
                    <a16:creationId xmlns:a16="http://schemas.microsoft.com/office/drawing/2014/main" id="{3C439608-2439-4BAB-9E53-EFF00743EC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36900"/>
                <a:ext cx="742950" cy="1588"/>
              </a:xfrm>
              <a:prstGeom prst="rect">
                <a:avLst/>
              </a:prstGeom>
              <a:solidFill>
                <a:srgbClr val="4E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4" name="Rectangle 146">
                <a:extLst>
                  <a:ext uri="{FF2B5EF4-FFF2-40B4-BE49-F238E27FC236}">
                    <a16:creationId xmlns:a16="http://schemas.microsoft.com/office/drawing/2014/main" id="{27F8ED99-6E84-421C-A5AC-4E0BA2A4E1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38488"/>
                <a:ext cx="742950" cy="1588"/>
              </a:xfrm>
              <a:prstGeom prst="rect">
                <a:avLst/>
              </a:prstGeom>
              <a:solidFill>
                <a:srgbClr val="4D71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5" name="Rectangle 147">
                <a:extLst>
                  <a:ext uri="{FF2B5EF4-FFF2-40B4-BE49-F238E27FC236}">
                    <a16:creationId xmlns:a16="http://schemas.microsoft.com/office/drawing/2014/main" id="{FD3B5A92-BDC0-4C13-9678-22F26CFA55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40075"/>
                <a:ext cx="742950" cy="1588"/>
              </a:xfrm>
              <a:prstGeom prst="rect">
                <a:avLst/>
              </a:prstGeom>
              <a:solidFill>
                <a:srgbClr val="4D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6" name="Rectangle 148">
                <a:extLst>
                  <a:ext uri="{FF2B5EF4-FFF2-40B4-BE49-F238E27FC236}">
                    <a16:creationId xmlns:a16="http://schemas.microsoft.com/office/drawing/2014/main" id="{01856ACA-CB39-4E6B-9A63-CD8AEE42F8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41663"/>
                <a:ext cx="742950" cy="1588"/>
              </a:xfrm>
              <a:prstGeom prst="rect">
                <a:avLst/>
              </a:prstGeom>
              <a:solidFill>
                <a:srgbClr val="4C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7" name="Rectangle 149">
                <a:extLst>
                  <a:ext uri="{FF2B5EF4-FFF2-40B4-BE49-F238E27FC236}">
                    <a16:creationId xmlns:a16="http://schemas.microsoft.com/office/drawing/2014/main" id="{10C0F034-A7E5-40C8-B33E-3AD2E38EE0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43250"/>
                <a:ext cx="742950" cy="3175"/>
              </a:xfrm>
              <a:prstGeom prst="rect">
                <a:avLst/>
              </a:prstGeom>
              <a:solidFill>
                <a:srgbClr val="4B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8" name="Rectangle 150">
                <a:extLst>
                  <a:ext uri="{FF2B5EF4-FFF2-40B4-BE49-F238E27FC236}">
                    <a16:creationId xmlns:a16="http://schemas.microsoft.com/office/drawing/2014/main" id="{7EBD01D8-350A-4D10-B154-C6C03D039C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46425"/>
                <a:ext cx="742950" cy="1588"/>
              </a:xfrm>
              <a:prstGeom prst="rect">
                <a:avLst/>
              </a:prstGeom>
              <a:solidFill>
                <a:srgbClr val="4A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9" name="Rectangle 151">
                <a:extLst>
                  <a:ext uri="{FF2B5EF4-FFF2-40B4-BE49-F238E27FC236}">
                    <a16:creationId xmlns:a16="http://schemas.microsoft.com/office/drawing/2014/main" id="{8C30539A-8031-4A1E-B9C3-B06F23683E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48013"/>
                <a:ext cx="742950" cy="1588"/>
              </a:xfrm>
              <a:prstGeom prst="rect">
                <a:avLst/>
              </a:prstGeom>
              <a:solidFill>
                <a:srgbClr val="49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0" name="Rectangle 152">
                <a:extLst>
                  <a:ext uri="{FF2B5EF4-FFF2-40B4-BE49-F238E27FC236}">
                    <a16:creationId xmlns:a16="http://schemas.microsoft.com/office/drawing/2014/main" id="{9F840320-383C-4B75-B1CA-694C911FBE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49600"/>
                <a:ext cx="742950" cy="1588"/>
              </a:xfrm>
              <a:prstGeom prst="rect">
                <a:avLst/>
              </a:prstGeom>
              <a:solidFill>
                <a:srgbClr val="48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1" name="Rectangle 153">
                <a:extLst>
                  <a:ext uri="{FF2B5EF4-FFF2-40B4-BE49-F238E27FC236}">
                    <a16:creationId xmlns:a16="http://schemas.microsoft.com/office/drawing/2014/main" id="{3C0BAA04-4FD1-48CC-9DA1-1BBEF6D85E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51188"/>
                <a:ext cx="742950" cy="1588"/>
              </a:xfrm>
              <a:prstGeom prst="rect">
                <a:avLst/>
              </a:prstGeom>
              <a:solidFill>
                <a:srgbClr val="47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2" name="Rectangle 154">
                <a:extLst>
                  <a:ext uri="{FF2B5EF4-FFF2-40B4-BE49-F238E27FC236}">
                    <a16:creationId xmlns:a16="http://schemas.microsoft.com/office/drawing/2014/main" id="{C566F25D-A319-4D17-B8F8-B3DF39AE66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52775"/>
                <a:ext cx="742950" cy="1588"/>
              </a:xfrm>
              <a:prstGeom prst="rect">
                <a:avLst/>
              </a:prstGeom>
              <a:solidFill>
                <a:srgbClr val="46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3" name="Rectangle 155">
                <a:extLst>
                  <a:ext uri="{FF2B5EF4-FFF2-40B4-BE49-F238E27FC236}">
                    <a16:creationId xmlns:a16="http://schemas.microsoft.com/office/drawing/2014/main" id="{11E06D11-CB07-4C5A-BF5A-5AD2A641FB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54363"/>
                <a:ext cx="742950" cy="1588"/>
              </a:xfrm>
              <a:prstGeom prst="rect">
                <a:avLst/>
              </a:prstGeom>
              <a:solidFill>
                <a:srgbClr val="46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4" name="Rectangle 156">
                <a:extLst>
                  <a:ext uri="{FF2B5EF4-FFF2-40B4-BE49-F238E27FC236}">
                    <a16:creationId xmlns:a16="http://schemas.microsoft.com/office/drawing/2014/main" id="{D58E67B1-CB8E-4D99-AE9E-494B8596E9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55950"/>
                <a:ext cx="742950" cy="3175"/>
              </a:xfrm>
              <a:prstGeom prst="rect">
                <a:avLst/>
              </a:prstGeom>
              <a:solidFill>
                <a:srgbClr val="45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5" name="Rectangle 157">
                <a:extLst>
                  <a:ext uri="{FF2B5EF4-FFF2-40B4-BE49-F238E27FC236}">
                    <a16:creationId xmlns:a16="http://schemas.microsoft.com/office/drawing/2014/main" id="{77448867-8440-4B08-9E8B-0B5935EE21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59125"/>
                <a:ext cx="742950" cy="1588"/>
              </a:xfrm>
              <a:prstGeom prst="rect">
                <a:avLst/>
              </a:prstGeom>
              <a:solidFill>
                <a:srgbClr val="44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6" name="Rectangle 158">
                <a:extLst>
                  <a:ext uri="{FF2B5EF4-FFF2-40B4-BE49-F238E27FC236}">
                    <a16:creationId xmlns:a16="http://schemas.microsoft.com/office/drawing/2014/main" id="{37DA87A4-9164-417D-AC85-D1FE1A26A6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60713"/>
                <a:ext cx="742950" cy="3175"/>
              </a:xfrm>
              <a:prstGeom prst="rect">
                <a:avLst/>
              </a:prstGeom>
              <a:solidFill>
                <a:srgbClr val="43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7" name="Rectangle 159">
                <a:extLst>
                  <a:ext uri="{FF2B5EF4-FFF2-40B4-BE49-F238E27FC236}">
                    <a16:creationId xmlns:a16="http://schemas.microsoft.com/office/drawing/2014/main" id="{FC121C48-98AD-4EA7-AC65-2366A31750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63888"/>
                <a:ext cx="742950" cy="1588"/>
              </a:xfrm>
              <a:prstGeom prst="rect">
                <a:avLst/>
              </a:prstGeom>
              <a:solidFill>
                <a:srgbClr val="42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8" name="Rectangle 160">
                <a:extLst>
                  <a:ext uri="{FF2B5EF4-FFF2-40B4-BE49-F238E27FC236}">
                    <a16:creationId xmlns:a16="http://schemas.microsoft.com/office/drawing/2014/main" id="{3ABB27D2-69DF-43C5-A3DA-20233309BE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65475"/>
                <a:ext cx="742950" cy="1588"/>
              </a:xfrm>
              <a:prstGeom prst="rect">
                <a:avLst/>
              </a:prstGeom>
              <a:solidFill>
                <a:srgbClr val="41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9" name="Rectangle 161">
                <a:extLst>
                  <a:ext uri="{FF2B5EF4-FFF2-40B4-BE49-F238E27FC236}">
                    <a16:creationId xmlns:a16="http://schemas.microsoft.com/office/drawing/2014/main" id="{65FE7DEF-6D88-477C-97C8-5519236612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67063"/>
                <a:ext cx="742950" cy="1588"/>
              </a:xfrm>
              <a:prstGeom prst="rect">
                <a:avLst/>
              </a:prstGeom>
              <a:solidFill>
                <a:srgbClr val="40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0" name="Rectangle 162">
                <a:extLst>
                  <a:ext uri="{FF2B5EF4-FFF2-40B4-BE49-F238E27FC236}">
                    <a16:creationId xmlns:a16="http://schemas.microsoft.com/office/drawing/2014/main" id="{C4E36A2B-5D78-4F18-A4C1-4D3AAA13B9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68650"/>
                <a:ext cx="742950" cy="1588"/>
              </a:xfrm>
              <a:prstGeom prst="rect">
                <a:avLst/>
              </a:prstGeom>
              <a:solidFill>
                <a:srgbClr val="3F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1" name="Rectangle 163">
                <a:extLst>
                  <a:ext uri="{FF2B5EF4-FFF2-40B4-BE49-F238E27FC236}">
                    <a16:creationId xmlns:a16="http://schemas.microsoft.com/office/drawing/2014/main" id="{EC6E67F7-BA78-4C7E-9EAC-99D7B3CBCF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70238"/>
                <a:ext cx="742950" cy="3175"/>
              </a:xfrm>
              <a:prstGeom prst="rect">
                <a:avLst/>
              </a:prstGeom>
              <a:solidFill>
                <a:srgbClr val="3E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2" name="Rectangle 164">
                <a:extLst>
                  <a:ext uri="{FF2B5EF4-FFF2-40B4-BE49-F238E27FC236}">
                    <a16:creationId xmlns:a16="http://schemas.microsoft.com/office/drawing/2014/main" id="{0D7B387B-98C7-475D-9189-3D08785847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73413"/>
                <a:ext cx="742950" cy="1588"/>
              </a:xfrm>
              <a:prstGeom prst="rect">
                <a:avLst/>
              </a:prstGeom>
              <a:solidFill>
                <a:srgbClr val="3D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3" name="Rectangle 165">
                <a:extLst>
                  <a:ext uri="{FF2B5EF4-FFF2-40B4-BE49-F238E27FC236}">
                    <a16:creationId xmlns:a16="http://schemas.microsoft.com/office/drawing/2014/main" id="{F52EB797-1E2D-4973-B198-DBDE3A855A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75000"/>
                <a:ext cx="742950" cy="3175"/>
              </a:xfrm>
              <a:prstGeom prst="rect">
                <a:avLst/>
              </a:prstGeom>
              <a:solidFill>
                <a:srgbClr val="3C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4" name="Rectangle 166">
                <a:extLst>
                  <a:ext uri="{FF2B5EF4-FFF2-40B4-BE49-F238E27FC236}">
                    <a16:creationId xmlns:a16="http://schemas.microsoft.com/office/drawing/2014/main" id="{A9F1C1AD-8264-41C3-A622-A90484C907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78175"/>
                <a:ext cx="742950" cy="1588"/>
              </a:xfrm>
              <a:prstGeom prst="rect">
                <a:avLst/>
              </a:prstGeom>
              <a:solidFill>
                <a:srgbClr val="3B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5" name="Rectangle 167">
                <a:extLst>
                  <a:ext uri="{FF2B5EF4-FFF2-40B4-BE49-F238E27FC236}">
                    <a16:creationId xmlns:a16="http://schemas.microsoft.com/office/drawing/2014/main" id="{9AB511D5-2825-4444-BED7-0E76924142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79763"/>
                <a:ext cx="742950" cy="1588"/>
              </a:xfrm>
              <a:prstGeom prst="rect">
                <a:avLst/>
              </a:prstGeom>
              <a:solidFill>
                <a:srgbClr val="3A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6" name="Rectangle 168">
                <a:extLst>
                  <a:ext uri="{FF2B5EF4-FFF2-40B4-BE49-F238E27FC236}">
                    <a16:creationId xmlns:a16="http://schemas.microsoft.com/office/drawing/2014/main" id="{94DE097F-1E1C-4E81-A3B6-09042CB01B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81350"/>
                <a:ext cx="742950" cy="1588"/>
              </a:xfrm>
              <a:prstGeom prst="rect">
                <a:avLst/>
              </a:prstGeom>
              <a:solidFill>
                <a:srgbClr val="39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7" name="Rectangle 169">
                <a:extLst>
                  <a:ext uri="{FF2B5EF4-FFF2-40B4-BE49-F238E27FC236}">
                    <a16:creationId xmlns:a16="http://schemas.microsoft.com/office/drawing/2014/main" id="{7B739B2E-D848-4C62-A6B3-3338E4B069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82938"/>
                <a:ext cx="742950" cy="3175"/>
              </a:xfrm>
              <a:prstGeom prst="rect">
                <a:avLst/>
              </a:prstGeom>
              <a:solidFill>
                <a:srgbClr val="38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8" name="Rectangle 170">
                <a:extLst>
                  <a:ext uri="{FF2B5EF4-FFF2-40B4-BE49-F238E27FC236}">
                    <a16:creationId xmlns:a16="http://schemas.microsoft.com/office/drawing/2014/main" id="{61FC0543-500A-4AF6-8C40-B1F3B94590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86113"/>
                <a:ext cx="742950" cy="1588"/>
              </a:xfrm>
              <a:prstGeom prst="rect">
                <a:avLst/>
              </a:prstGeom>
              <a:solidFill>
                <a:srgbClr val="37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9" name="Rectangle 171">
                <a:extLst>
                  <a:ext uri="{FF2B5EF4-FFF2-40B4-BE49-F238E27FC236}">
                    <a16:creationId xmlns:a16="http://schemas.microsoft.com/office/drawing/2014/main" id="{848D1297-977B-4B6C-9BB8-6413E94BF5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87700"/>
                <a:ext cx="742950" cy="1588"/>
              </a:xfrm>
              <a:prstGeom prst="rect">
                <a:avLst/>
              </a:prstGeom>
              <a:solidFill>
                <a:srgbClr val="36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0" name="Rectangle 172">
                <a:extLst>
                  <a:ext uri="{FF2B5EF4-FFF2-40B4-BE49-F238E27FC236}">
                    <a16:creationId xmlns:a16="http://schemas.microsoft.com/office/drawing/2014/main" id="{AC61699B-C2DD-468C-983B-5658B11EE9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89288"/>
                <a:ext cx="742950" cy="3175"/>
              </a:xfrm>
              <a:prstGeom prst="rect">
                <a:avLst/>
              </a:prstGeom>
              <a:solidFill>
                <a:srgbClr val="3563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1" name="Rectangle 173">
                <a:extLst>
                  <a:ext uri="{FF2B5EF4-FFF2-40B4-BE49-F238E27FC236}">
                    <a16:creationId xmlns:a16="http://schemas.microsoft.com/office/drawing/2014/main" id="{49C46E9E-5AAC-43C1-8987-CE5FDFA1B0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92463"/>
                <a:ext cx="742950" cy="3175"/>
              </a:xfrm>
              <a:prstGeom prst="rect">
                <a:avLst/>
              </a:prstGeom>
              <a:solidFill>
                <a:srgbClr val="35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2" name="Rectangle 174">
                <a:extLst>
                  <a:ext uri="{FF2B5EF4-FFF2-40B4-BE49-F238E27FC236}">
                    <a16:creationId xmlns:a16="http://schemas.microsoft.com/office/drawing/2014/main" id="{18979C4A-D7EF-4BBE-9ED0-0226DDD904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95638"/>
                <a:ext cx="742950" cy="1588"/>
              </a:xfrm>
              <a:prstGeom prst="rect">
                <a:avLst/>
              </a:prstGeom>
              <a:solidFill>
                <a:srgbClr val="34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3" name="Rectangle 175">
                <a:extLst>
                  <a:ext uri="{FF2B5EF4-FFF2-40B4-BE49-F238E27FC236}">
                    <a16:creationId xmlns:a16="http://schemas.microsoft.com/office/drawing/2014/main" id="{8A636738-18B5-40E5-829B-E6BB19602C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197225"/>
                <a:ext cx="742950" cy="6350"/>
              </a:xfrm>
              <a:prstGeom prst="rect">
                <a:avLst/>
              </a:prstGeom>
              <a:solidFill>
                <a:srgbClr val="3461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4" name="Rectangle 176">
                <a:extLst>
                  <a:ext uri="{FF2B5EF4-FFF2-40B4-BE49-F238E27FC236}">
                    <a16:creationId xmlns:a16="http://schemas.microsoft.com/office/drawing/2014/main" id="{CE014685-612F-494F-8894-5331912559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03575"/>
                <a:ext cx="742950" cy="1588"/>
              </a:xfrm>
              <a:prstGeom prst="rect">
                <a:avLst/>
              </a:prstGeom>
              <a:solidFill>
                <a:srgbClr val="3361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5" name="Rectangle 177">
                <a:extLst>
                  <a:ext uri="{FF2B5EF4-FFF2-40B4-BE49-F238E27FC236}">
                    <a16:creationId xmlns:a16="http://schemas.microsoft.com/office/drawing/2014/main" id="{C61D6355-2481-46E0-ABBD-CE6C87181B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05163"/>
                <a:ext cx="742950" cy="1588"/>
              </a:xfrm>
              <a:prstGeom prst="rect">
                <a:avLst/>
              </a:prstGeom>
              <a:solidFill>
                <a:srgbClr val="3360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6" name="Rectangle 178">
                <a:extLst>
                  <a:ext uri="{FF2B5EF4-FFF2-40B4-BE49-F238E27FC236}">
                    <a16:creationId xmlns:a16="http://schemas.microsoft.com/office/drawing/2014/main" id="{BD19BF56-E492-436E-B9A1-77C8258B79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06750"/>
                <a:ext cx="742950" cy="6350"/>
              </a:xfrm>
              <a:prstGeom prst="rect">
                <a:avLst/>
              </a:prstGeom>
              <a:solidFill>
                <a:srgbClr val="3260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7" name="Rectangle 179">
                <a:extLst>
                  <a:ext uri="{FF2B5EF4-FFF2-40B4-BE49-F238E27FC236}">
                    <a16:creationId xmlns:a16="http://schemas.microsoft.com/office/drawing/2014/main" id="{82B1F3E4-BEB1-4C52-B3F9-1D94070D26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13100"/>
                <a:ext cx="742950" cy="1588"/>
              </a:xfrm>
              <a:prstGeom prst="rect">
                <a:avLst/>
              </a:prstGeom>
              <a:solidFill>
                <a:srgbClr val="32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8" name="Rectangle 180">
                <a:extLst>
                  <a:ext uri="{FF2B5EF4-FFF2-40B4-BE49-F238E27FC236}">
                    <a16:creationId xmlns:a16="http://schemas.microsoft.com/office/drawing/2014/main" id="{1056AFE6-07DF-4ABD-A2D7-3CF01D7588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14688"/>
                <a:ext cx="742950" cy="3175"/>
              </a:xfrm>
              <a:prstGeom prst="rect">
                <a:avLst/>
              </a:prstGeom>
              <a:solidFill>
                <a:srgbClr val="31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9" name="Rectangle 181">
                <a:extLst>
                  <a:ext uri="{FF2B5EF4-FFF2-40B4-BE49-F238E27FC236}">
                    <a16:creationId xmlns:a16="http://schemas.microsoft.com/office/drawing/2014/main" id="{42436216-82D6-42B3-ABCA-4F1E3003C9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17863"/>
                <a:ext cx="742950" cy="3175"/>
              </a:xfrm>
              <a:prstGeom prst="rect">
                <a:avLst/>
              </a:prstGeom>
              <a:solidFill>
                <a:srgbClr val="315E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0" name="Rectangle 182">
                <a:extLst>
                  <a:ext uri="{FF2B5EF4-FFF2-40B4-BE49-F238E27FC236}">
                    <a16:creationId xmlns:a16="http://schemas.microsoft.com/office/drawing/2014/main" id="{284B3657-A737-4096-9C2C-634F9070E9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21038"/>
                <a:ext cx="742950" cy="3175"/>
              </a:xfrm>
              <a:prstGeom prst="rect">
                <a:avLst/>
              </a:prstGeom>
              <a:solidFill>
                <a:srgbClr val="305D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1" name="Rectangle 183">
                <a:extLst>
                  <a:ext uri="{FF2B5EF4-FFF2-40B4-BE49-F238E27FC236}">
                    <a16:creationId xmlns:a16="http://schemas.microsoft.com/office/drawing/2014/main" id="{3E4E2161-0C0E-4B24-9BDC-649098F206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24213"/>
                <a:ext cx="742950" cy="3175"/>
              </a:xfrm>
              <a:prstGeom prst="rect">
                <a:avLst/>
              </a:prstGeom>
              <a:solidFill>
                <a:srgbClr val="305D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2" name="Rectangle 184">
                <a:extLst>
                  <a:ext uri="{FF2B5EF4-FFF2-40B4-BE49-F238E27FC236}">
                    <a16:creationId xmlns:a16="http://schemas.microsoft.com/office/drawing/2014/main" id="{7C35B528-7E2D-463D-9504-048F793A22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27388"/>
                <a:ext cx="742950" cy="4763"/>
              </a:xfrm>
              <a:prstGeom prst="rect">
                <a:avLst/>
              </a:prstGeom>
              <a:solidFill>
                <a:srgbClr val="2F5C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3" name="Rectangle 185">
                <a:extLst>
                  <a:ext uri="{FF2B5EF4-FFF2-40B4-BE49-F238E27FC236}">
                    <a16:creationId xmlns:a16="http://schemas.microsoft.com/office/drawing/2014/main" id="{01F2184F-3D7B-4621-A115-FD289EB176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32150"/>
                <a:ext cx="742950" cy="1588"/>
              </a:xfrm>
              <a:prstGeom prst="rect">
                <a:avLst/>
              </a:prstGeom>
              <a:solidFill>
                <a:srgbClr val="2F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4" name="Rectangle 186">
                <a:extLst>
                  <a:ext uri="{FF2B5EF4-FFF2-40B4-BE49-F238E27FC236}">
                    <a16:creationId xmlns:a16="http://schemas.microsoft.com/office/drawing/2014/main" id="{E1A9D7EE-F90C-48C1-A1DA-4AFA7115CA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33738"/>
                <a:ext cx="742950" cy="1588"/>
              </a:xfrm>
              <a:prstGeom prst="rect">
                <a:avLst/>
              </a:prstGeom>
              <a:solidFill>
                <a:srgbClr val="2E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5" name="Rectangle 187">
                <a:extLst>
                  <a:ext uri="{FF2B5EF4-FFF2-40B4-BE49-F238E27FC236}">
                    <a16:creationId xmlns:a16="http://schemas.microsoft.com/office/drawing/2014/main" id="{FA953DC3-81F8-4958-9DEF-8BA5A53886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35325"/>
                <a:ext cx="742950" cy="6350"/>
              </a:xfrm>
              <a:prstGeom prst="rect">
                <a:avLst/>
              </a:prstGeom>
              <a:solidFill>
                <a:srgbClr val="2E5A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6" name="Rectangle 188">
                <a:extLst>
                  <a:ext uri="{FF2B5EF4-FFF2-40B4-BE49-F238E27FC236}">
                    <a16:creationId xmlns:a16="http://schemas.microsoft.com/office/drawing/2014/main" id="{A88493D3-14B2-4AD0-9BE6-66794BF1B1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41675"/>
                <a:ext cx="742950" cy="1588"/>
              </a:xfrm>
              <a:prstGeom prst="rect">
                <a:avLst/>
              </a:prstGeom>
              <a:solidFill>
                <a:srgbClr val="2D5A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7" name="Rectangle 189">
                <a:extLst>
                  <a:ext uri="{FF2B5EF4-FFF2-40B4-BE49-F238E27FC236}">
                    <a16:creationId xmlns:a16="http://schemas.microsoft.com/office/drawing/2014/main" id="{84A886DE-0352-4F1D-BED1-88F68A5163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43263"/>
                <a:ext cx="742950" cy="3175"/>
              </a:xfrm>
              <a:prstGeom prst="rect">
                <a:avLst/>
              </a:prstGeom>
              <a:solidFill>
                <a:srgbClr val="2D59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8" name="Rectangle 190">
                <a:extLst>
                  <a:ext uri="{FF2B5EF4-FFF2-40B4-BE49-F238E27FC236}">
                    <a16:creationId xmlns:a16="http://schemas.microsoft.com/office/drawing/2014/main" id="{889F8465-E77E-48AE-9CF0-AC44F13507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46438"/>
                <a:ext cx="742950" cy="3175"/>
              </a:xfrm>
              <a:prstGeom prst="rect">
                <a:avLst/>
              </a:prstGeom>
              <a:solidFill>
                <a:srgbClr val="2C59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9" name="Rectangle 191">
                <a:extLst>
                  <a:ext uri="{FF2B5EF4-FFF2-40B4-BE49-F238E27FC236}">
                    <a16:creationId xmlns:a16="http://schemas.microsoft.com/office/drawing/2014/main" id="{C64583D5-D714-454A-932A-82A154C457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49613"/>
                <a:ext cx="742950" cy="4763"/>
              </a:xfrm>
              <a:prstGeom prst="rect">
                <a:avLst/>
              </a:prstGeom>
              <a:solidFill>
                <a:srgbClr val="2C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0" name="Rectangle 192">
                <a:extLst>
                  <a:ext uri="{FF2B5EF4-FFF2-40B4-BE49-F238E27FC236}">
                    <a16:creationId xmlns:a16="http://schemas.microsoft.com/office/drawing/2014/main" id="{52D3FB7F-4EC6-4D33-9EC5-3B84FFE6DB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54375"/>
                <a:ext cx="742950" cy="1588"/>
              </a:xfrm>
              <a:prstGeom prst="rect">
                <a:avLst/>
              </a:prstGeom>
              <a:solidFill>
                <a:srgbClr val="2B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1" name="Rectangle 193">
                <a:extLst>
                  <a:ext uri="{FF2B5EF4-FFF2-40B4-BE49-F238E27FC236}">
                    <a16:creationId xmlns:a16="http://schemas.microsoft.com/office/drawing/2014/main" id="{716F3050-4326-4763-B468-772C710700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55963"/>
                <a:ext cx="742950" cy="4763"/>
              </a:xfrm>
              <a:prstGeom prst="rect">
                <a:avLst/>
              </a:prstGeom>
              <a:solidFill>
                <a:srgbClr val="2B57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2" name="Rectangle 194">
                <a:extLst>
                  <a:ext uri="{FF2B5EF4-FFF2-40B4-BE49-F238E27FC236}">
                    <a16:creationId xmlns:a16="http://schemas.microsoft.com/office/drawing/2014/main" id="{D48B1C64-24B5-44E7-B561-428289016E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60725"/>
                <a:ext cx="742950" cy="3175"/>
              </a:xfrm>
              <a:prstGeom prst="rect">
                <a:avLst/>
              </a:prstGeom>
              <a:solidFill>
                <a:srgbClr val="2A56A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3" name="Rectangle 195">
                <a:extLst>
                  <a:ext uri="{FF2B5EF4-FFF2-40B4-BE49-F238E27FC236}">
                    <a16:creationId xmlns:a16="http://schemas.microsoft.com/office/drawing/2014/main" id="{087E43E9-90CC-451D-BA5E-1406563538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3263900"/>
                <a:ext cx="742950" cy="3175"/>
              </a:xfrm>
              <a:prstGeom prst="rect">
                <a:avLst/>
              </a:prstGeom>
              <a:solidFill>
                <a:srgbClr val="2955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4" name="Rectangle 196">
                <a:extLst>
                  <a:ext uri="{FF2B5EF4-FFF2-40B4-BE49-F238E27FC236}">
                    <a16:creationId xmlns:a16="http://schemas.microsoft.com/office/drawing/2014/main" id="{171BA2B4-483C-4E9B-9B13-7E9F2F42BD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52713"/>
                <a:ext cx="928688" cy="1588"/>
              </a:xfrm>
              <a:prstGeom prst="rect">
                <a:avLst/>
              </a:prstGeom>
              <a:solidFill>
                <a:srgbClr val="59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5" name="Rectangle 197">
                <a:extLst>
                  <a:ext uri="{FF2B5EF4-FFF2-40B4-BE49-F238E27FC236}">
                    <a16:creationId xmlns:a16="http://schemas.microsoft.com/office/drawing/2014/main" id="{A07D58E1-E13A-431F-9634-1D352E80C6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54300"/>
                <a:ext cx="928688" cy="1588"/>
              </a:xfrm>
              <a:prstGeom prst="rect">
                <a:avLst/>
              </a:prstGeom>
              <a:solidFill>
                <a:srgbClr val="58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6" name="Rectangle 198">
                <a:extLst>
                  <a:ext uri="{FF2B5EF4-FFF2-40B4-BE49-F238E27FC236}">
                    <a16:creationId xmlns:a16="http://schemas.microsoft.com/office/drawing/2014/main" id="{0A6AECCC-AD9F-4E43-BA9C-DAF4542333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55888"/>
                <a:ext cx="928688" cy="1588"/>
              </a:xfrm>
              <a:prstGeom prst="rect">
                <a:avLst/>
              </a:prstGeom>
              <a:solidFill>
                <a:srgbClr val="5876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7" name="Rectangle 199">
                <a:extLst>
                  <a:ext uri="{FF2B5EF4-FFF2-40B4-BE49-F238E27FC236}">
                    <a16:creationId xmlns:a16="http://schemas.microsoft.com/office/drawing/2014/main" id="{3548E58F-1016-475E-A7C3-2626B4092F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57475"/>
                <a:ext cx="928688" cy="1588"/>
              </a:xfrm>
              <a:prstGeom prst="rect">
                <a:avLst/>
              </a:prstGeom>
              <a:solidFill>
                <a:srgbClr val="57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Rectangle 200">
                <a:extLst>
                  <a:ext uri="{FF2B5EF4-FFF2-40B4-BE49-F238E27FC236}">
                    <a16:creationId xmlns:a16="http://schemas.microsoft.com/office/drawing/2014/main" id="{0888CAC3-94EA-40AE-ABD4-10E01CEE38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59063"/>
                <a:ext cx="928688" cy="3175"/>
              </a:xfrm>
              <a:prstGeom prst="rect">
                <a:avLst/>
              </a:prstGeom>
              <a:solidFill>
                <a:srgbClr val="56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9" name="Rectangle 201">
                <a:extLst>
                  <a:ext uri="{FF2B5EF4-FFF2-40B4-BE49-F238E27FC236}">
                    <a16:creationId xmlns:a16="http://schemas.microsoft.com/office/drawing/2014/main" id="{0A462FF6-2AFB-4302-94D1-63DF44F89F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62238"/>
                <a:ext cx="928688" cy="1588"/>
              </a:xfrm>
              <a:prstGeom prst="rect">
                <a:avLst/>
              </a:prstGeom>
              <a:solidFill>
                <a:srgbClr val="55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0" name="Rectangle 202">
                <a:extLst>
                  <a:ext uri="{FF2B5EF4-FFF2-40B4-BE49-F238E27FC236}">
                    <a16:creationId xmlns:a16="http://schemas.microsoft.com/office/drawing/2014/main" id="{6EB8B373-851F-47EA-AB66-C42E85DEC8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63825"/>
                <a:ext cx="928688" cy="1588"/>
              </a:xfrm>
              <a:prstGeom prst="rect">
                <a:avLst/>
              </a:prstGeom>
              <a:solidFill>
                <a:srgbClr val="54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1" name="Rectangle 203">
                <a:extLst>
                  <a:ext uri="{FF2B5EF4-FFF2-40B4-BE49-F238E27FC236}">
                    <a16:creationId xmlns:a16="http://schemas.microsoft.com/office/drawing/2014/main" id="{ED2940B8-A4E3-43A4-91FC-59D289E5D3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65413"/>
                <a:ext cx="928688" cy="1588"/>
              </a:xfrm>
              <a:prstGeom prst="rect">
                <a:avLst/>
              </a:prstGeom>
              <a:solidFill>
                <a:srgbClr val="5374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2" name="Rectangle 204">
                <a:extLst>
                  <a:ext uri="{FF2B5EF4-FFF2-40B4-BE49-F238E27FC236}">
                    <a16:creationId xmlns:a16="http://schemas.microsoft.com/office/drawing/2014/main" id="{3C101248-1475-443D-B83E-906617FEB4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0" y="2667000"/>
                <a:ext cx="928688" cy="3175"/>
              </a:xfrm>
              <a:prstGeom prst="rect">
                <a:avLst/>
              </a:prstGeom>
              <a:solidFill>
                <a:srgbClr val="5273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Rectangle 206">
                <a:extLst>
                  <a:ext uri="{FF2B5EF4-FFF2-40B4-BE49-F238E27FC236}">
                    <a16:creationId xmlns:a16="http://schemas.microsoft.com/office/drawing/2014/main" id="{411C49C0-C15C-41F6-9CA0-0D280B8032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70176"/>
                <a:ext cx="928688" cy="1588"/>
              </a:xfrm>
              <a:prstGeom prst="rect">
                <a:avLst/>
              </a:prstGeom>
              <a:solidFill>
                <a:srgbClr val="51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Rectangle 207">
                <a:extLst>
                  <a:ext uri="{FF2B5EF4-FFF2-40B4-BE49-F238E27FC236}">
                    <a16:creationId xmlns:a16="http://schemas.microsoft.com/office/drawing/2014/main" id="{4D573AA4-FB56-42C9-BE50-506BFC0A61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71763"/>
                <a:ext cx="928688" cy="1588"/>
              </a:xfrm>
              <a:prstGeom prst="rect">
                <a:avLst/>
              </a:prstGeom>
              <a:solidFill>
                <a:srgbClr val="50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Rectangle 208">
                <a:extLst>
                  <a:ext uri="{FF2B5EF4-FFF2-40B4-BE49-F238E27FC236}">
                    <a16:creationId xmlns:a16="http://schemas.microsoft.com/office/drawing/2014/main" id="{48EB53A7-B339-4E1E-AE99-832C1C9AB1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73351"/>
                <a:ext cx="928688" cy="3175"/>
              </a:xfrm>
              <a:prstGeom prst="rect">
                <a:avLst/>
              </a:prstGeom>
              <a:solidFill>
                <a:srgbClr val="4F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Rectangle 209">
                <a:extLst>
                  <a:ext uri="{FF2B5EF4-FFF2-40B4-BE49-F238E27FC236}">
                    <a16:creationId xmlns:a16="http://schemas.microsoft.com/office/drawing/2014/main" id="{047FD6E7-58E5-44D5-9BF9-4C6A59DE39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76526"/>
                <a:ext cx="928688" cy="1588"/>
              </a:xfrm>
              <a:prstGeom prst="rect">
                <a:avLst/>
              </a:prstGeom>
              <a:solidFill>
                <a:srgbClr val="4E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Rectangle 210">
                <a:extLst>
                  <a:ext uri="{FF2B5EF4-FFF2-40B4-BE49-F238E27FC236}">
                    <a16:creationId xmlns:a16="http://schemas.microsoft.com/office/drawing/2014/main" id="{430FBDB0-0DAB-41E4-9461-9C87AA8117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78113"/>
                <a:ext cx="928688" cy="1588"/>
              </a:xfrm>
              <a:prstGeom prst="rect">
                <a:avLst/>
              </a:prstGeom>
              <a:solidFill>
                <a:srgbClr val="4D71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Rectangle 211">
                <a:extLst>
                  <a:ext uri="{FF2B5EF4-FFF2-40B4-BE49-F238E27FC236}">
                    <a16:creationId xmlns:a16="http://schemas.microsoft.com/office/drawing/2014/main" id="{54F9CD0F-2DD9-44C6-A5FB-E15CF752BB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79701"/>
                <a:ext cx="928688" cy="1588"/>
              </a:xfrm>
              <a:prstGeom prst="rect">
                <a:avLst/>
              </a:prstGeom>
              <a:solidFill>
                <a:srgbClr val="4D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Rectangle 212">
                <a:extLst>
                  <a:ext uri="{FF2B5EF4-FFF2-40B4-BE49-F238E27FC236}">
                    <a16:creationId xmlns:a16="http://schemas.microsoft.com/office/drawing/2014/main" id="{D229E896-1CE5-461B-8CCF-E419BA9434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81288"/>
                <a:ext cx="928688" cy="1588"/>
              </a:xfrm>
              <a:prstGeom prst="rect">
                <a:avLst/>
              </a:prstGeom>
              <a:solidFill>
                <a:srgbClr val="4C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Rectangle 213">
                <a:extLst>
                  <a:ext uri="{FF2B5EF4-FFF2-40B4-BE49-F238E27FC236}">
                    <a16:creationId xmlns:a16="http://schemas.microsoft.com/office/drawing/2014/main" id="{4E3A9883-2834-4D04-A08A-6D47DEF33C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82876"/>
                <a:ext cx="928688" cy="1588"/>
              </a:xfrm>
              <a:prstGeom prst="rect">
                <a:avLst/>
              </a:prstGeom>
              <a:solidFill>
                <a:srgbClr val="4B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Rectangle 214">
                <a:extLst>
                  <a:ext uri="{FF2B5EF4-FFF2-40B4-BE49-F238E27FC236}">
                    <a16:creationId xmlns:a16="http://schemas.microsoft.com/office/drawing/2014/main" id="{881C8031-1226-45CF-9C72-8543028A07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84463"/>
                <a:ext cx="928688" cy="1588"/>
              </a:xfrm>
              <a:prstGeom prst="rect">
                <a:avLst/>
              </a:prstGeom>
              <a:solidFill>
                <a:srgbClr val="4A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Rectangle 215">
                <a:extLst>
                  <a:ext uri="{FF2B5EF4-FFF2-40B4-BE49-F238E27FC236}">
                    <a16:creationId xmlns:a16="http://schemas.microsoft.com/office/drawing/2014/main" id="{7BE3BD6A-A282-49DA-B87E-CD5C454687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86051"/>
                <a:ext cx="928688" cy="3175"/>
              </a:xfrm>
              <a:prstGeom prst="rect">
                <a:avLst/>
              </a:prstGeom>
              <a:solidFill>
                <a:srgbClr val="49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Rectangle 216">
                <a:extLst>
                  <a:ext uri="{FF2B5EF4-FFF2-40B4-BE49-F238E27FC236}">
                    <a16:creationId xmlns:a16="http://schemas.microsoft.com/office/drawing/2014/main" id="{F3FCBB97-9A3B-420F-B2CF-4F50EB127C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89226"/>
                <a:ext cx="928688" cy="1588"/>
              </a:xfrm>
              <a:prstGeom prst="rect">
                <a:avLst/>
              </a:prstGeom>
              <a:solidFill>
                <a:srgbClr val="48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Rectangle 217">
                <a:extLst>
                  <a:ext uri="{FF2B5EF4-FFF2-40B4-BE49-F238E27FC236}">
                    <a16:creationId xmlns:a16="http://schemas.microsoft.com/office/drawing/2014/main" id="{004E2D4E-6245-4203-9584-3CF1F800F1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90813"/>
                <a:ext cx="928688" cy="1588"/>
              </a:xfrm>
              <a:prstGeom prst="rect">
                <a:avLst/>
              </a:prstGeom>
              <a:solidFill>
                <a:srgbClr val="47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Rectangle 218">
                <a:extLst>
                  <a:ext uri="{FF2B5EF4-FFF2-40B4-BE49-F238E27FC236}">
                    <a16:creationId xmlns:a16="http://schemas.microsoft.com/office/drawing/2014/main" id="{3166D39B-A2FD-4FA5-8EC2-CF7F6910C6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92401"/>
                <a:ext cx="928688" cy="1588"/>
              </a:xfrm>
              <a:prstGeom prst="rect">
                <a:avLst/>
              </a:prstGeom>
              <a:solidFill>
                <a:srgbClr val="46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Rectangle 219">
                <a:extLst>
                  <a:ext uri="{FF2B5EF4-FFF2-40B4-BE49-F238E27FC236}">
                    <a16:creationId xmlns:a16="http://schemas.microsoft.com/office/drawing/2014/main" id="{1BDF1FDA-4150-4F7D-A51D-69F085606A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93988"/>
                <a:ext cx="928688" cy="1588"/>
              </a:xfrm>
              <a:prstGeom prst="rect">
                <a:avLst/>
              </a:prstGeom>
              <a:solidFill>
                <a:srgbClr val="46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Rectangle 220">
                <a:extLst>
                  <a:ext uri="{FF2B5EF4-FFF2-40B4-BE49-F238E27FC236}">
                    <a16:creationId xmlns:a16="http://schemas.microsoft.com/office/drawing/2014/main" id="{E863928C-EE3C-4979-81A6-3F1C345049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95576"/>
                <a:ext cx="928688" cy="1588"/>
              </a:xfrm>
              <a:prstGeom prst="rect">
                <a:avLst/>
              </a:prstGeom>
              <a:solidFill>
                <a:srgbClr val="45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Rectangle 221">
                <a:extLst>
                  <a:ext uri="{FF2B5EF4-FFF2-40B4-BE49-F238E27FC236}">
                    <a16:creationId xmlns:a16="http://schemas.microsoft.com/office/drawing/2014/main" id="{54932B69-1769-4E2E-B2CE-098BA5BBE9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97163"/>
                <a:ext cx="928688" cy="1588"/>
              </a:xfrm>
              <a:prstGeom prst="rect">
                <a:avLst/>
              </a:prstGeom>
              <a:solidFill>
                <a:srgbClr val="44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Rectangle 222">
                <a:extLst>
                  <a:ext uri="{FF2B5EF4-FFF2-40B4-BE49-F238E27FC236}">
                    <a16:creationId xmlns:a16="http://schemas.microsoft.com/office/drawing/2014/main" id="{B7FA07AD-CABF-4BF7-8231-39CBA3B477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698751"/>
                <a:ext cx="928688" cy="4763"/>
              </a:xfrm>
              <a:prstGeom prst="rect">
                <a:avLst/>
              </a:prstGeom>
              <a:solidFill>
                <a:srgbClr val="43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Rectangle 223">
                <a:extLst>
                  <a:ext uri="{FF2B5EF4-FFF2-40B4-BE49-F238E27FC236}">
                    <a16:creationId xmlns:a16="http://schemas.microsoft.com/office/drawing/2014/main" id="{1BC5E205-6B1E-4EDD-839C-8FDF3D0343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03513"/>
                <a:ext cx="928688" cy="1588"/>
              </a:xfrm>
              <a:prstGeom prst="rect">
                <a:avLst/>
              </a:prstGeom>
              <a:solidFill>
                <a:srgbClr val="42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Rectangle 224">
                <a:extLst>
                  <a:ext uri="{FF2B5EF4-FFF2-40B4-BE49-F238E27FC236}">
                    <a16:creationId xmlns:a16="http://schemas.microsoft.com/office/drawing/2014/main" id="{CCAC5643-872B-4ADC-B378-34DBF38323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05101"/>
                <a:ext cx="928688" cy="1588"/>
              </a:xfrm>
              <a:prstGeom prst="rect">
                <a:avLst/>
              </a:prstGeom>
              <a:solidFill>
                <a:srgbClr val="41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Rectangle 225">
                <a:extLst>
                  <a:ext uri="{FF2B5EF4-FFF2-40B4-BE49-F238E27FC236}">
                    <a16:creationId xmlns:a16="http://schemas.microsoft.com/office/drawing/2014/main" id="{A9F19711-791B-4E77-836D-47893B9610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06688"/>
                <a:ext cx="928688" cy="1588"/>
              </a:xfrm>
              <a:prstGeom prst="rect">
                <a:avLst/>
              </a:prstGeom>
              <a:solidFill>
                <a:srgbClr val="40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Rectangle 226">
                <a:extLst>
                  <a:ext uri="{FF2B5EF4-FFF2-40B4-BE49-F238E27FC236}">
                    <a16:creationId xmlns:a16="http://schemas.microsoft.com/office/drawing/2014/main" id="{AB1906B5-8182-4EB6-9E65-FE8E66824D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08276"/>
                <a:ext cx="928688" cy="1588"/>
              </a:xfrm>
              <a:prstGeom prst="rect">
                <a:avLst/>
              </a:prstGeom>
              <a:solidFill>
                <a:srgbClr val="3F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Rectangle 227">
                <a:extLst>
                  <a:ext uri="{FF2B5EF4-FFF2-40B4-BE49-F238E27FC236}">
                    <a16:creationId xmlns:a16="http://schemas.microsoft.com/office/drawing/2014/main" id="{9C1C8B43-9A5C-4E9E-AD5D-EC73EDAAF0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09863"/>
                <a:ext cx="928688" cy="1588"/>
              </a:xfrm>
              <a:prstGeom prst="rect">
                <a:avLst/>
              </a:prstGeom>
              <a:solidFill>
                <a:srgbClr val="3E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Rectangle 228">
                <a:extLst>
                  <a:ext uri="{FF2B5EF4-FFF2-40B4-BE49-F238E27FC236}">
                    <a16:creationId xmlns:a16="http://schemas.microsoft.com/office/drawing/2014/main" id="{5225CB17-547F-4B06-AE46-8F091C2532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11451"/>
                <a:ext cx="928688" cy="1588"/>
              </a:xfrm>
              <a:prstGeom prst="rect">
                <a:avLst/>
              </a:prstGeom>
              <a:solidFill>
                <a:srgbClr val="3D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Rectangle 229">
                <a:extLst>
                  <a:ext uri="{FF2B5EF4-FFF2-40B4-BE49-F238E27FC236}">
                    <a16:creationId xmlns:a16="http://schemas.microsoft.com/office/drawing/2014/main" id="{DF89FE7F-1A62-435C-875B-3ABF8B2854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13038"/>
                <a:ext cx="928688" cy="4763"/>
              </a:xfrm>
              <a:prstGeom prst="rect">
                <a:avLst/>
              </a:prstGeom>
              <a:solidFill>
                <a:srgbClr val="3C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Rectangle 230">
                <a:extLst>
                  <a:ext uri="{FF2B5EF4-FFF2-40B4-BE49-F238E27FC236}">
                    <a16:creationId xmlns:a16="http://schemas.microsoft.com/office/drawing/2014/main" id="{BFA2344C-0D28-4462-89E5-4C4D847E83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17801"/>
                <a:ext cx="928688" cy="1588"/>
              </a:xfrm>
              <a:prstGeom prst="rect">
                <a:avLst/>
              </a:prstGeom>
              <a:solidFill>
                <a:srgbClr val="3B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Rectangle 231">
                <a:extLst>
                  <a:ext uri="{FF2B5EF4-FFF2-40B4-BE49-F238E27FC236}">
                    <a16:creationId xmlns:a16="http://schemas.microsoft.com/office/drawing/2014/main" id="{B28A0F1A-795A-4D20-9A58-29C7ED0AE8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19388"/>
                <a:ext cx="928688" cy="1588"/>
              </a:xfrm>
              <a:prstGeom prst="rect">
                <a:avLst/>
              </a:prstGeom>
              <a:solidFill>
                <a:srgbClr val="3A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Rectangle 232">
                <a:extLst>
                  <a:ext uri="{FF2B5EF4-FFF2-40B4-BE49-F238E27FC236}">
                    <a16:creationId xmlns:a16="http://schemas.microsoft.com/office/drawing/2014/main" id="{E0D48871-0CCB-4580-8834-86BFF3DFD4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20976"/>
                <a:ext cx="928688" cy="1588"/>
              </a:xfrm>
              <a:prstGeom prst="rect">
                <a:avLst/>
              </a:prstGeom>
              <a:solidFill>
                <a:srgbClr val="39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Rectangle 233">
                <a:extLst>
                  <a:ext uri="{FF2B5EF4-FFF2-40B4-BE49-F238E27FC236}">
                    <a16:creationId xmlns:a16="http://schemas.microsoft.com/office/drawing/2014/main" id="{2DB8CF20-8E3A-4B4F-8F06-8B969F269A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22563"/>
                <a:ext cx="928688" cy="1588"/>
              </a:xfrm>
              <a:prstGeom prst="rect">
                <a:avLst/>
              </a:prstGeom>
              <a:solidFill>
                <a:srgbClr val="38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Rectangle 234">
                <a:extLst>
                  <a:ext uri="{FF2B5EF4-FFF2-40B4-BE49-F238E27FC236}">
                    <a16:creationId xmlns:a16="http://schemas.microsoft.com/office/drawing/2014/main" id="{BEB3B746-AAB7-4B0F-9CA5-747C699993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24151"/>
                <a:ext cx="928688" cy="1588"/>
              </a:xfrm>
              <a:prstGeom prst="rect">
                <a:avLst/>
              </a:prstGeom>
              <a:solidFill>
                <a:srgbClr val="37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Rectangle 235">
                <a:extLst>
                  <a:ext uri="{FF2B5EF4-FFF2-40B4-BE49-F238E27FC236}">
                    <a16:creationId xmlns:a16="http://schemas.microsoft.com/office/drawing/2014/main" id="{07FF1DDA-7468-4121-A3DC-3F8FCC961D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25738"/>
                <a:ext cx="928688" cy="3175"/>
              </a:xfrm>
              <a:prstGeom prst="rect">
                <a:avLst/>
              </a:prstGeom>
              <a:solidFill>
                <a:srgbClr val="36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Rectangle 236">
                <a:extLst>
                  <a:ext uri="{FF2B5EF4-FFF2-40B4-BE49-F238E27FC236}">
                    <a16:creationId xmlns:a16="http://schemas.microsoft.com/office/drawing/2014/main" id="{9F14DDCE-DB39-47A4-B849-36006EADB9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28913"/>
                <a:ext cx="928688" cy="3175"/>
              </a:xfrm>
              <a:prstGeom prst="rect">
                <a:avLst/>
              </a:prstGeom>
              <a:solidFill>
                <a:srgbClr val="3563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Rectangle 237">
                <a:extLst>
                  <a:ext uri="{FF2B5EF4-FFF2-40B4-BE49-F238E27FC236}">
                    <a16:creationId xmlns:a16="http://schemas.microsoft.com/office/drawing/2014/main" id="{8AC9FBF3-1A2A-452D-8D55-86D52E8AB4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32088"/>
                <a:ext cx="928688" cy="3175"/>
              </a:xfrm>
              <a:prstGeom prst="rect">
                <a:avLst/>
              </a:prstGeom>
              <a:solidFill>
                <a:srgbClr val="35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Rectangle 238">
                <a:extLst>
                  <a:ext uri="{FF2B5EF4-FFF2-40B4-BE49-F238E27FC236}">
                    <a16:creationId xmlns:a16="http://schemas.microsoft.com/office/drawing/2014/main" id="{869C7939-465C-4291-A340-63B6D9906B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35263"/>
                <a:ext cx="928688" cy="1588"/>
              </a:xfrm>
              <a:prstGeom prst="rect">
                <a:avLst/>
              </a:prstGeom>
              <a:solidFill>
                <a:srgbClr val="34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Rectangle 239">
                <a:extLst>
                  <a:ext uri="{FF2B5EF4-FFF2-40B4-BE49-F238E27FC236}">
                    <a16:creationId xmlns:a16="http://schemas.microsoft.com/office/drawing/2014/main" id="{C523955F-0292-4DA5-BB16-B19F6CDBAC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36851"/>
                <a:ext cx="928688" cy="6350"/>
              </a:xfrm>
              <a:prstGeom prst="rect">
                <a:avLst/>
              </a:prstGeom>
              <a:solidFill>
                <a:srgbClr val="3461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Rectangle 240">
                <a:extLst>
                  <a:ext uri="{FF2B5EF4-FFF2-40B4-BE49-F238E27FC236}">
                    <a16:creationId xmlns:a16="http://schemas.microsoft.com/office/drawing/2014/main" id="{81C6DAB2-80DC-4BE5-88A0-0CFE806BB0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43201"/>
                <a:ext cx="928688" cy="1588"/>
              </a:xfrm>
              <a:prstGeom prst="rect">
                <a:avLst/>
              </a:prstGeom>
              <a:solidFill>
                <a:srgbClr val="3361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Rectangle 241">
                <a:extLst>
                  <a:ext uri="{FF2B5EF4-FFF2-40B4-BE49-F238E27FC236}">
                    <a16:creationId xmlns:a16="http://schemas.microsoft.com/office/drawing/2014/main" id="{435372D5-3C46-4600-BD50-7E3587B0FB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44788"/>
                <a:ext cx="928688" cy="1588"/>
              </a:xfrm>
              <a:prstGeom prst="rect">
                <a:avLst/>
              </a:prstGeom>
              <a:solidFill>
                <a:srgbClr val="3360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Rectangle 242">
                <a:extLst>
                  <a:ext uri="{FF2B5EF4-FFF2-40B4-BE49-F238E27FC236}">
                    <a16:creationId xmlns:a16="http://schemas.microsoft.com/office/drawing/2014/main" id="{63F35346-5D5B-4317-A97F-7E829CD134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46376"/>
                <a:ext cx="928688" cy="4763"/>
              </a:xfrm>
              <a:prstGeom prst="rect">
                <a:avLst/>
              </a:prstGeom>
              <a:solidFill>
                <a:srgbClr val="3260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Rectangle 243">
                <a:extLst>
                  <a:ext uri="{FF2B5EF4-FFF2-40B4-BE49-F238E27FC236}">
                    <a16:creationId xmlns:a16="http://schemas.microsoft.com/office/drawing/2014/main" id="{99D308C1-3998-4421-A47B-8CBAD47455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51138"/>
                <a:ext cx="928688" cy="1588"/>
              </a:xfrm>
              <a:prstGeom prst="rect">
                <a:avLst/>
              </a:prstGeom>
              <a:solidFill>
                <a:srgbClr val="32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Rectangle 244">
                <a:extLst>
                  <a:ext uri="{FF2B5EF4-FFF2-40B4-BE49-F238E27FC236}">
                    <a16:creationId xmlns:a16="http://schemas.microsoft.com/office/drawing/2014/main" id="{8B563DE4-027F-4290-8329-4D1557D328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52726"/>
                <a:ext cx="928688" cy="4763"/>
              </a:xfrm>
              <a:prstGeom prst="rect">
                <a:avLst/>
              </a:prstGeom>
              <a:solidFill>
                <a:srgbClr val="31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Rectangle 245">
                <a:extLst>
                  <a:ext uri="{FF2B5EF4-FFF2-40B4-BE49-F238E27FC236}">
                    <a16:creationId xmlns:a16="http://schemas.microsoft.com/office/drawing/2014/main" id="{38062ADC-F20E-4680-A31B-8EAF039E2E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57488"/>
                <a:ext cx="928688" cy="3175"/>
              </a:xfrm>
              <a:prstGeom prst="rect">
                <a:avLst/>
              </a:prstGeom>
              <a:solidFill>
                <a:srgbClr val="315E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Rectangle 246">
                <a:extLst>
                  <a:ext uri="{FF2B5EF4-FFF2-40B4-BE49-F238E27FC236}">
                    <a16:creationId xmlns:a16="http://schemas.microsoft.com/office/drawing/2014/main" id="{E1CD55AF-4A3C-42D5-BD3D-EE0E555A95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60663"/>
                <a:ext cx="928688" cy="3175"/>
              </a:xfrm>
              <a:prstGeom prst="rect">
                <a:avLst/>
              </a:prstGeom>
              <a:solidFill>
                <a:srgbClr val="305D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Rectangle 247">
                <a:extLst>
                  <a:ext uri="{FF2B5EF4-FFF2-40B4-BE49-F238E27FC236}">
                    <a16:creationId xmlns:a16="http://schemas.microsoft.com/office/drawing/2014/main" id="{9E8A6782-6299-4B29-B3F7-A4083F80B0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63838"/>
                <a:ext cx="928688" cy="1588"/>
              </a:xfrm>
              <a:prstGeom prst="rect">
                <a:avLst/>
              </a:prstGeom>
              <a:solidFill>
                <a:srgbClr val="305D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Rectangle 248">
                <a:extLst>
                  <a:ext uri="{FF2B5EF4-FFF2-40B4-BE49-F238E27FC236}">
                    <a16:creationId xmlns:a16="http://schemas.microsoft.com/office/drawing/2014/main" id="{5E56ACEE-0888-4A2A-AE0E-A1B38C05EC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65426"/>
                <a:ext cx="928688" cy="6350"/>
              </a:xfrm>
              <a:prstGeom prst="rect">
                <a:avLst/>
              </a:prstGeom>
              <a:solidFill>
                <a:srgbClr val="2F5C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Rectangle 249">
                <a:extLst>
                  <a:ext uri="{FF2B5EF4-FFF2-40B4-BE49-F238E27FC236}">
                    <a16:creationId xmlns:a16="http://schemas.microsoft.com/office/drawing/2014/main" id="{5AF0AB69-CB0C-4805-BF4A-0975F28E8F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71776"/>
                <a:ext cx="928688" cy="1588"/>
              </a:xfrm>
              <a:prstGeom prst="rect">
                <a:avLst/>
              </a:prstGeom>
              <a:solidFill>
                <a:srgbClr val="2F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Rectangle 250">
                <a:extLst>
                  <a:ext uri="{FF2B5EF4-FFF2-40B4-BE49-F238E27FC236}">
                    <a16:creationId xmlns:a16="http://schemas.microsoft.com/office/drawing/2014/main" id="{79181EEA-7D03-40E7-A57C-EB20521658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73363"/>
                <a:ext cx="928688" cy="1588"/>
              </a:xfrm>
              <a:prstGeom prst="rect">
                <a:avLst/>
              </a:prstGeom>
              <a:solidFill>
                <a:srgbClr val="2E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Rectangle 251">
                <a:extLst>
                  <a:ext uri="{FF2B5EF4-FFF2-40B4-BE49-F238E27FC236}">
                    <a16:creationId xmlns:a16="http://schemas.microsoft.com/office/drawing/2014/main" id="{D0875B2E-9E5C-45EF-A82A-F3F45FE6E0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74951"/>
                <a:ext cx="928688" cy="4763"/>
              </a:xfrm>
              <a:prstGeom prst="rect">
                <a:avLst/>
              </a:prstGeom>
              <a:solidFill>
                <a:srgbClr val="2E5A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Rectangle 252">
                <a:extLst>
                  <a:ext uri="{FF2B5EF4-FFF2-40B4-BE49-F238E27FC236}">
                    <a16:creationId xmlns:a16="http://schemas.microsoft.com/office/drawing/2014/main" id="{4DB6F315-B3B3-44CA-81FB-82FC75B52B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79713"/>
                <a:ext cx="928688" cy="3175"/>
              </a:xfrm>
              <a:prstGeom prst="rect">
                <a:avLst/>
              </a:prstGeom>
              <a:solidFill>
                <a:srgbClr val="2D5A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Rectangle 253">
                <a:extLst>
                  <a:ext uri="{FF2B5EF4-FFF2-40B4-BE49-F238E27FC236}">
                    <a16:creationId xmlns:a16="http://schemas.microsoft.com/office/drawing/2014/main" id="{76DC2EEB-95CD-49AC-89EA-F547671771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82888"/>
                <a:ext cx="928688" cy="3175"/>
              </a:xfrm>
              <a:prstGeom prst="rect">
                <a:avLst/>
              </a:prstGeom>
              <a:solidFill>
                <a:srgbClr val="2D59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Rectangle 254">
                <a:extLst>
                  <a:ext uri="{FF2B5EF4-FFF2-40B4-BE49-F238E27FC236}">
                    <a16:creationId xmlns:a16="http://schemas.microsoft.com/office/drawing/2014/main" id="{5A22FE66-27C4-42DA-B656-5E74F44CE3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86063"/>
                <a:ext cx="928688" cy="3175"/>
              </a:xfrm>
              <a:prstGeom prst="rect">
                <a:avLst/>
              </a:prstGeom>
              <a:solidFill>
                <a:srgbClr val="2C59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Rectangle 255">
                <a:extLst>
                  <a:ext uri="{FF2B5EF4-FFF2-40B4-BE49-F238E27FC236}">
                    <a16:creationId xmlns:a16="http://schemas.microsoft.com/office/drawing/2014/main" id="{31A53DE1-7D80-404E-8BE1-B0CC43A56C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89238"/>
                <a:ext cx="928688" cy="3175"/>
              </a:xfrm>
              <a:prstGeom prst="rect">
                <a:avLst/>
              </a:prstGeom>
              <a:solidFill>
                <a:srgbClr val="2C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Rectangle 256">
                <a:extLst>
                  <a:ext uri="{FF2B5EF4-FFF2-40B4-BE49-F238E27FC236}">
                    <a16:creationId xmlns:a16="http://schemas.microsoft.com/office/drawing/2014/main" id="{063E6136-A836-4407-86F2-8B3AFCACE5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92413"/>
                <a:ext cx="928688" cy="1588"/>
              </a:xfrm>
              <a:prstGeom prst="rect">
                <a:avLst/>
              </a:prstGeom>
              <a:solidFill>
                <a:srgbClr val="2B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Rectangle 257">
                <a:extLst>
                  <a:ext uri="{FF2B5EF4-FFF2-40B4-BE49-F238E27FC236}">
                    <a16:creationId xmlns:a16="http://schemas.microsoft.com/office/drawing/2014/main" id="{58E0A82A-6492-4C49-99FD-B57E822DDF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794001"/>
                <a:ext cx="928688" cy="6350"/>
              </a:xfrm>
              <a:prstGeom prst="rect">
                <a:avLst/>
              </a:prstGeom>
              <a:solidFill>
                <a:srgbClr val="2B57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Rectangle 258">
                <a:extLst>
                  <a:ext uri="{FF2B5EF4-FFF2-40B4-BE49-F238E27FC236}">
                    <a16:creationId xmlns:a16="http://schemas.microsoft.com/office/drawing/2014/main" id="{2FC522E2-2D1C-44F5-9F55-4D655C0BF0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800351"/>
                <a:ext cx="928688" cy="3175"/>
              </a:xfrm>
              <a:prstGeom prst="rect">
                <a:avLst/>
              </a:prstGeom>
              <a:solidFill>
                <a:srgbClr val="2A56A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Rectangle 259">
                <a:extLst>
                  <a:ext uri="{FF2B5EF4-FFF2-40B4-BE49-F238E27FC236}">
                    <a16:creationId xmlns:a16="http://schemas.microsoft.com/office/drawing/2014/main" id="{11BDFD93-6E1B-4214-818E-321382C757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803526"/>
                <a:ext cx="928688" cy="1588"/>
              </a:xfrm>
              <a:prstGeom prst="rect">
                <a:avLst/>
              </a:prstGeom>
              <a:solidFill>
                <a:srgbClr val="2955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Rectangle 260">
                <a:extLst>
                  <a:ext uri="{FF2B5EF4-FFF2-40B4-BE49-F238E27FC236}">
                    <a16:creationId xmlns:a16="http://schemas.microsoft.com/office/drawing/2014/main" id="{AC25958F-EBC0-45C5-82A8-DDDD608666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192338"/>
                <a:ext cx="3903663" cy="1588"/>
              </a:xfrm>
              <a:prstGeom prst="rect">
                <a:avLst/>
              </a:prstGeom>
              <a:solidFill>
                <a:srgbClr val="59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Rectangle 261">
                <a:extLst>
                  <a:ext uri="{FF2B5EF4-FFF2-40B4-BE49-F238E27FC236}">
                    <a16:creationId xmlns:a16="http://schemas.microsoft.com/office/drawing/2014/main" id="{D0D62544-323F-4F27-A3FF-C64FC39301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193926"/>
                <a:ext cx="3903663" cy="1588"/>
              </a:xfrm>
              <a:prstGeom prst="rect">
                <a:avLst/>
              </a:prstGeom>
              <a:solidFill>
                <a:srgbClr val="58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Rectangle 262">
                <a:extLst>
                  <a:ext uri="{FF2B5EF4-FFF2-40B4-BE49-F238E27FC236}">
                    <a16:creationId xmlns:a16="http://schemas.microsoft.com/office/drawing/2014/main" id="{28AB4013-CC0B-47CF-9BFD-122C533BC4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195513"/>
                <a:ext cx="3903663" cy="1588"/>
              </a:xfrm>
              <a:prstGeom prst="rect">
                <a:avLst/>
              </a:prstGeom>
              <a:solidFill>
                <a:srgbClr val="5876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" name="Rectangle 263">
                <a:extLst>
                  <a:ext uri="{FF2B5EF4-FFF2-40B4-BE49-F238E27FC236}">
                    <a16:creationId xmlns:a16="http://schemas.microsoft.com/office/drawing/2014/main" id="{4C29BA44-8633-4DFD-ACDB-685AF51736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197101"/>
                <a:ext cx="3903663" cy="1588"/>
              </a:xfrm>
              <a:prstGeom prst="rect">
                <a:avLst/>
              </a:prstGeom>
              <a:solidFill>
                <a:srgbClr val="57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Rectangle 264">
                <a:extLst>
                  <a:ext uri="{FF2B5EF4-FFF2-40B4-BE49-F238E27FC236}">
                    <a16:creationId xmlns:a16="http://schemas.microsoft.com/office/drawing/2014/main" id="{DC991319-7D41-465A-B637-CC414BAFAD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198688"/>
                <a:ext cx="3903663" cy="1588"/>
              </a:xfrm>
              <a:prstGeom prst="rect">
                <a:avLst/>
              </a:prstGeom>
              <a:solidFill>
                <a:srgbClr val="56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Rectangle 265">
                <a:extLst>
                  <a:ext uri="{FF2B5EF4-FFF2-40B4-BE49-F238E27FC236}">
                    <a16:creationId xmlns:a16="http://schemas.microsoft.com/office/drawing/2014/main" id="{3C154086-BE30-4475-828E-D53049A4C6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00276"/>
                <a:ext cx="3903663" cy="1588"/>
              </a:xfrm>
              <a:prstGeom prst="rect">
                <a:avLst/>
              </a:prstGeom>
              <a:solidFill>
                <a:srgbClr val="55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Rectangle 266">
                <a:extLst>
                  <a:ext uri="{FF2B5EF4-FFF2-40B4-BE49-F238E27FC236}">
                    <a16:creationId xmlns:a16="http://schemas.microsoft.com/office/drawing/2014/main" id="{E8D3B82C-00EB-4678-87B5-644EDADD32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01863"/>
                <a:ext cx="3903663" cy="3175"/>
              </a:xfrm>
              <a:prstGeom prst="rect">
                <a:avLst/>
              </a:prstGeom>
              <a:solidFill>
                <a:srgbClr val="54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Rectangle 267">
                <a:extLst>
                  <a:ext uri="{FF2B5EF4-FFF2-40B4-BE49-F238E27FC236}">
                    <a16:creationId xmlns:a16="http://schemas.microsoft.com/office/drawing/2014/main" id="{3FFEA4EA-13D9-40C6-8B51-D53792D911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05038"/>
                <a:ext cx="3903663" cy="3175"/>
              </a:xfrm>
              <a:prstGeom prst="rect">
                <a:avLst/>
              </a:prstGeom>
              <a:solidFill>
                <a:srgbClr val="5374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Rectangle 268">
                <a:extLst>
                  <a:ext uri="{FF2B5EF4-FFF2-40B4-BE49-F238E27FC236}">
                    <a16:creationId xmlns:a16="http://schemas.microsoft.com/office/drawing/2014/main" id="{07830B54-4F4A-4172-9874-1AA60EB241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08213"/>
                <a:ext cx="3903663" cy="1588"/>
              </a:xfrm>
              <a:prstGeom prst="rect">
                <a:avLst/>
              </a:prstGeom>
              <a:solidFill>
                <a:srgbClr val="5273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Rectangle 269">
                <a:extLst>
                  <a:ext uri="{FF2B5EF4-FFF2-40B4-BE49-F238E27FC236}">
                    <a16:creationId xmlns:a16="http://schemas.microsoft.com/office/drawing/2014/main" id="{554BFADF-25C3-47A8-8CCE-A025D26685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09801"/>
                <a:ext cx="3903663" cy="1588"/>
              </a:xfrm>
              <a:prstGeom prst="rect">
                <a:avLst/>
              </a:prstGeom>
              <a:solidFill>
                <a:srgbClr val="51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Rectangle 270">
                <a:extLst>
                  <a:ext uri="{FF2B5EF4-FFF2-40B4-BE49-F238E27FC236}">
                    <a16:creationId xmlns:a16="http://schemas.microsoft.com/office/drawing/2014/main" id="{26F90E2F-5D99-4FFF-960B-7E6F2C7478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11388"/>
                <a:ext cx="3903663" cy="1588"/>
              </a:xfrm>
              <a:prstGeom prst="rect">
                <a:avLst/>
              </a:prstGeom>
              <a:solidFill>
                <a:srgbClr val="50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Rectangle 271">
                <a:extLst>
                  <a:ext uri="{FF2B5EF4-FFF2-40B4-BE49-F238E27FC236}">
                    <a16:creationId xmlns:a16="http://schemas.microsoft.com/office/drawing/2014/main" id="{ADB737E7-EAD6-4C9C-8816-6EC71667E3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12976"/>
                <a:ext cx="3903663" cy="1588"/>
              </a:xfrm>
              <a:prstGeom prst="rect">
                <a:avLst/>
              </a:prstGeom>
              <a:solidFill>
                <a:srgbClr val="4F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Rectangle 272">
                <a:extLst>
                  <a:ext uri="{FF2B5EF4-FFF2-40B4-BE49-F238E27FC236}">
                    <a16:creationId xmlns:a16="http://schemas.microsoft.com/office/drawing/2014/main" id="{899B0DD3-4D4F-4CF0-BF8F-4048F088EE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14563"/>
                <a:ext cx="3903663" cy="1588"/>
              </a:xfrm>
              <a:prstGeom prst="rect">
                <a:avLst/>
              </a:prstGeom>
              <a:solidFill>
                <a:srgbClr val="4E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Rectangle 273">
                <a:extLst>
                  <a:ext uri="{FF2B5EF4-FFF2-40B4-BE49-F238E27FC236}">
                    <a16:creationId xmlns:a16="http://schemas.microsoft.com/office/drawing/2014/main" id="{D4CDF820-4A50-474A-A077-CDE55B5688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16151"/>
                <a:ext cx="3903663" cy="3175"/>
              </a:xfrm>
              <a:prstGeom prst="rect">
                <a:avLst/>
              </a:prstGeom>
              <a:solidFill>
                <a:srgbClr val="4E71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Rectangle 274">
                <a:extLst>
                  <a:ext uri="{FF2B5EF4-FFF2-40B4-BE49-F238E27FC236}">
                    <a16:creationId xmlns:a16="http://schemas.microsoft.com/office/drawing/2014/main" id="{60E6DB8C-0DC8-4FC5-89AC-61AC0A9C76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19326"/>
                <a:ext cx="3903663" cy="1588"/>
              </a:xfrm>
              <a:prstGeom prst="rect">
                <a:avLst/>
              </a:prstGeom>
              <a:solidFill>
                <a:srgbClr val="4D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Rectangle 275">
                <a:extLst>
                  <a:ext uri="{FF2B5EF4-FFF2-40B4-BE49-F238E27FC236}">
                    <a16:creationId xmlns:a16="http://schemas.microsoft.com/office/drawing/2014/main" id="{96FAA452-1CA0-43B0-BB61-6859C93154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20913"/>
                <a:ext cx="3903663" cy="1588"/>
              </a:xfrm>
              <a:prstGeom prst="rect">
                <a:avLst/>
              </a:prstGeom>
              <a:solidFill>
                <a:srgbClr val="4C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Rectangle 276">
                <a:extLst>
                  <a:ext uri="{FF2B5EF4-FFF2-40B4-BE49-F238E27FC236}">
                    <a16:creationId xmlns:a16="http://schemas.microsoft.com/office/drawing/2014/main" id="{5432A4E5-9AC5-4A1F-AE07-699C453ECF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22501"/>
                <a:ext cx="3903663" cy="1588"/>
              </a:xfrm>
              <a:prstGeom prst="rect">
                <a:avLst/>
              </a:prstGeom>
              <a:solidFill>
                <a:srgbClr val="4B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Rectangle 277">
                <a:extLst>
                  <a:ext uri="{FF2B5EF4-FFF2-40B4-BE49-F238E27FC236}">
                    <a16:creationId xmlns:a16="http://schemas.microsoft.com/office/drawing/2014/main" id="{28D2BAE4-A7FE-4FEC-A39F-EF6D85A927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24088"/>
                <a:ext cx="3903663" cy="1588"/>
              </a:xfrm>
              <a:prstGeom prst="rect">
                <a:avLst/>
              </a:prstGeom>
              <a:solidFill>
                <a:srgbClr val="4A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Rectangle 278">
                <a:extLst>
                  <a:ext uri="{FF2B5EF4-FFF2-40B4-BE49-F238E27FC236}">
                    <a16:creationId xmlns:a16="http://schemas.microsoft.com/office/drawing/2014/main" id="{215508D8-7235-4A5B-B8F6-DC83C45018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25676"/>
                <a:ext cx="3903663" cy="1588"/>
              </a:xfrm>
              <a:prstGeom prst="rect">
                <a:avLst/>
              </a:prstGeom>
              <a:solidFill>
                <a:srgbClr val="49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6" name="Rectangle 279">
                <a:extLst>
                  <a:ext uri="{FF2B5EF4-FFF2-40B4-BE49-F238E27FC236}">
                    <a16:creationId xmlns:a16="http://schemas.microsoft.com/office/drawing/2014/main" id="{7DF3D302-1D56-4F83-A871-90281C85C5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27263"/>
                <a:ext cx="3903663" cy="1588"/>
              </a:xfrm>
              <a:prstGeom prst="rect">
                <a:avLst/>
              </a:prstGeom>
              <a:solidFill>
                <a:srgbClr val="48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Rectangle 280">
                <a:extLst>
                  <a:ext uri="{FF2B5EF4-FFF2-40B4-BE49-F238E27FC236}">
                    <a16:creationId xmlns:a16="http://schemas.microsoft.com/office/drawing/2014/main" id="{84B1F0B1-F130-409D-B891-CEE5F882BE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28851"/>
                <a:ext cx="3903663" cy="4763"/>
              </a:xfrm>
              <a:prstGeom prst="rect">
                <a:avLst/>
              </a:prstGeom>
              <a:solidFill>
                <a:srgbClr val="47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8" name="Rectangle 281">
                <a:extLst>
                  <a:ext uri="{FF2B5EF4-FFF2-40B4-BE49-F238E27FC236}">
                    <a16:creationId xmlns:a16="http://schemas.microsoft.com/office/drawing/2014/main" id="{55D359BA-8392-4C5D-AF14-22F5901F22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33613"/>
                <a:ext cx="3903663" cy="1588"/>
              </a:xfrm>
              <a:prstGeom prst="rect">
                <a:avLst/>
              </a:prstGeom>
              <a:solidFill>
                <a:srgbClr val="46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9" name="Rectangle 282">
                <a:extLst>
                  <a:ext uri="{FF2B5EF4-FFF2-40B4-BE49-F238E27FC236}">
                    <a16:creationId xmlns:a16="http://schemas.microsoft.com/office/drawing/2014/main" id="{F1647B44-D1D8-4629-B6C1-84126F69EF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35201"/>
                <a:ext cx="3903663" cy="1588"/>
              </a:xfrm>
              <a:prstGeom prst="rect">
                <a:avLst/>
              </a:prstGeom>
              <a:solidFill>
                <a:srgbClr val="45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0" name="Rectangle 283">
                <a:extLst>
                  <a:ext uri="{FF2B5EF4-FFF2-40B4-BE49-F238E27FC236}">
                    <a16:creationId xmlns:a16="http://schemas.microsoft.com/office/drawing/2014/main" id="{B6E03E19-F8F0-4833-8873-B70A327E6C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36788"/>
                <a:ext cx="3903663" cy="1588"/>
              </a:xfrm>
              <a:prstGeom prst="rect">
                <a:avLst/>
              </a:prstGeom>
              <a:solidFill>
                <a:srgbClr val="44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Rectangle 284">
                <a:extLst>
                  <a:ext uri="{FF2B5EF4-FFF2-40B4-BE49-F238E27FC236}">
                    <a16:creationId xmlns:a16="http://schemas.microsoft.com/office/drawing/2014/main" id="{79D5DA89-33B6-43FC-8D18-E4CE2062CC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38376"/>
                <a:ext cx="3903663" cy="1588"/>
              </a:xfrm>
              <a:prstGeom prst="rect">
                <a:avLst/>
              </a:prstGeom>
              <a:solidFill>
                <a:srgbClr val="44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Rectangle 285">
                <a:extLst>
                  <a:ext uri="{FF2B5EF4-FFF2-40B4-BE49-F238E27FC236}">
                    <a16:creationId xmlns:a16="http://schemas.microsoft.com/office/drawing/2014/main" id="{F439D1B5-3E08-4FE2-8430-897C71DFD4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39963"/>
                <a:ext cx="3903663" cy="1588"/>
              </a:xfrm>
              <a:prstGeom prst="rect">
                <a:avLst/>
              </a:prstGeom>
              <a:solidFill>
                <a:srgbClr val="43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Rectangle 286">
                <a:extLst>
                  <a:ext uri="{FF2B5EF4-FFF2-40B4-BE49-F238E27FC236}">
                    <a16:creationId xmlns:a16="http://schemas.microsoft.com/office/drawing/2014/main" id="{97B38B8B-2105-4314-8BA0-33C601A611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41551"/>
                <a:ext cx="3903663" cy="1588"/>
              </a:xfrm>
              <a:prstGeom prst="rect">
                <a:avLst/>
              </a:prstGeom>
              <a:solidFill>
                <a:srgbClr val="42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Rectangle 287">
                <a:extLst>
                  <a:ext uri="{FF2B5EF4-FFF2-40B4-BE49-F238E27FC236}">
                    <a16:creationId xmlns:a16="http://schemas.microsoft.com/office/drawing/2014/main" id="{28D7BEEE-C150-4681-B67A-0B70F9730E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43138"/>
                <a:ext cx="3903663" cy="3175"/>
              </a:xfrm>
              <a:prstGeom prst="rect">
                <a:avLst/>
              </a:prstGeom>
              <a:solidFill>
                <a:srgbClr val="41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Rectangle 288">
                <a:extLst>
                  <a:ext uri="{FF2B5EF4-FFF2-40B4-BE49-F238E27FC236}">
                    <a16:creationId xmlns:a16="http://schemas.microsoft.com/office/drawing/2014/main" id="{B3D58AA5-12BA-4B35-A41A-F1ED406611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46313"/>
                <a:ext cx="3903663" cy="1588"/>
              </a:xfrm>
              <a:prstGeom prst="rect">
                <a:avLst/>
              </a:prstGeom>
              <a:solidFill>
                <a:srgbClr val="40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Rectangle 289">
                <a:extLst>
                  <a:ext uri="{FF2B5EF4-FFF2-40B4-BE49-F238E27FC236}">
                    <a16:creationId xmlns:a16="http://schemas.microsoft.com/office/drawing/2014/main" id="{1806302D-58A7-4D3A-A8D0-6366704B82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47901"/>
                <a:ext cx="3903663" cy="1588"/>
              </a:xfrm>
              <a:prstGeom prst="rect">
                <a:avLst/>
              </a:prstGeom>
              <a:solidFill>
                <a:srgbClr val="3F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Rectangle 290">
                <a:extLst>
                  <a:ext uri="{FF2B5EF4-FFF2-40B4-BE49-F238E27FC236}">
                    <a16:creationId xmlns:a16="http://schemas.microsoft.com/office/drawing/2014/main" id="{1FB00E18-B702-4097-9311-BE36913880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49488"/>
                <a:ext cx="3903663" cy="1588"/>
              </a:xfrm>
              <a:prstGeom prst="rect">
                <a:avLst/>
              </a:prstGeom>
              <a:solidFill>
                <a:srgbClr val="3E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Rectangle 291">
                <a:extLst>
                  <a:ext uri="{FF2B5EF4-FFF2-40B4-BE49-F238E27FC236}">
                    <a16:creationId xmlns:a16="http://schemas.microsoft.com/office/drawing/2014/main" id="{1C8B8652-9AB7-401A-B959-5B61DFE044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51076"/>
                <a:ext cx="3903663" cy="1588"/>
              </a:xfrm>
              <a:prstGeom prst="rect">
                <a:avLst/>
              </a:prstGeom>
              <a:solidFill>
                <a:srgbClr val="3D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Rectangle 292">
                <a:extLst>
                  <a:ext uri="{FF2B5EF4-FFF2-40B4-BE49-F238E27FC236}">
                    <a16:creationId xmlns:a16="http://schemas.microsoft.com/office/drawing/2014/main" id="{FF85D913-228C-4BB8-99F1-77C3E471D8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52663"/>
                <a:ext cx="3903663" cy="1588"/>
              </a:xfrm>
              <a:prstGeom prst="rect">
                <a:avLst/>
              </a:prstGeom>
              <a:solidFill>
                <a:srgbClr val="3D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0" name="Rectangle 293">
                <a:extLst>
                  <a:ext uri="{FF2B5EF4-FFF2-40B4-BE49-F238E27FC236}">
                    <a16:creationId xmlns:a16="http://schemas.microsoft.com/office/drawing/2014/main" id="{41F29752-DB31-4E16-98CE-E7714CB3B7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54251"/>
                <a:ext cx="3903663" cy="1588"/>
              </a:xfrm>
              <a:prstGeom prst="rect">
                <a:avLst/>
              </a:prstGeom>
              <a:solidFill>
                <a:srgbClr val="3C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Rectangle 294">
                <a:extLst>
                  <a:ext uri="{FF2B5EF4-FFF2-40B4-BE49-F238E27FC236}">
                    <a16:creationId xmlns:a16="http://schemas.microsoft.com/office/drawing/2014/main" id="{B430FDAA-FA37-4C29-ACE6-B8EE7D3B47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55838"/>
                <a:ext cx="3903663" cy="3175"/>
              </a:xfrm>
              <a:prstGeom prst="rect">
                <a:avLst/>
              </a:prstGeom>
              <a:solidFill>
                <a:srgbClr val="3B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Rectangle 295">
                <a:extLst>
                  <a:ext uri="{FF2B5EF4-FFF2-40B4-BE49-F238E27FC236}">
                    <a16:creationId xmlns:a16="http://schemas.microsoft.com/office/drawing/2014/main" id="{7A43EE19-37EA-48D3-B216-D0E3A4E37D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59013"/>
                <a:ext cx="3903663" cy="3175"/>
              </a:xfrm>
              <a:prstGeom prst="rect">
                <a:avLst/>
              </a:prstGeom>
              <a:solidFill>
                <a:srgbClr val="3A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Rectangle 296">
                <a:extLst>
                  <a:ext uri="{FF2B5EF4-FFF2-40B4-BE49-F238E27FC236}">
                    <a16:creationId xmlns:a16="http://schemas.microsoft.com/office/drawing/2014/main" id="{BE3E7C3B-8257-4593-AFA2-2EEA91B3DD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62188"/>
                <a:ext cx="3903663" cy="1588"/>
              </a:xfrm>
              <a:prstGeom prst="rect">
                <a:avLst/>
              </a:prstGeom>
              <a:solidFill>
                <a:srgbClr val="39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Rectangle 297">
                <a:extLst>
                  <a:ext uri="{FF2B5EF4-FFF2-40B4-BE49-F238E27FC236}">
                    <a16:creationId xmlns:a16="http://schemas.microsoft.com/office/drawing/2014/main" id="{D7CA0163-8BFF-4294-80BF-B2AD720D1B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63776"/>
                <a:ext cx="3903663" cy="1588"/>
              </a:xfrm>
              <a:prstGeom prst="rect">
                <a:avLst/>
              </a:prstGeom>
              <a:solidFill>
                <a:srgbClr val="38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Rectangle 298">
                <a:extLst>
                  <a:ext uri="{FF2B5EF4-FFF2-40B4-BE49-F238E27FC236}">
                    <a16:creationId xmlns:a16="http://schemas.microsoft.com/office/drawing/2014/main" id="{1DCA3A1A-599F-4415-AD59-2A4FD85831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65363"/>
                <a:ext cx="3903663" cy="1588"/>
              </a:xfrm>
              <a:prstGeom prst="rect">
                <a:avLst/>
              </a:prstGeom>
              <a:solidFill>
                <a:srgbClr val="37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Rectangle 299">
                <a:extLst>
                  <a:ext uri="{FF2B5EF4-FFF2-40B4-BE49-F238E27FC236}">
                    <a16:creationId xmlns:a16="http://schemas.microsoft.com/office/drawing/2014/main" id="{076EDDFF-7842-461F-8CA0-8CA2D1A404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66951"/>
                <a:ext cx="3903663" cy="1588"/>
              </a:xfrm>
              <a:prstGeom prst="rect">
                <a:avLst/>
              </a:prstGeom>
              <a:solidFill>
                <a:srgbClr val="36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Rectangle 300">
                <a:extLst>
                  <a:ext uri="{FF2B5EF4-FFF2-40B4-BE49-F238E27FC236}">
                    <a16:creationId xmlns:a16="http://schemas.microsoft.com/office/drawing/2014/main" id="{4D838500-7435-4373-9F03-FBF8AA62E6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68538"/>
                <a:ext cx="3903663" cy="4763"/>
              </a:xfrm>
              <a:prstGeom prst="rect">
                <a:avLst/>
              </a:prstGeom>
              <a:solidFill>
                <a:srgbClr val="3563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Rectangle 301">
                <a:extLst>
                  <a:ext uri="{FF2B5EF4-FFF2-40B4-BE49-F238E27FC236}">
                    <a16:creationId xmlns:a16="http://schemas.microsoft.com/office/drawing/2014/main" id="{437136AC-6809-42F5-A681-AC9C08098E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73301"/>
                <a:ext cx="3903663" cy="1588"/>
              </a:xfrm>
              <a:prstGeom prst="rect">
                <a:avLst/>
              </a:prstGeom>
              <a:solidFill>
                <a:srgbClr val="35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Rectangle 302">
                <a:extLst>
                  <a:ext uri="{FF2B5EF4-FFF2-40B4-BE49-F238E27FC236}">
                    <a16:creationId xmlns:a16="http://schemas.microsoft.com/office/drawing/2014/main" id="{21744982-2909-4D34-B27C-B43252EA36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74888"/>
                <a:ext cx="3903663" cy="3175"/>
              </a:xfrm>
              <a:prstGeom prst="rect">
                <a:avLst/>
              </a:prstGeom>
              <a:solidFill>
                <a:srgbClr val="34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Rectangle 303">
                <a:extLst>
                  <a:ext uri="{FF2B5EF4-FFF2-40B4-BE49-F238E27FC236}">
                    <a16:creationId xmlns:a16="http://schemas.microsoft.com/office/drawing/2014/main" id="{D9942083-BF70-4325-8C51-F57515E7D5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78063"/>
                <a:ext cx="3903663" cy="3175"/>
              </a:xfrm>
              <a:prstGeom prst="rect">
                <a:avLst/>
              </a:prstGeom>
              <a:solidFill>
                <a:srgbClr val="3461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Rectangle 304">
                <a:extLst>
                  <a:ext uri="{FF2B5EF4-FFF2-40B4-BE49-F238E27FC236}">
                    <a16:creationId xmlns:a16="http://schemas.microsoft.com/office/drawing/2014/main" id="{94C702F5-10CB-4C7F-8D93-A476AA853C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81238"/>
                <a:ext cx="3903663" cy="4763"/>
              </a:xfrm>
              <a:prstGeom prst="rect">
                <a:avLst/>
              </a:prstGeom>
              <a:solidFill>
                <a:srgbClr val="3361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2" name="Rectangle 305">
                <a:extLst>
                  <a:ext uri="{FF2B5EF4-FFF2-40B4-BE49-F238E27FC236}">
                    <a16:creationId xmlns:a16="http://schemas.microsoft.com/office/drawing/2014/main" id="{CED9A54E-B9DF-40EA-AAF0-9521743F1D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86001"/>
                <a:ext cx="3903663" cy="1588"/>
              </a:xfrm>
              <a:prstGeom prst="rect">
                <a:avLst/>
              </a:prstGeom>
              <a:solidFill>
                <a:srgbClr val="3360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3" name="Rectangle 306">
                <a:extLst>
                  <a:ext uri="{FF2B5EF4-FFF2-40B4-BE49-F238E27FC236}">
                    <a16:creationId xmlns:a16="http://schemas.microsoft.com/office/drawing/2014/main" id="{6FD10A2C-339D-45AF-A4C5-8358DC50B1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87588"/>
                <a:ext cx="3903663" cy="4763"/>
              </a:xfrm>
              <a:prstGeom prst="rect">
                <a:avLst/>
              </a:prstGeom>
              <a:solidFill>
                <a:srgbClr val="3260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Rectangle 307">
                <a:extLst>
                  <a:ext uri="{FF2B5EF4-FFF2-40B4-BE49-F238E27FC236}">
                    <a16:creationId xmlns:a16="http://schemas.microsoft.com/office/drawing/2014/main" id="{1CA27213-C7A1-4425-BC68-9EB86FBBC7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92351"/>
                <a:ext cx="3903663" cy="1588"/>
              </a:xfrm>
              <a:prstGeom prst="rect">
                <a:avLst/>
              </a:prstGeom>
              <a:solidFill>
                <a:srgbClr val="32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Rectangle 308">
                <a:extLst>
                  <a:ext uri="{FF2B5EF4-FFF2-40B4-BE49-F238E27FC236}">
                    <a16:creationId xmlns:a16="http://schemas.microsoft.com/office/drawing/2014/main" id="{43D4AF59-83E0-4AE9-A118-CFF0E1C682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93938"/>
                <a:ext cx="3903663" cy="1588"/>
              </a:xfrm>
              <a:prstGeom prst="rect">
                <a:avLst/>
              </a:prstGeom>
              <a:solidFill>
                <a:srgbClr val="31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Rectangle 309">
                <a:extLst>
                  <a:ext uri="{FF2B5EF4-FFF2-40B4-BE49-F238E27FC236}">
                    <a16:creationId xmlns:a16="http://schemas.microsoft.com/office/drawing/2014/main" id="{AFD1781E-A1A3-4248-8D68-6DAF564FF1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295526"/>
                <a:ext cx="3903663" cy="6350"/>
              </a:xfrm>
              <a:prstGeom prst="rect">
                <a:avLst/>
              </a:prstGeom>
              <a:solidFill>
                <a:srgbClr val="315E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Rectangle 310">
                <a:extLst>
                  <a:ext uri="{FF2B5EF4-FFF2-40B4-BE49-F238E27FC236}">
                    <a16:creationId xmlns:a16="http://schemas.microsoft.com/office/drawing/2014/main" id="{0D1E4708-9BFD-4B8D-AA17-46F325C8E5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01876"/>
                <a:ext cx="3903663" cy="1588"/>
              </a:xfrm>
              <a:prstGeom prst="rect">
                <a:avLst/>
              </a:prstGeom>
              <a:solidFill>
                <a:srgbClr val="305D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Rectangle 311">
                <a:extLst>
                  <a:ext uri="{FF2B5EF4-FFF2-40B4-BE49-F238E27FC236}">
                    <a16:creationId xmlns:a16="http://schemas.microsoft.com/office/drawing/2014/main" id="{A97F03C4-51AA-4AEE-858B-52A65F58B3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03463"/>
                <a:ext cx="3903663" cy="3175"/>
              </a:xfrm>
              <a:prstGeom prst="rect">
                <a:avLst/>
              </a:prstGeom>
              <a:solidFill>
                <a:srgbClr val="305D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Rectangle 312">
                <a:extLst>
                  <a:ext uri="{FF2B5EF4-FFF2-40B4-BE49-F238E27FC236}">
                    <a16:creationId xmlns:a16="http://schemas.microsoft.com/office/drawing/2014/main" id="{390ED3B4-DC3C-4A19-BC00-6698E9B58A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06638"/>
                <a:ext cx="3903663" cy="3175"/>
              </a:xfrm>
              <a:prstGeom prst="rect">
                <a:avLst/>
              </a:prstGeom>
              <a:solidFill>
                <a:srgbClr val="2F5C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0" name="Rectangle 313">
                <a:extLst>
                  <a:ext uri="{FF2B5EF4-FFF2-40B4-BE49-F238E27FC236}">
                    <a16:creationId xmlns:a16="http://schemas.microsoft.com/office/drawing/2014/main" id="{AE28C8E5-7405-48C2-82EB-33D4D4E85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09813"/>
                <a:ext cx="3903663" cy="4763"/>
              </a:xfrm>
              <a:prstGeom prst="rect">
                <a:avLst/>
              </a:prstGeom>
              <a:solidFill>
                <a:srgbClr val="2F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1" name="Rectangle 314">
                <a:extLst>
                  <a:ext uri="{FF2B5EF4-FFF2-40B4-BE49-F238E27FC236}">
                    <a16:creationId xmlns:a16="http://schemas.microsoft.com/office/drawing/2014/main" id="{0E398917-40C9-4DAD-BEC2-AFA5C93C1A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14576"/>
                <a:ext cx="3903663" cy="1588"/>
              </a:xfrm>
              <a:prstGeom prst="rect">
                <a:avLst/>
              </a:prstGeom>
              <a:solidFill>
                <a:srgbClr val="2E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2" name="Rectangle 315">
                <a:extLst>
                  <a:ext uri="{FF2B5EF4-FFF2-40B4-BE49-F238E27FC236}">
                    <a16:creationId xmlns:a16="http://schemas.microsoft.com/office/drawing/2014/main" id="{7E04495B-BE96-4230-A8DA-02F8039457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16163"/>
                <a:ext cx="3903663" cy="4763"/>
              </a:xfrm>
              <a:prstGeom prst="rect">
                <a:avLst/>
              </a:prstGeom>
              <a:solidFill>
                <a:srgbClr val="2E5A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3" name="Rectangle 316">
                <a:extLst>
                  <a:ext uri="{FF2B5EF4-FFF2-40B4-BE49-F238E27FC236}">
                    <a16:creationId xmlns:a16="http://schemas.microsoft.com/office/drawing/2014/main" id="{BB701912-32E6-4DAD-920F-992CF3FB5E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20926"/>
                <a:ext cx="3903663" cy="1588"/>
              </a:xfrm>
              <a:prstGeom prst="rect">
                <a:avLst/>
              </a:prstGeom>
              <a:solidFill>
                <a:srgbClr val="2D5A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4" name="Rectangle 317">
                <a:extLst>
                  <a:ext uri="{FF2B5EF4-FFF2-40B4-BE49-F238E27FC236}">
                    <a16:creationId xmlns:a16="http://schemas.microsoft.com/office/drawing/2014/main" id="{59340B66-A9E1-4CEE-82CE-15211339D8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22513"/>
                <a:ext cx="3903663" cy="3175"/>
              </a:xfrm>
              <a:prstGeom prst="rect">
                <a:avLst/>
              </a:prstGeom>
              <a:solidFill>
                <a:srgbClr val="2D59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Rectangle 318">
                <a:extLst>
                  <a:ext uri="{FF2B5EF4-FFF2-40B4-BE49-F238E27FC236}">
                    <a16:creationId xmlns:a16="http://schemas.microsoft.com/office/drawing/2014/main" id="{28FEA9BF-E1D3-4608-9607-937D875AC5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25688"/>
                <a:ext cx="3903663" cy="4763"/>
              </a:xfrm>
              <a:prstGeom prst="rect">
                <a:avLst/>
              </a:prstGeom>
              <a:solidFill>
                <a:srgbClr val="2C59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Rectangle 319">
                <a:extLst>
                  <a:ext uri="{FF2B5EF4-FFF2-40B4-BE49-F238E27FC236}">
                    <a16:creationId xmlns:a16="http://schemas.microsoft.com/office/drawing/2014/main" id="{FA4B14AA-ECB1-4C40-856A-9D9CE42ECB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30451"/>
                <a:ext cx="3903663" cy="1588"/>
              </a:xfrm>
              <a:prstGeom prst="rect">
                <a:avLst/>
              </a:prstGeom>
              <a:solidFill>
                <a:srgbClr val="2C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7" name="Rectangle 320">
                <a:extLst>
                  <a:ext uri="{FF2B5EF4-FFF2-40B4-BE49-F238E27FC236}">
                    <a16:creationId xmlns:a16="http://schemas.microsoft.com/office/drawing/2014/main" id="{D6424767-1EFE-45E8-AFF3-72624717FB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32038"/>
                <a:ext cx="3903663" cy="3175"/>
              </a:xfrm>
              <a:prstGeom prst="rect">
                <a:avLst/>
              </a:prstGeom>
              <a:solidFill>
                <a:srgbClr val="2B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8" name="Rectangle 321">
                <a:extLst>
                  <a:ext uri="{FF2B5EF4-FFF2-40B4-BE49-F238E27FC236}">
                    <a16:creationId xmlns:a16="http://schemas.microsoft.com/office/drawing/2014/main" id="{972FEB7F-B5C0-4F1A-A995-77C9C613C1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35213"/>
                <a:ext cx="3903663" cy="4763"/>
              </a:xfrm>
              <a:prstGeom prst="rect">
                <a:avLst/>
              </a:prstGeom>
              <a:solidFill>
                <a:srgbClr val="2B57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9" name="Rectangle 322">
                <a:extLst>
                  <a:ext uri="{FF2B5EF4-FFF2-40B4-BE49-F238E27FC236}">
                    <a16:creationId xmlns:a16="http://schemas.microsoft.com/office/drawing/2014/main" id="{5EF6A3D7-E8F4-4AAD-B439-E6707B901C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39976"/>
                <a:ext cx="3903663" cy="4763"/>
              </a:xfrm>
              <a:prstGeom prst="rect">
                <a:avLst/>
              </a:prstGeom>
              <a:solidFill>
                <a:srgbClr val="2A56A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0" name="Rectangle 323">
                <a:extLst>
                  <a:ext uri="{FF2B5EF4-FFF2-40B4-BE49-F238E27FC236}">
                    <a16:creationId xmlns:a16="http://schemas.microsoft.com/office/drawing/2014/main" id="{016E9EB5-497C-4CEB-89E9-2A338FCD7F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2344738"/>
                <a:ext cx="3903663" cy="1588"/>
              </a:xfrm>
              <a:prstGeom prst="rect">
                <a:avLst/>
              </a:prstGeom>
              <a:solidFill>
                <a:srgbClr val="2955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Rectangle 324">
                <a:extLst>
                  <a:ext uri="{FF2B5EF4-FFF2-40B4-BE49-F238E27FC236}">
                    <a16:creationId xmlns:a16="http://schemas.microsoft.com/office/drawing/2014/main" id="{767C8156-8C54-4F43-B781-F55116BC91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30376"/>
                <a:ext cx="555625" cy="1588"/>
              </a:xfrm>
              <a:prstGeom prst="rect">
                <a:avLst/>
              </a:prstGeom>
              <a:solidFill>
                <a:srgbClr val="59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Rectangle 325">
                <a:extLst>
                  <a:ext uri="{FF2B5EF4-FFF2-40B4-BE49-F238E27FC236}">
                    <a16:creationId xmlns:a16="http://schemas.microsoft.com/office/drawing/2014/main" id="{2C8841AB-5C8F-4554-8EAB-4AFF11A79E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31963"/>
                <a:ext cx="555625" cy="3175"/>
              </a:xfrm>
              <a:prstGeom prst="rect">
                <a:avLst/>
              </a:prstGeom>
              <a:solidFill>
                <a:srgbClr val="5877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Rectangle 326">
                <a:extLst>
                  <a:ext uri="{FF2B5EF4-FFF2-40B4-BE49-F238E27FC236}">
                    <a16:creationId xmlns:a16="http://schemas.microsoft.com/office/drawing/2014/main" id="{31C68771-BBBB-44BD-BBF0-B54D419D0B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35138"/>
                <a:ext cx="555625" cy="1588"/>
              </a:xfrm>
              <a:prstGeom prst="rect">
                <a:avLst/>
              </a:prstGeom>
              <a:solidFill>
                <a:srgbClr val="5876B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Rectangle 327">
                <a:extLst>
                  <a:ext uri="{FF2B5EF4-FFF2-40B4-BE49-F238E27FC236}">
                    <a16:creationId xmlns:a16="http://schemas.microsoft.com/office/drawing/2014/main" id="{D73F5641-01C3-434F-A6CE-D78F1F006B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36726"/>
                <a:ext cx="555625" cy="1588"/>
              </a:xfrm>
              <a:prstGeom prst="rect">
                <a:avLst/>
              </a:prstGeom>
              <a:solidFill>
                <a:srgbClr val="57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Rectangle 328">
                <a:extLst>
                  <a:ext uri="{FF2B5EF4-FFF2-40B4-BE49-F238E27FC236}">
                    <a16:creationId xmlns:a16="http://schemas.microsoft.com/office/drawing/2014/main" id="{B171BE2C-1D6D-4593-B9E6-4D888B914D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38313"/>
                <a:ext cx="555625" cy="1588"/>
              </a:xfrm>
              <a:prstGeom prst="rect">
                <a:avLst/>
              </a:prstGeom>
              <a:solidFill>
                <a:srgbClr val="5676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Rectangle 329">
                <a:extLst>
                  <a:ext uri="{FF2B5EF4-FFF2-40B4-BE49-F238E27FC236}">
                    <a16:creationId xmlns:a16="http://schemas.microsoft.com/office/drawing/2014/main" id="{56E145EA-E91B-4558-9D69-F0DA2F2925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39901"/>
                <a:ext cx="555625" cy="1588"/>
              </a:xfrm>
              <a:prstGeom prst="rect">
                <a:avLst/>
              </a:prstGeom>
              <a:solidFill>
                <a:srgbClr val="55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Rectangle 330">
                <a:extLst>
                  <a:ext uri="{FF2B5EF4-FFF2-40B4-BE49-F238E27FC236}">
                    <a16:creationId xmlns:a16="http://schemas.microsoft.com/office/drawing/2014/main" id="{5B6F8A54-41BC-461C-921A-F0E72FAD50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41488"/>
                <a:ext cx="555625" cy="1588"/>
              </a:xfrm>
              <a:prstGeom prst="rect">
                <a:avLst/>
              </a:prstGeom>
              <a:solidFill>
                <a:srgbClr val="5475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Rectangle 331">
                <a:extLst>
                  <a:ext uri="{FF2B5EF4-FFF2-40B4-BE49-F238E27FC236}">
                    <a16:creationId xmlns:a16="http://schemas.microsoft.com/office/drawing/2014/main" id="{0876B147-CB05-44DE-BA91-36BBA5A6B8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43076"/>
                <a:ext cx="555625" cy="4763"/>
              </a:xfrm>
              <a:prstGeom prst="rect">
                <a:avLst/>
              </a:prstGeom>
              <a:solidFill>
                <a:srgbClr val="5374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9" name="Rectangle 332">
                <a:extLst>
                  <a:ext uri="{FF2B5EF4-FFF2-40B4-BE49-F238E27FC236}">
                    <a16:creationId xmlns:a16="http://schemas.microsoft.com/office/drawing/2014/main" id="{03DF3518-B107-4E37-B8DB-EB4593C2AE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47838"/>
                <a:ext cx="555625" cy="1588"/>
              </a:xfrm>
              <a:prstGeom prst="rect">
                <a:avLst/>
              </a:prstGeom>
              <a:solidFill>
                <a:srgbClr val="5273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0" name="Rectangle 333">
                <a:extLst>
                  <a:ext uri="{FF2B5EF4-FFF2-40B4-BE49-F238E27FC236}">
                    <a16:creationId xmlns:a16="http://schemas.microsoft.com/office/drawing/2014/main" id="{B6599B71-9C47-417D-82C2-46E1AE32D1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49426"/>
                <a:ext cx="555625" cy="1588"/>
              </a:xfrm>
              <a:prstGeom prst="rect">
                <a:avLst/>
              </a:prstGeom>
              <a:solidFill>
                <a:srgbClr val="51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1" name="Rectangle 334">
                <a:extLst>
                  <a:ext uri="{FF2B5EF4-FFF2-40B4-BE49-F238E27FC236}">
                    <a16:creationId xmlns:a16="http://schemas.microsoft.com/office/drawing/2014/main" id="{51C165C2-C52D-4F49-88D0-E4C38F3BAE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51013"/>
                <a:ext cx="555625" cy="1588"/>
              </a:xfrm>
              <a:prstGeom prst="rect">
                <a:avLst/>
              </a:prstGeom>
              <a:solidFill>
                <a:srgbClr val="50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2" name="Rectangle 335">
                <a:extLst>
                  <a:ext uri="{FF2B5EF4-FFF2-40B4-BE49-F238E27FC236}">
                    <a16:creationId xmlns:a16="http://schemas.microsoft.com/office/drawing/2014/main" id="{6FDB783C-F245-45DE-8046-7CE8143CBD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52601"/>
                <a:ext cx="555625" cy="1588"/>
              </a:xfrm>
              <a:prstGeom prst="rect">
                <a:avLst/>
              </a:prstGeom>
              <a:solidFill>
                <a:srgbClr val="4F72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3" name="Rectangle 336">
                <a:extLst>
                  <a:ext uri="{FF2B5EF4-FFF2-40B4-BE49-F238E27FC236}">
                    <a16:creationId xmlns:a16="http://schemas.microsoft.com/office/drawing/2014/main" id="{270F0D01-7C5F-4555-931F-E5DCB9B5DD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54188"/>
                <a:ext cx="555625" cy="1588"/>
              </a:xfrm>
              <a:prstGeom prst="rect">
                <a:avLst/>
              </a:prstGeom>
              <a:solidFill>
                <a:srgbClr val="4E71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4" name="Rectangle 337">
                <a:extLst>
                  <a:ext uri="{FF2B5EF4-FFF2-40B4-BE49-F238E27FC236}">
                    <a16:creationId xmlns:a16="http://schemas.microsoft.com/office/drawing/2014/main" id="{A1565125-0182-4B65-BF54-85C7EF35DB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55776"/>
                <a:ext cx="555625" cy="1588"/>
              </a:xfrm>
              <a:prstGeom prst="rect">
                <a:avLst/>
              </a:prstGeom>
              <a:solidFill>
                <a:srgbClr val="4E71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5" name="Rectangle 338">
                <a:extLst>
                  <a:ext uri="{FF2B5EF4-FFF2-40B4-BE49-F238E27FC236}">
                    <a16:creationId xmlns:a16="http://schemas.microsoft.com/office/drawing/2014/main" id="{4A7ED7FB-D241-4278-B9D3-694EA6A1D8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57363"/>
                <a:ext cx="555625" cy="1588"/>
              </a:xfrm>
              <a:prstGeom prst="rect">
                <a:avLst/>
              </a:prstGeom>
              <a:solidFill>
                <a:srgbClr val="4D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6" name="Rectangle 339">
                <a:extLst>
                  <a:ext uri="{FF2B5EF4-FFF2-40B4-BE49-F238E27FC236}">
                    <a16:creationId xmlns:a16="http://schemas.microsoft.com/office/drawing/2014/main" id="{83FC8C2B-CA51-438F-8847-7489B1F47F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58951"/>
                <a:ext cx="555625" cy="3175"/>
              </a:xfrm>
              <a:prstGeom prst="rect">
                <a:avLst/>
              </a:prstGeom>
              <a:solidFill>
                <a:srgbClr val="4C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Rectangle 340">
                <a:extLst>
                  <a:ext uri="{FF2B5EF4-FFF2-40B4-BE49-F238E27FC236}">
                    <a16:creationId xmlns:a16="http://schemas.microsoft.com/office/drawing/2014/main" id="{0980D7FF-A552-4D62-B540-5C0743F734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62126"/>
                <a:ext cx="555625" cy="1588"/>
              </a:xfrm>
              <a:prstGeom prst="rect">
                <a:avLst/>
              </a:prstGeom>
              <a:solidFill>
                <a:srgbClr val="4B70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Rectangle 341">
                <a:extLst>
                  <a:ext uri="{FF2B5EF4-FFF2-40B4-BE49-F238E27FC236}">
                    <a16:creationId xmlns:a16="http://schemas.microsoft.com/office/drawing/2014/main" id="{CB9F4884-47C5-4BCE-86E4-6BF57A8911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63713"/>
                <a:ext cx="555625" cy="1588"/>
              </a:xfrm>
              <a:prstGeom prst="rect">
                <a:avLst/>
              </a:prstGeom>
              <a:solidFill>
                <a:srgbClr val="4A6F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Rectangle 342">
                <a:extLst>
                  <a:ext uri="{FF2B5EF4-FFF2-40B4-BE49-F238E27FC236}">
                    <a16:creationId xmlns:a16="http://schemas.microsoft.com/office/drawing/2014/main" id="{AA292CC9-6F7B-4668-A462-011A2A41E9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65301"/>
                <a:ext cx="555625" cy="1588"/>
              </a:xfrm>
              <a:prstGeom prst="rect">
                <a:avLst/>
              </a:prstGeom>
              <a:solidFill>
                <a:srgbClr val="49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Rectangle 343">
                <a:extLst>
                  <a:ext uri="{FF2B5EF4-FFF2-40B4-BE49-F238E27FC236}">
                    <a16:creationId xmlns:a16="http://schemas.microsoft.com/office/drawing/2014/main" id="{703A383A-4315-457A-8E6B-ABA24CD131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66888"/>
                <a:ext cx="555625" cy="1588"/>
              </a:xfrm>
              <a:prstGeom prst="rect">
                <a:avLst/>
              </a:prstGeom>
              <a:solidFill>
                <a:srgbClr val="486E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1" name="Rectangle 344">
                <a:extLst>
                  <a:ext uri="{FF2B5EF4-FFF2-40B4-BE49-F238E27FC236}">
                    <a16:creationId xmlns:a16="http://schemas.microsoft.com/office/drawing/2014/main" id="{DAC515C1-119F-431D-BEF2-B991775A73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68476"/>
                <a:ext cx="555625" cy="3175"/>
              </a:xfrm>
              <a:prstGeom prst="rect">
                <a:avLst/>
              </a:prstGeom>
              <a:solidFill>
                <a:srgbClr val="476D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2" name="Rectangle 345">
                <a:extLst>
                  <a:ext uri="{FF2B5EF4-FFF2-40B4-BE49-F238E27FC236}">
                    <a16:creationId xmlns:a16="http://schemas.microsoft.com/office/drawing/2014/main" id="{0E9A23F8-9353-43D2-ACD2-29D091B2AE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71651"/>
                <a:ext cx="555625" cy="3175"/>
              </a:xfrm>
              <a:prstGeom prst="rect">
                <a:avLst/>
              </a:prstGeom>
              <a:solidFill>
                <a:srgbClr val="46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3" name="Rectangle 346">
                <a:extLst>
                  <a:ext uri="{FF2B5EF4-FFF2-40B4-BE49-F238E27FC236}">
                    <a16:creationId xmlns:a16="http://schemas.microsoft.com/office/drawing/2014/main" id="{838672C6-3647-4BE3-9644-392A9C3ECE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74826"/>
                <a:ext cx="555625" cy="1588"/>
              </a:xfrm>
              <a:prstGeom prst="rect">
                <a:avLst/>
              </a:prstGeom>
              <a:solidFill>
                <a:srgbClr val="456CB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4" name="Rectangle 347">
                <a:extLst>
                  <a:ext uri="{FF2B5EF4-FFF2-40B4-BE49-F238E27FC236}">
                    <a16:creationId xmlns:a16="http://schemas.microsoft.com/office/drawing/2014/main" id="{988E912D-C7CC-4A04-990D-5416C10B77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76413"/>
                <a:ext cx="555625" cy="1588"/>
              </a:xfrm>
              <a:prstGeom prst="rect">
                <a:avLst/>
              </a:prstGeom>
              <a:solidFill>
                <a:srgbClr val="446C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5" name="Rectangle 348">
                <a:extLst>
                  <a:ext uri="{FF2B5EF4-FFF2-40B4-BE49-F238E27FC236}">
                    <a16:creationId xmlns:a16="http://schemas.microsoft.com/office/drawing/2014/main" id="{9B6B9F7C-F672-4A50-BBC1-D25A0279CF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78001"/>
                <a:ext cx="555625" cy="1588"/>
              </a:xfrm>
              <a:prstGeom prst="rect">
                <a:avLst/>
              </a:prstGeom>
              <a:solidFill>
                <a:srgbClr val="44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6" name="Rectangle 349">
                <a:extLst>
                  <a:ext uri="{FF2B5EF4-FFF2-40B4-BE49-F238E27FC236}">
                    <a16:creationId xmlns:a16="http://schemas.microsoft.com/office/drawing/2014/main" id="{CC6005E9-C36E-4581-ACDF-1418A61992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79588"/>
                <a:ext cx="555625" cy="1588"/>
              </a:xfrm>
              <a:prstGeom prst="rect">
                <a:avLst/>
              </a:prstGeom>
              <a:solidFill>
                <a:srgbClr val="436B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7" name="Rectangle 350">
                <a:extLst>
                  <a:ext uri="{FF2B5EF4-FFF2-40B4-BE49-F238E27FC236}">
                    <a16:creationId xmlns:a16="http://schemas.microsoft.com/office/drawing/2014/main" id="{3C21BC9D-3124-4452-BB56-9659840DF8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81176"/>
                <a:ext cx="555625" cy="1588"/>
              </a:xfrm>
              <a:prstGeom prst="rect">
                <a:avLst/>
              </a:prstGeom>
              <a:solidFill>
                <a:srgbClr val="42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8" name="Rectangle 351">
                <a:extLst>
                  <a:ext uri="{FF2B5EF4-FFF2-40B4-BE49-F238E27FC236}">
                    <a16:creationId xmlns:a16="http://schemas.microsoft.com/office/drawing/2014/main" id="{D1C29FB0-AE64-4152-B174-4C070542F8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82763"/>
                <a:ext cx="555625" cy="1588"/>
              </a:xfrm>
              <a:prstGeom prst="rect">
                <a:avLst/>
              </a:prstGeom>
              <a:solidFill>
                <a:srgbClr val="416A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9" name="Rectangle 352">
                <a:extLst>
                  <a:ext uri="{FF2B5EF4-FFF2-40B4-BE49-F238E27FC236}">
                    <a16:creationId xmlns:a16="http://schemas.microsoft.com/office/drawing/2014/main" id="{A383B5CB-AFCC-494E-B3F6-D7B9D288DC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84351"/>
                <a:ext cx="555625" cy="1588"/>
              </a:xfrm>
              <a:prstGeom prst="rect">
                <a:avLst/>
              </a:prstGeom>
              <a:solidFill>
                <a:srgbClr val="40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0" name="Rectangle 353">
                <a:extLst>
                  <a:ext uri="{FF2B5EF4-FFF2-40B4-BE49-F238E27FC236}">
                    <a16:creationId xmlns:a16="http://schemas.microsoft.com/office/drawing/2014/main" id="{CEE1E3E3-93E7-4BE9-8C0D-2FFE31C06B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85938"/>
                <a:ext cx="555625" cy="3175"/>
              </a:xfrm>
              <a:prstGeom prst="rect">
                <a:avLst/>
              </a:prstGeom>
              <a:solidFill>
                <a:srgbClr val="3F69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1" name="Rectangle 354">
                <a:extLst>
                  <a:ext uri="{FF2B5EF4-FFF2-40B4-BE49-F238E27FC236}">
                    <a16:creationId xmlns:a16="http://schemas.microsoft.com/office/drawing/2014/main" id="{96BCF123-DFC0-4807-9FB9-AE00BEF9F4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89113"/>
                <a:ext cx="555625" cy="1588"/>
              </a:xfrm>
              <a:prstGeom prst="rect">
                <a:avLst/>
              </a:prstGeom>
              <a:solidFill>
                <a:srgbClr val="3E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Rectangle 355">
                <a:extLst>
                  <a:ext uri="{FF2B5EF4-FFF2-40B4-BE49-F238E27FC236}">
                    <a16:creationId xmlns:a16="http://schemas.microsoft.com/office/drawing/2014/main" id="{26441117-98DA-4BE2-8C5A-2A7C2B6594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90701"/>
                <a:ext cx="555625" cy="1588"/>
              </a:xfrm>
              <a:prstGeom prst="rect">
                <a:avLst/>
              </a:prstGeom>
              <a:solidFill>
                <a:srgbClr val="3D68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Rectangle 356">
                <a:extLst>
                  <a:ext uri="{FF2B5EF4-FFF2-40B4-BE49-F238E27FC236}">
                    <a16:creationId xmlns:a16="http://schemas.microsoft.com/office/drawing/2014/main" id="{55A4597C-1BE0-449D-879F-BEFA7B1EF7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92288"/>
                <a:ext cx="555625" cy="1588"/>
              </a:xfrm>
              <a:prstGeom prst="rect">
                <a:avLst/>
              </a:prstGeom>
              <a:solidFill>
                <a:srgbClr val="3D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4" name="Rectangle 357">
                <a:extLst>
                  <a:ext uri="{FF2B5EF4-FFF2-40B4-BE49-F238E27FC236}">
                    <a16:creationId xmlns:a16="http://schemas.microsoft.com/office/drawing/2014/main" id="{A91D3AD2-D023-40D9-AF9D-DA4E3AB277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93876"/>
                <a:ext cx="555625" cy="1588"/>
              </a:xfrm>
              <a:prstGeom prst="rect">
                <a:avLst/>
              </a:prstGeom>
              <a:solidFill>
                <a:srgbClr val="3C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Rectangle 358">
                <a:extLst>
                  <a:ext uri="{FF2B5EF4-FFF2-40B4-BE49-F238E27FC236}">
                    <a16:creationId xmlns:a16="http://schemas.microsoft.com/office/drawing/2014/main" id="{FB65E2DB-4D24-4609-A708-81B6572F53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95463"/>
                <a:ext cx="555625" cy="1588"/>
              </a:xfrm>
              <a:prstGeom prst="rect">
                <a:avLst/>
              </a:prstGeom>
              <a:solidFill>
                <a:srgbClr val="3B67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Rectangle 359">
                <a:extLst>
                  <a:ext uri="{FF2B5EF4-FFF2-40B4-BE49-F238E27FC236}">
                    <a16:creationId xmlns:a16="http://schemas.microsoft.com/office/drawing/2014/main" id="{CA8F2B80-08D8-4D9F-A31E-D035466A7A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797051"/>
                <a:ext cx="555625" cy="4763"/>
              </a:xfrm>
              <a:prstGeom prst="rect">
                <a:avLst/>
              </a:prstGeom>
              <a:solidFill>
                <a:srgbClr val="3A66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Rectangle 360">
                <a:extLst>
                  <a:ext uri="{FF2B5EF4-FFF2-40B4-BE49-F238E27FC236}">
                    <a16:creationId xmlns:a16="http://schemas.microsoft.com/office/drawing/2014/main" id="{DDAF8E05-8090-40BE-9B3F-73AF8A79B7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01813"/>
                <a:ext cx="555625" cy="1588"/>
              </a:xfrm>
              <a:prstGeom prst="rect">
                <a:avLst/>
              </a:prstGeom>
              <a:solidFill>
                <a:srgbClr val="39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Rectangle 361">
                <a:extLst>
                  <a:ext uri="{FF2B5EF4-FFF2-40B4-BE49-F238E27FC236}">
                    <a16:creationId xmlns:a16="http://schemas.microsoft.com/office/drawing/2014/main" id="{6B71DAC8-88EB-4AA4-9ED7-1550D6446E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03401"/>
                <a:ext cx="555625" cy="1588"/>
              </a:xfrm>
              <a:prstGeom prst="rect">
                <a:avLst/>
              </a:prstGeom>
              <a:solidFill>
                <a:srgbClr val="3865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Rectangle 362">
                <a:extLst>
                  <a:ext uri="{FF2B5EF4-FFF2-40B4-BE49-F238E27FC236}">
                    <a16:creationId xmlns:a16="http://schemas.microsoft.com/office/drawing/2014/main" id="{3B58B70C-7D44-45CA-8E76-F76727FFEC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04988"/>
                <a:ext cx="555625" cy="1588"/>
              </a:xfrm>
              <a:prstGeom prst="rect">
                <a:avLst/>
              </a:prstGeom>
              <a:solidFill>
                <a:srgbClr val="37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0" name="Rectangle 363">
                <a:extLst>
                  <a:ext uri="{FF2B5EF4-FFF2-40B4-BE49-F238E27FC236}">
                    <a16:creationId xmlns:a16="http://schemas.microsoft.com/office/drawing/2014/main" id="{066B6B6F-35D0-4EB0-97B3-1A59A50152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06576"/>
                <a:ext cx="555625" cy="1588"/>
              </a:xfrm>
              <a:prstGeom prst="rect">
                <a:avLst/>
              </a:prstGeom>
              <a:solidFill>
                <a:srgbClr val="3664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1" name="Rectangle 364">
                <a:extLst>
                  <a:ext uri="{FF2B5EF4-FFF2-40B4-BE49-F238E27FC236}">
                    <a16:creationId xmlns:a16="http://schemas.microsoft.com/office/drawing/2014/main" id="{DD63696B-3570-4FD2-8626-62189AF8FB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08163"/>
                <a:ext cx="555625" cy="3175"/>
              </a:xfrm>
              <a:prstGeom prst="rect">
                <a:avLst/>
              </a:prstGeom>
              <a:solidFill>
                <a:srgbClr val="3563B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2" name="Rectangle 365">
                <a:extLst>
                  <a:ext uri="{FF2B5EF4-FFF2-40B4-BE49-F238E27FC236}">
                    <a16:creationId xmlns:a16="http://schemas.microsoft.com/office/drawing/2014/main" id="{ED593AF8-B899-4333-9917-7AEAD24245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11338"/>
                <a:ext cx="555625" cy="1588"/>
              </a:xfrm>
              <a:prstGeom prst="rect">
                <a:avLst/>
              </a:prstGeom>
              <a:solidFill>
                <a:srgbClr val="35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3" name="Rectangle 366">
                <a:extLst>
                  <a:ext uri="{FF2B5EF4-FFF2-40B4-BE49-F238E27FC236}">
                    <a16:creationId xmlns:a16="http://schemas.microsoft.com/office/drawing/2014/main" id="{FEDCAD15-FE6F-4C36-A271-1D7A42B439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12926"/>
                <a:ext cx="555625" cy="4763"/>
              </a:xfrm>
              <a:prstGeom prst="rect">
                <a:avLst/>
              </a:prstGeom>
              <a:solidFill>
                <a:srgbClr val="346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4" name="Rectangle 367">
                <a:extLst>
                  <a:ext uri="{FF2B5EF4-FFF2-40B4-BE49-F238E27FC236}">
                    <a16:creationId xmlns:a16="http://schemas.microsoft.com/office/drawing/2014/main" id="{9D1ABFE4-A2AD-4213-906D-24E4A13020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17688"/>
                <a:ext cx="555625" cy="3175"/>
              </a:xfrm>
              <a:prstGeom prst="rect">
                <a:avLst/>
              </a:prstGeom>
              <a:solidFill>
                <a:srgbClr val="3461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5" name="Rectangle 368">
                <a:extLst>
                  <a:ext uri="{FF2B5EF4-FFF2-40B4-BE49-F238E27FC236}">
                    <a16:creationId xmlns:a16="http://schemas.microsoft.com/office/drawing/2014/main" id="{7E99BC7A-E8AD-4663-BC84-BC3782E924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20863"/>
                <a:ext cx="555625" cy="3175"/>
              </a:xfrm>
              <a:prstGeom prst="rect">
                <a:avLst/>
              </a:prstGeom>
              <a:solidFill>
                <a:srgbClr val="3361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Rectangle 369">
                <a:extLst>
                  <a:ext uri="{FF2B5EF4-FFF2-40B4-BE49-F238E27FC236}">
                    <a16:creationId xmlns:a16="http://schemas.microsoft.com/office/drawing/2014/main" id="{6A86096C-82E6-4B2F-875E-A9734C33B5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24038"/>
                <a:ext cx="555625" cy="1588"/>
              </a:xfrm>
              <a:prstGeom prst="rect">
                <a:avLst/>
              </a:prstGeom>
              <a:solidFill>
                <a:srgbClr val="3360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7" name="Rectangle 370">
                <a:extLst>
                  <a:ext uri="{FF2B5EF4-FFF2-40B4-BE49-F238E27FC236}">
                    <a16:creationId xmlns:a16="http://schemas.microsoft.com/office/drawing/2014/main" id="{6412DA00-41C2-4A9F-905D-371E9033C9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25626"/>
                <a:ext cx="555625" cy="6350"/>
              </a:xfrm>
              <a:prstGeom prst="rect">
                <a:avLst/>
              </a:prstGeom>
              <a:solidFill>
                <a:srgbClr val="3260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Rectangle 371">
                <a:extLst>
                  <a:ext uri="{FF2B5EF4-FFF2-40B4-BE49-F238E27FC236}">
                    <a16:creationId xmlns:a16="http://schemas.microsoft.com/office/drawing/2014/main" id="{F6EB2565-3EFA-4673-8720-C732092A5E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31976"/>
                <a:ext cx="555625" cy="1588"/>
              </a:xfrm>
              <a:prstGeom prst="rect">
                <a:avLst/>
              </a:prstGeom>
              <a:solidFill>
                <a:srgbClr val="32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9" name="Rectangle 372">
                <a:extLst>
                  <a:ext uri="{FF2B5EF4-FFF2-40B4-BE49-F238E27FC236}">
                    <a16:creationId xmlns:a16="http://schemas.microsoft.com/office/drawing/2014/main" id="{9706305B-0C01-425E-BB62-C892887F0C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33563"/>
                <a:ext cx="555625" cy="1588"/>
              </a:xfrm>
              <a:prstGeom prst="rect">
                <a:avLst/>
              </a:prstGeom>
              <a:solidFill>
                <a:srgbClr val="315F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0" name="Rectangle 373">
                <a:extLst>
                  <a:ext uri="{FF2B5EF4-FFF2-40B4-BE49-F238E27FC236}">
                    <a16:creationId xmlns:a16="http://schemas.microsoft.com/office/drawing/2014/main" id="{B6D936A9-6699-4D04-930B-A003A4EC3A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35151"/>
                <a:ext cx="555625" cy="4763"/>
              </a:xfrm>
              <a:prstGeom prst="rect">
                <a:avLst/>
              </a:prstGeom>
              <a:solidFill>
                <a:srgbClr val="315E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1" name="Rectangle 374">
                <a:extLst>
                  <a:ext uri="{FF2B5EF4-FFF2-40B4-BE49-F238E27FC236}">
                    <a16:creationId xmlns:a16="http://schemas.microsoft.com/office/drawing/2014/main" id="{3FAF5CAC-EAA8-48B2-807D-6E571F5195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39913"/>
                <a:ext cx="555625" cy="3175"/>
              </a:xfrm>
              <a:prstGeom prst="rect">
                <a:avLst/>
              </a:prstGeom>
              <a:solidFill>
                <a:srgbClr val="305D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2" name="Rectangle 375">
                <a:extLst>
                  <a:ext uri="{FF2B5EF4-FFF2-40B4-BE49-F238E27FC236}">
                    <a16:creationId xmlns:a16="http://schemas.microsoft.com/office/drawing/2014/main" id="{C34C5AF9-A94C-4CBF-86B8-53DE6E475C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43088"/>
                <a:ext cx="555625" cy="3175"/>
              </a:xfrm>
              <a:prstGeom prst="rect">
                <a:avLst/>
              </a:prstGeom>
              <a:solidFill>
                <a:srgbClr val="305D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3" name="Rectangle 376">
                <a:extLst>
                  <a:ext uri="{FF2B5EF4-FFF2-40B4-BE49-F238E27FC236}">
                    <a16:creationId xmlns:a16="http://schemas.microsoft.com/office/drawing/2014/main" id="{21A579BF-A2C5-4377-9AF6-C8A6A53783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46263"/>
                <a:ext cx="555625" cy="3175"/>
              </a:xfrm>
              <a:prstGeom prst="rect">
                <a:avLst/>
              </a:prstGeom>
              <a:solidFill>
                <a:srgbClr val="2F5C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4" name="Rectangle 377">
                <a:extLst>
                  <a:ext uri="{FF2B5EF4-FFF2-40B4-BE49-F238E27FC236}">
                    <a16:creationId xmlns:a16="http://schemas.microsoft.com/office/drawing/2014/main" id="{2EF8C4C9-7AC2-44D2-AF1D-2C8AE1F1FC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49438"/>
                <a:ext cx="555625" cy="3175"/>
              </a:xfrm>
              <a:prstGeom prst="rect">
                <a:avLst/>
              </a:prstGeom>
              <a:solidFill>
                <a:srgbClr val="2F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5" name="Rectangle 378">
                <a:extLst>
                  <a:ext uri="{FF2B5EF4-FFF2-40B4-BE49-F238E27FC236}">
                    <a16:creationId xmlns:a16="http://schemas.microsoft.com/office/drawing/2014/main" id="{D65F95D4-A1FA-4532-BBA9-BD743818D5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52613"/>
                <a:ext cx="555625" cy="3175"/>
              </a:xfrm>
              <a:prstGeom prst="rect">
                <a:avLst/>
              </a:prstGeom>
              <a:solidFill>
                <a:srgbClr val="2E5B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6" name="Rectangle 379">
                <a:extLst>
                  <a:ext uri="{FF2B5EF4-FFF2-40B4-BE49-F238E27FC236}">
                    <a16:creationId xmlns:a16="http://schemas.microsoft.com/office/drawing/2014/main" id="{428C1E74-739E-4727-B97D-A27F60E641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55788"/>
                <a:ext cx="555625" cy="4763"/>
              </a:xfrm>
              <a:prstGeom prst="rect">
                <a:avLst/>
              </a:prstGeom>
              <a:solidFill>
                <a:srgbClr val="2E5A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7" name="Rectangle 380">
                <a:extLst>
                  <a:ext uri="{FF2B5EF4-FFF2-40B4-BE49-F238E27FC236}">
                    <a16:creationId xmlns:a16="http://schemas.microsoft.com/office/drawing/2014/main" id="{6A2C6CF8-671C-409B-BD03-3942F4458B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60551"/>
                <a:ext cx="555625" cy="1588"/>
              </a:xfrm>
              <a:prstGeom prst="rect">
                <a:avLst/>
              </a:prstGeom>
              <a:solidFill>
                <a:srgbClr val="2D5A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Rectangle 381">
                <a:extLst>
                  <a:ext uri="{FF2B5EF4-FFF2-40B4-BE49-F238E27FC236}">
                    <a16:creationId xmlns:a16="http://schemas.microsoft.com/office/drawing/2014/main" id="{5F4D8820-2BE1-4CA0-836B-48EBC21CD1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62138"/>
                <a:ext cx="555625" cy="1588"/>
              </a:xfrm>
              <a:prstGeom prst="rect">
                <a:avLst/>
              </a:prstGeom>
              <a:solidFill>
                <a:srgbClr val="2D59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9" name="Rectangle 382">
                <a:extLst>
                  <a:ext uri="{FF2B5EF4-FFF2-40B4-BE49-F238E27FC236}">
                    <a16:creationId xmlns:a16="http://schemas.microsoft.com/office/drawing/2014/main" id="{E336F749-6EBE-4AD9-85D2-23FA05D368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63726"/>
                <a:ext cx="555625" cy="6350"/>
              </a:xfrm>
              <a:prstGeom prst="rect">
                <a:avLst/>
              </a:prstGeom>
              <a:solidFill>
                <a:srgbClr val="2C59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0" name="Rectangle 383">
                <a:extLst>
                  <a:ext uri="{FF2B5EF4-FFF2-40B4-BE49-F238E27FC236}">
                    <a16:creationId xmlns:a16="http://schemas.microsoft.com/office/drawing/2014/main" id="{3CBE5636-6EF4-484D-B2C1-558348D529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70076"/>
                <a:ext cx="555625" cy="1588"/>
              </a:xfrm>
              <a:prstGeom prst="rect">
                <a:avLst/>
              </a:prstGeom>
              <a:solidFill>
                <a:srgbClr val="2C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1" name="Rectangle 384">
                <a:extLst>
                  <a:ext uri="{FF2B5EF4-FFF2-40B4-BE49-F238E27FC236}">
                    <a16:creationId xmlns:a16="http://schemas.microsoft.com/office/drawing/2014/main" id="{838A4E17-DC22-4C53-8757-28A6982D23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71663"/>
                <a:ext cx="555625" cy="3175"/>
              </a:xfrm>
              <a:prstGeom prst="rect">
                <a:avLst/>
              </a:prstGeom>
              <a:solidFill>
                <a:srgbClr val="2B58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2" name="Rectangle 385">
                <a:extLst>
                  <a:ext uri="{FF2B5EF4-FFF2-40B4-BE49-F238E27FC236}">
                    <a16:creationId xmlns:a16="http://schemas.microsoft.com/office/drawing/2014/main" id="{3C2D85F4-4EF0-4664-AEE0-3CED442EED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74838"/>
                <a:ext cx="555625" cy="3175"/>
              </a:xfrm>
              <a:prstGeom prst="rect">
                <a:avLst/>
              </a:prstGeom>
              <a:solidFill>
                <a:srgbClr val="2B57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3" name="Rectangle 386">
                <a:extLst>
                  <a:ext uri="{FF2B5EF4-FFF2-40B4-BE49-F238E27FC236}">
                    <a16:creationId xmlns:a16="http://schemas.microsoft.com/office/drawing/2014/main" id="{F550991D-D580-49E9-8626-5F6A6C8F1E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78013"/>
                <a:ext cx="555625" cy="6350"/>
              </a:xfrm>
              <a:prstGeom prst="rect">
                <a:avLst/>
              </a:prstGeom>
              <a:solidFill>
                <a:srgbClr val="2A56A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4" name="Rectangle 387">
                <a:extLst>
                  <a:ext uri="{FF2B5EF4-FFF2-40B4-BE49-F238E27FC236}">
                    <a16:creationId xmlns:a16="http://schemas.microsoft.com/office/drawing/2014/main" id="{8E64657F-0C0F-4D29-8FE3-2BFF32D167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6051" y="1884363"/>
                <a:ext cx="555625" cy="1588"/>
              </a:xfrm>
              <a:prstGeom prst="rect">
                <a:avLst/>
              </a:prstGeom>
              <a:solidFill>
                <a:srgbClr val="2955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5" name="Line 388">
                <a:extLst>
                  <a:ext uri="{FF2B5EF4-FFF2-40B4-BE49-F238E27FC236}">
                    <a16:creationId xmlns:a16="http://schemas.microsoft.com/office/drawing/2014/main" id="{D7886691-8FEF-424F-9C2F-EE30473187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87638" y="1655763"/>
                <a:ext cx="0" cy="2763838"/>
              </a:xfrm>
              <a:prstGeom prst="line">
                <a:avLst/>
              </a:prstGeom>
              <a:noFill/>
              <a:ln w="11113" cap="flat">
                <a:solidFill>
                  <a:srgbClr val="E0E5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6" name="Rectangle 389">
                <a:extLst>
                  <a:ext uri="{FF2B5EF4-FFF2-40B4-BE49-F238E27FC236}">
                    <a16:creationId xmlns:a16="http://schemas.microsoft.com/office/drawing/2014/main" id="{F4F0C880-AB70-409E-ADA0-C703EE9F96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2713" y="4506913"/>
                <a:ext cx="89768" cy="148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287" name="Rectangle 390">
                <a:extLst>
                  <a:ext uri="{FF2B5EF4-FFF2-40B4-BE49-F238E27FC236}">
                    <a16:creationId xmlns:a16="http://schemas.microsoft.com/office/drawing/2014/main" id="{54E2EA02-82BB-4540-B361-E925D278B1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82988" y="4506913"/>
                <a:ext cx="89768" cy="148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288" name="Rectangle 391">
                <a:extLst>
                  <a:ext uri="{FF2B5EF4-FFF2-40B4-BE49-F238E27FC236}">
                    <a16:creationId xmlns:a16="http://schemas.microsoft.com/office/drawing/2014/main" id="{49863B26-FA13-4C3C-B602-D3B6EE9895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78338" y="4506913"/>
                <a:ext cx="179536" cy="148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289" name="Rectangle 392">
                <a:extLst>
                  <a:ext uri="{FF2B5EF4-FFF2-40B4-BE49-F238E27FC236}">
                    <a16:creationId xmlns:a16="http://schemas.microsoft.com/office/drawing/2014/main" id="{05D837F1-F7A0-4738-9971-2F40387FF7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21214" y="4506913"/>
                <a:ext cx="179536" cy="148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</a:p>
            </p:txBody>
          </p:sp>
          <p:sp>
            <p:nvSpPr>
              <p:cNvPr id="290" name="Rectangle 393">
                <a:extLst>
                  <a:ext uri="{FF2B5EF4-FFF2-40B4-BE49-F238E27FC236}">
                    <a16:creationId xmlns:a16="http://schemas.microsoft.com/office/drawing/2014/main" id="{321C8651-256E-4515-90DE-1011703288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1489" y="4506913"/>
                <a:ext cx="179536" cy="148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</a:p>
            </p:txBody>
          </p:sp>
          <p:sp>
            <p:nvSpPr>
              <p:cNvPr id="291" name="Rectangle 394">
                <a:extLst>
                  <a:ext uri="{FF2B5EF4-FFF2-40B4-BE49-F238E27FC236}">
                    <a16:creationId xmlns:a16="http://schemas.microsoft.com/office/drawing/2014/main" id="{342763BB-2115-4057-A0CD-8F3280DEE6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81764" y="4506913"/>
                <a:ext cx="179536" cy="148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</a:p>
            </p:txBody>
          </p:sp>
          <p:sp>
            <p:nvSpPr>
              <p:cNvPr id="292" name="Rectangle 395">
                <a:extLst>
                  <a:ext uri="{FF2B5EF4-FFF2-40B4-BE49-F238E27FC236}">
                    <a16:creationId xmlns:a16="http://schemas.microsoft.com/office/drawing/2014/main" id="{37852E7F-8195-4E70-AE17-2307A523D6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93963" y="4098926"/>
                <a:ext cx="65" cy="2012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04" name="テキスト ボックス 503">
              <a:extLst>
                <a:ext uri="{FF2B5EF4-FFF2-40B4-BE49-F238E27FC236}">
                  <a16:creationId xmlns:a16="http://schemas.microsoft.com/office/drawing/2014/main" id="{88E1167D-F344-4BCF-94CB-DDCB2289817D}"/>
                </a:ext>
              </a:extLst>
            </p:cNvPr>
            <p:cNvSpPr txBox="1"/>
            <p:nvPr/>
          </p:nvSpPr>
          <p:spPr>
            <a:xfrm>
              <a:off x="1597080" y="1412776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6" name="直線コネクタ 505">
              <a:extLst>
                <a:ext uri="{FF2B5EF4-FFF2-40B4-BE49-F238E27FC236}">
                  <a16:creationId xmlns:a16="http://schemas.microsoft.com/office/drawing/2014/main" id="{6E772392-2437-4152-927A-97DF09208B2C}"/>
                </a:ext>
              </a:extLst>
            </p:cNvPr>
            <p:cNvCxnSpPr/>
            <p:nvPr/>
          </p:nvCxnSpPr>
          <p:spPr>
            <a:xfrm>
              <a:off x="2345528" y="5346277"/>
              <a:ext cx="4648200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8" name="直線コネクタ 507">
              <a:extLst>
                <a:ext uri="{FF2B5EF4-FFF2-40B4-BE49-F238E27FC236}">
                  <a16:creationId xmlns:a16="http://schemas.microsoft.com/office/drawing/2014/main" id="{9FEC5755-6FEF-432F-840F-E9CBEF923C26}"/>
                </a:ext>
              </a:extLst>
            </p:cNvPr>
            <p:cNvCxnSpPr>
              <a:stCxn id="285" idx="0"/>
              <a:endCxn id="285" idx="1"/>
            </p:cNvCxnSpPr>
            <p:nvPr/>
          </p:nvCxnSpPr>
          <p:spPr>
            <a:xfrm flipV="1">
              <a:off x="2347116" y="1340768"/>
              <a:ext cx="1" cy="4005509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44126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07F322AF-4F1A-410F-BCBF-4D3030EFE887}"/>
              </a:ext>
            </a:extLst>
          </p:cNvPr>
          <p:cNvGrpSpPr/>
          <p:nvPr/>
        </p:nvGrpSpPr>
        <p:grpSpPr>
          <a:xfrm>
            <a:off x="179512" y="1196752"/>
            <a:ext cx="8784976" cy="5133310"/>
            <a:chOff x="179512" y="1196752"/>
            <a:chExt cx="8784977" cy="5133310"/>
          </a:xfrm>
        </p:grpSpPr>
        <p:graphicFrame>
          <p:nvGraphicFramePr>
            <p:cNvPr id="4" name="図表 3">
              <a:extLst>
                <a:ext uri="{FF2B5EF4-FFF2-40B4-BE49-F238E27FC236}">
                  <a16:creationId xmlns:a16="http://schemas.microsoft.com/office/drawing/2014/main" id="{CA5B82BA-157B-4F10-BE78-680D932E65DD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274571200"/>
                </p:ext>
              </p:extLst>
            </p:nvPr>
          </p:nvGraphicFramePr>
          <p:xfrm>
            <a:off x="1691680" y="1196752"/>
            <a:ext cx="7272809" cy="4312352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3" r:lo="rId4" r:qs="rId5" r:cs="rId6"/>
            </a:graphicData>
          </a:graphic>
        </p:graphicFrame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A9F1C82C-2D62-463A-8757-53AA3D98BF7E}"/>
                </a:ext>
              </a:extLst>
            </p:cNvPr>
            <p:cNvSpPr txBox="1"/>
            <p:nvPr/>
          </p:nvSpPr>
          <p:spPr>
            <a:xfrm>
              <a:off x="1828876" y="5960730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F55A10D7-CDB7-4253-B800-3A1405C1C6EF}"/>
                </a:ext>
              </a:extLst>
            </p:cNvPr>
            <p:cNvSpPr txBox="1"/>
            <p:nvPr/>
          </p:nvSpPr>
          <p:spPr>
            <a:xfrm>
              <a:off x="5646703" y="524060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2B4A3EE6-49E0-425C-87F7-A2EBFDF141A8}"/>
                </a:ext>
              </a:extLst>
            </p:cNvPr>
            <p:cNvSpPr txBox="1"/>
            <p:nvPr/>
          </p:nvSpPr>
          <p:spPr>
            <a:xfrm>
              <a:off x="4784750" y="5221599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934BE50A-FFB8-4FC7-AC75-81128F6F44B2}"/>
                </a:ext>
              </a:extLst>
            </p:cNvPr>
            <p:cNvSpPr txBox="1"/>
            <p:nvPr/>
          </p:nvSpPr>
          <p:spPr>
            <a:xfrm>
              <a:off x="6553927" y="525826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F481D1A-C17B-4C25-BB45-DD41DE91C2F7}"/>
                </a:ext>
              </a:extLst>
            </p:cNvPr>
            <p:cNvSpPr txBox="1"/>
            <p:nvPr/>
          </p:nvSpPr>
          <p:spPr>
            <a:xfrm>
              <a:off x="7481328" y="5240601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EAED1B01-9000-48F6-97AF-1D3F0214A409}"/>
                </a:ext>
              </a:extLst>
            </p:cNvPr>
            <p:cNvSpPr txBox="1"/>
            <p:nvPr/>
          </p:nvSpPr>
          <p:spPr>
            <a:xfrm>
              <a:off x="8470240" y="525826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BF64E69D-2553-4D42-A3A9-C6DD0E0EE3AB}"/>
                </a:ext>
              </a:extLst>
            </p:cNvPr>
            <p:cNvSpPr txBox="1"/>
            <p:nvPr/>
          </p:nvSpPr>
          <p:spPr>
            <a:xfrm>
              <a:off x="2052463" y="5209829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B004FB51-20C9-4934-9BCF-B3EFFC89F33C}"/>
                </a:ext>
              </a:extLst>
            </p:cNvPr>
            <p:cNvSpPr txBox="1"/>
            <p:nvPr/>
          </p:nvSpPr>
          <p:spPr>
            <a:xfrm>
              <a:off x="2903936" y="5190187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F7E51D76-114D-4753-B6EC-A3D9F76B688D}"/>
                </a:ext>
              </a:extLst>
            </p:cNvPr>
            <p:cNvSpPr txBox="1"/>
            <p:nvPr/>
          </p:nvSpPr>
          <p:spPr>
            <a:xfrm>
              <a:off x="3897541" y="521753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5E938AFD-2A2D-4391-80E0-A0FA5B146DF5}"/>
                </a:ext>
              </a:extLst>
            </p:cNvPr>
            <p:cNvSpPr txBox="1"/>
            <p:nvPr/>
          </p:nvSpPr>
          <p:spPr>
            <a:xfrm>
              <a:off x="334974" y="1752292"/>
              <a:ext cx="5769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325CD81F-8AED-4646-970E-07EDC1BC42C5}"/>
                </a:ext>
              </a:extLst>
            </p:cNvPr>
            <p:cNvSpPr txBox="1"/>
            <p:nvPr/>
          </p:nvSpPr>
          <p:spPr>
            <a:xfrm>
              <a:off x="303703" y="2431559"/>
              <a:ext cx="16483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-RT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　（</a:t>
              </a:r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s. (+)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　</a:t>
              </a: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7F1B345B-F371-49BC-B8AF-478062677197}"/>
                </a:ext>
              </a:extLst>
            </p:cNvPr>
            <p:cNvSpPr txBox="1"/>
            <p:nvPr/>
          </p:nvSpPr>
          <p:spPr>
            <a:xfrm>
              <a:off x="244770" y="3140968"/>
              <a:ext cx="24842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sy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tract.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s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s.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C73FE649-D7FE-4F6A-A575-578F17C6E833}"/>
                </a:ext>
              </a:extLst>
            </p:cNvPr>
            <p:cNvSpPr txBox="1"/>
            <p:nvPr/>
          </p:nvSpPr>
          <p:spPr>
            <a:xfrm>
              <a:off x="251520" y="3841013"/>
              <a:ext cx="16980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-RT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g </a:t>
              </a:r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 vs (-)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337C2BA8-0C69-4456-AEC3-1F51F3F229F0}"/>
                </a:ext>
              </a:extLst>
            </p:cNvPr>
            <p:cNvSpPr txBox="1"/>
            <p:nvPr/>
          </p:nvSpPr>
          <p:spPr>
            <a:xfrm>
              <a:off x="278677" y="4519320"/>
              <a:ext cx="6895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50869653-B5BF-47BF-BF36-CE8F894294E0}"/>
                </a:ext>
              </a:extLst>
            </p:cNvPr>
            <p:cNvSpPr txBox="1"/>
            <p:nvPr/>
          </p:nvSpPr>
          <p:spPr>
            <a:xfrm>
              <a:off x="179512" y="5066020"/>
              <a:ext cx="158735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. institution </a:t>
              </a:r>
            </a:p>
            <a:p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ort Re-RT</a:t>
              </a:r>
              <a:r>
                <a:rPr kumimoji="1"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.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499C1B2-680E-48D1-B1CD-45B7F42613F9}"/>
              </a:ext>
            </a:extLst>
          </p:cNvPr>
          <p:cNvSpPr txBox="1"/>
          <p:nvPr/>
        </p:nvSpPr>
        <p:spPr>
          <a:xfrm>
            <a:off x="116769" y="96498"/>
            <a:ext cx="20136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Supplemental Figure 2. 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7210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155</Words>
  <Application>Microsoft Office PowerPoint</Application>
  <PresentationFormat>画面に合わせる (4:3)</PresentationFormat>
  <Paragraphs>65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ewlett-Packard Company</dc:creator>
  <cp:lastModifiedBy>Hewlett-Packard Company</cp:lastModifiedBy>
  <cp:revision>25</cp:revision>
  <cp:lastPrinted>2020-10-04T06:37:51Z</cp:lastPrinted>
  <dcterms:created xsi:type="dcterms:W3CDTF">2020-10-04T03:19:08Z</dcterms:created>
  <dcterms:modified xsi:type="dcterms:W3CDTF">2020-10-06T04:42:44Z</dcterms:modified>
</cp:coreProperties>
</file>